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  <p:sldId id="261" r:id="rId5"/>
    <p:sldId id="262" r:id="rId6"/>
    <p:sldId id="259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2B87A3D-0BCF-43FE-BE70-508B5C39EF1C}" v="110" dt="2019-05-06T06:13:24.23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228" autoAdjust="0"/>
  </p:normalViewPr>
  <p:slideViewPr>
    <p:cSldViewPr snapToGrid="0">
      <p:cViewPr varScale="1">
        <p:scale>
          <a:sx n="80" d="100"/>
          <a:sy n="80" d="100"/>
        </p:scale>
        <p:origin x="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hu Huyen Pham" userId="3eb787573b41f7e6" providerId="LiveId" clId="{D21008C1-1F35-4EFD-920C-00227BB11F61}"/>
    <pc:docChg chg="undo custSel mod addSld delSld modSld">
      <pc:chgData name="Thu Huyen Pham" userId="3eb787573b41f7e6" providerId="LiveId" clId="{D21008C1-1F35-4EFD-920C-00227BB11F61}" dt="2019-04-09T12:05:26.292" v="3311" actId="1076"/>
      <pc:docMkLst>
        <pc:docMk/>
      </pc:docMkLst>
      <pc:sldChg chg="addSp delSp modSp">
        <pc:chgData name="Thu Huyen Pham" userId="3eb787573b41f7e6" providerId="LiveId" clId="{D21008C1-1F35-4EFD-920C-00227BB11F61}" dt="2019-04-09T12:05:26.292" v="3311" actId="1076"/>
        <pc:sldMkLst>
          <pc:docMk/>
          <pc:sldMk cId="3167603900" sldId="257"/>
        </pc:sldMkLst>
        <pc:spChg chg="del mod">
          <ac:chgData name="Thu Huyen Pham" userId="3eb787573b41f7e6" providerId="LiveId" clId="{D21008C1-1F35-4EFD-920C-00227BB11F61}" dt="2019-03-17T12:51:25.915" v="2348" actId="478"/>
          <ac:spMkLst>
            <pc:docMk/>
            <pc:sldMk cId="3167603900" sldId="257"/>
            <ac:spMk id="5" creationId="{36D4A4F6-EF9E-4C24-B1AF-F5E4E914E832}"/>
          </ac:spMkLst>
        </pc:spChg>
        <pc:spChg chg="mod">
          <ac:chgData name="Thu Huyen Pham" userId="3eb787573b41f7e6" providerId="LiveId" clId="{D21008C1-1F35-4EFD-920C-00227BB11F61}" dt="2019-04-09T11:25:48.336" v="3240" actId="1038"/>
          <ac:spMkLst>
            <pc:docMk/>
            <pc:sldMk cId="3167603900" sldId="257"/>
            <ac:spMk id="7" creationId="{51FA6AF8-392F-4641-AAD7-537A31C2C83B}"/>
          </ac:spMkLst>
        </pc:spChg>
        <pc:spChg chg="del">
          <ac:chgData name="Thu Huyen Pham" userId="3eb787573b41f7e6" providerId="LiveId" clId="{D21008C1-1F35-4EFD-920C-00227BB11F61}" dt="2019-03-17T12:51:25.915" v="2348" actId="478"/>
          <ac:spMkLst>
            <pc:docMk/>
            <pc:sldMk cId="3167603900" sldId="257"/>
            <ac:spMk id="8" creationId="{9C36D44F-51F7-4C7D-8EEA-02298A6ED4BA}"/>
          </ac:spMkLst>
        </pc:spChg>
        <pc:spChg chg="del">
          <ac:chgData name="Thu Huyen Pham" userId="3eb787573b41f7e6" providerId="LiveId" clId="{D21008C1-1F35-4EFD-920C-00227BB11F61}" dt="2019-03-17T12:51:25.915" v="2348" actId="478"/>
          <ac:spMkLst>
            <pc:docMk/>
            <pc:sldMk cId="3167603900" sldId="257"/>
            <ac:spMk id="9" creationId="{257F2758-9C02-4D38-BC8F-B81165BA6FA2}"/>
          </ac:spMkLst>
        </pc:spChg>
        <pc:spChg chg="mod ord">
          <ac:chgData name="Thu Huyen Pham" userId="3eb787573b41f7e6" providerId="LiveId" clId="{D21008C1-1F35-4EFD-920C-00227BB11F61}" dt="2019-04-09T11:25:48.336" v="3240" actId="1038"/>
          <ac:spMkLst>
            <pc:docMk/>
            <pc:sldMk cId="3167603900" sldId="257"/>
            <ac:spMk id="12" creationId="{DFFD46ED-186B-4714-8E35-DEDD8C12EA65}"/>
          </ac:spMkLst>
        </pc:spChg>
        <pc:spChg chg="mod ord">
          <ac:chgData name="Thu Huyen Pham" userId="3eb787573b41f7e6" providerId="LiveId" clId="{D21008C1-1F35-4EFD-920C-00227BB11F61}" dt="2019-04-09T11:25:48.336" v="3240" actId="1038"/>
          <ac:spMkLst>
            <pc:docMk/>
            <pc:sldMk cId="3167603900" sldId="257"/>
            <ac:spMk id="13" creationId="{3A2898AE-61A5-4E6F-9333-89FBC1E722E4}"/>
          </ac:spMkLst>
        </pc:spChg>
        <pc:spChg chg="del">
          <ac:chgData name="Thu Huyen Pham" userId="3eb787573b41f7e6" providerId="LiveId" clId="{D21008C1-1F35-4EFD-920C-00227BB11F61}" dt="2019-03-17T12:51:25.915" v="2348" actId="478"/>
          <ac:spMkLst>
            <pc:docMk/>
            <pc:sldMk cId="3167603900" sldId="257"/>
            <ac:spMk id="14" creationId="{7CF46B3E-3A6F-4B0A-8AD6-BE5700C310BF}"/>
          </ac:spMkLst>
        </pc:spChg>
        <pc:spChg chg="add mod">
          <ac:chgData name="Thu Huyen Pham" userId="3eb787573b41f7e6" providerId="LiveId" clId="{D21008C1-1F35-4EFD-920C-00227BB11F61}" dt="2019-04-09T12:04:29.057" v="3303" actId="1076"/>
          <ac:spMkLst>
            <pc:docMk/>
            <pc:sldMk cId="3167603900" sldId="257"/>
            <ac:spMk id="15" creationId="{3CF0093B-505E-4E57-8476-3C7B72F0C045}"/>
          </ac:spMkLst>
        </pc:spChg>
        <pc:spChg chg="add mod">
          <ac:chgData name="Thu Huyen Pham" userId="3eb787573b41f7e6" providerId="LiveId" clId="{D21008C1-1F35-4EFD-920C-00227BB11F61}" dt="2019-04-09T12:04:37.005" v="3304" actId="1076"/>
          <ac:spMkLst>
            <pc:docMk/>
            <pc:sldMk cId="3167603900" sldId="257"/>
            <ac:spMk id="16" creationId="{31D9C915-8D97-427F-898C-C0B1B5610F60}"/>
          </ac:spMkLst>
        </pc:spChg>
        <pc:spChg chg="del">
          <ac:chgData name="Thu Huyen Pham" userId="3eb787573b41f7e6" providerId="LiveId" clId="{D21008C1-1F35-4EFD-920C-00227BB11F61}" dt="2019-03-17T12:51:25.915" v="2348" actId="478"/>
          <ac:spMkLst>
            <pc:docMk/>
            <pc:sldMk cId="3167603900" sldId="257"/>
            <ac:spMk id="16" creationId="{3681D254-0856-45EE-9DAD-CF37AB0EF4AB}"/>
          </ac:spMkLst>
        </pc:spChg>
        <pc:spChg chg="add mod">
          <ac:chgData name="Thu Huyen Pham" userId="3eb787573b41f7e6" providerId="LiveId" clId="{D21008C1-1F35-4EFD-920C-00227BB11F61}" dt="2019-04-09T12:04:37.005" v="3304" actId="1076"/>
          <ac:spMkLst>
            <pc:docMk/>
            <pc:sldMk cId="3167603900" sldId="257"/>
            <ac:spMk id="17" creationId="{67917173-75AE-4646-A0B0-0ECD6FA491AF}"/>
          </ac:spMkLst>
        </pc:spChg>
        <pc:spChg chg="add mod">
          <ac:chgData name="Thu Huyen Pham" userId="3eb787573b41f7e6" providerId="LiveId" clId="{D21008C1-1F35-4EFD-920C-00227BB11F61}" dt="2019-04-09T11:48:32.776" v="3299" actId="1037"/>
          <ac:spMkLst>
            <pc:docMk/>
            <pc:sldMk cId="3167603900" sldId="257"/>
            <ac:spMk id="18" creationId="{156EC955-F388-4C0A-94B6-9D630EB635F1}"/>
          </ac:spMkLst>
        </pc:spChg>
        <pc:spChg chg="del">
          <ac:chgData name="Thu Huyen Pham" userId="3eb787573b41f7e6" providerId="LiveId" clId="{D21008C1-1F35-4EFD-920C-00227BB11F61}" dt="2019-03-17T12:51:25.915" v="2348" actId="478"/>
          <ac:spMkLst>
            <pc:docMk/>
            <pc:sldMk cId="3167603900" sldId="257"/>
            <ac:spMk id="18" creationId="{32312411-E6D7-4E32-82ED-8E6B1E544F7D}"/>
          </ac:spMkLst>
        </pc:spChg>
        <pc:spChg chg="del">
          <ac:chgData name="Thu Huyen Pham" userId="3eb787573b41f7e6" providerId="LiveId" clId="{D21008C1-1F35-4EFD-920C-00227BB11F61}" dt="2019-03-17T12:51:25.915" v="2348" actId="478"/>
          <ac:spMkLst>
            <pc:docMk/>
            <pc:sldMk cId="3167603900" sldId="257"/>
            <ac:spMk id="19" creationId="{CFBCD699-9A9D-4870-9EE1-C928A2F73363}"/>
          </ac:spMkLst>
        </pc:spChg>
        <pc:spChg chg="add mod ord">
          <ac:chgData name="Thu Huyen Pham" userId="3eb787573b41f7e6" providerId="LiveId" clId="{D21008C1-1F35-4EFD-920C-00227BB11F61}" dt="2019-04-09T11:25:48.336" v="3240" actId="1038"/>
          <ac:spMkLst>
            <pc:docMk/>
            <pc:sldMk cId="3167603900" sldId="257"/>
            <ac:spMk id="23" creationId="{AFF6ABB5-7952-4CC4-8EA8-D64E785DCFC0}"/>
          </ac:spMkLst>
        </pc:spChg>
        <pc:spChg chg="add mod ord">
          <ac:chgData name="Thu Huyen Pham" userId="3eb787573b41f7e6" providerId="LiveId" clId="{D21008C1-1F35-4EFD-920C-00227BB11F61}" dt="2019-04-09T11:25:48.336" v="3240" actId="1038"/>
          <ac:spMkLst>
            <pc:docMk/>
            <pc:sldMk cId="3167603900" sldId="257"/>
            <ac:spMk id="24" creationId="{8E948285-4864-4D48-99A8-CB9E6FECF7BE}"/>
          </ac:spMkLst>
        </pc:spChg>
        <pc:spChg chg="add del mod">
          <ac:chgData name="Thu Huyen Pham" userId="3eb787573b41f7e6" providerId="LiveId" clId="{D21008C1-1F35-4EFD-920C-00227BB11F61}" dt="2019-03-16T07:04:46.445" v="1148" actId="478"/>
          <ac:spMkLst>
            <pc:docMk/>
            <pc:sldMk cId="3167603900" sldId="257"/>
            <ac:spMk id="30" creationId="{9B1BE4CC-5F4B-4586-A45C-95AA9DC04093}"/>
          </ac:spMkLst>
        </pc:spChg>
        <pc:spChg chg="add mod">
          <ac:chgData name="Thu Huyen Pham" userId="3eb787573b41f7e6" providerId="LiveId" clId="{D21008C1-1F35-4EFD-920C-00227BB11F61}" dt="2019-03-17T12:51:33.895" v="2349" actId="1076"/>
          <ac:spMkLst>
            <pc:docMk/>
            <pc:sldMk cId="3167603900" sldId="257"/>
            <ac:spMk id="34" creationId="{82751969-E042-44DE-9CA6-6A062342F814}"/>
          </ac:spMkLst>
        </pc:spChg>
        <pc:spChg chg="add del mod">
          <ac:chgData name="Thu Huyen Pham" userId="3eb787573b41f7e6" providerId="LiveId" clId="{D21008C1-1F35-4EFD-920C-00227BB11F61}" dt="2019-03-17T12:49:37.206" v="2328"/>
          <ac:spMkLst>
            <pc:docMk/>
            <pc:sldMk cId="3167603900" sldId="257"/>
            <ac:spMk id="41" creationId="{EA51A71F-A582-4E1D-A54F-21CCCA165BBC}"/>
          </ac:spMkLst>
        </pc:spChg>
        <pc:spChg chg="add mod">
          <ac:chgData name="Thu Huyen Pham" userId="3eb787573b41f7e6" providerId="LiveId" clId="{D21008C1-1F35-4EFD-920C-00227BB11F61}" dt="2019-04-09T11:25:48.336" v="3240" actId="1038"/>
          <ac:spMkLst>
            <pc:docMk/>
            <pc:sldMk cId="3167603900" sldId="257"/>
            <ac:spMk id="42" creationId="{6A7394B3-88F3-40F2-B57D-A6D10D1B7AE0}"/>
          </ac:spMkLst>
        </pc:spChg>
        <pc:spChg chg="add mod">
          <ac:chgData name="Thu Huyen Pham" userId="3eb787573b41f7e6" providerId="LiveId" clId="{D21008C1-1F35-4EFD-920C-00227BB11F61}" dt="2019-04-09T11:25:48.336" v="3240" actId="1038"/>
          <ac:spMkLst>
            <pc:docMk/>
            <pc:sldMk cId="3167603900" sldId="257"/>
            <ac:spMk id="43" creationId="{575AC14D-CCC7-45A2-A913-ADB5BF7677AE}"/>
          </ac:spMkLst>
        </pc:spChg>
        <pc:spChg chg="add mod">
          <ac:chgData name="Thu Huyen Pham" userId="3eb787573b41f7e6" providerId="LiveId" clId="{D21008C1-1F35-4EFD-920C-00227BB11F61}" dt="2019-04-09T11:25:48.336" v="3240" actId="1038"/>
          <ac:spMkLst>
            <pc:docMk/>
            <pc:sldMk cId="3167603900" sldId="257"/>
            <ac:spMk id="44" creationId="{1A47D944-5C88-49FB-BED7-CE2B0BA44898}"/>
          </ac:spMkLst>
        </pc:spChg>
        <pc:picChg chg="add mod ord">
          <ac:chgData name="Thu Huyen Pham" userId="3eb787573b41f7e6" providerId="LiveId" clId="{D21008C1-1F35-4EFD-920C-00227BB11F61}" dt="2019-04-09T12:05:26.292" v="3311" actId="1076"/>
          <ac:picMkLst>
            <pc:docMk/>
            <pc:sldMk cId="3167603900" sldId="257"/>
            <ac:picMk id="2" creationId="{2DA1856D-60BE-40D8-AB9A-1724575E53C1}"/>
          </ac:picMkLst>
        </pc:picChg>
        <pc:picChg chg="del">
          <ac:chgData name="Thu Huyen Pham" userId="3eb787573b41f7e6" providerId="LiveId" clId="{D21008C1-1F35-4EFD-920C-00227BB11F61}" dt="2019-03-17T12:51:25.915" v="2348" actId="478"/>
          <ac:picMkLst>
            <pc:docMk/>
            <pc:sldMk cId="3167603900" sldId="257"/>
            <ac:picMk id="4" creationId="{51294A59-D5F9-440A-86AB-3AE3F4A4D2E3}"/>
          </ac:picMkLst>
        </pc:picChg>
        <pc:picChg chg="del">
          <ac:chgData name="Thu Huyen Pham" userId="3eb787573b41f7e6" providerId="LiveId" clId="{D21008C1-1F35-4EFD-920C-00227BB11F61}" dt="2019-03-17T12:51:25.915" v="2348" actId="478"/>
          <ac:picMkLst>
            <pc:docMk/>
            <pc:sldMk cId="3167603900" sldId="257"/>
            <ac:picMk id="6" creationId="{9AF3657A-9B4B-4611-9B77-BDC3A7A84052}"/>
          </ac:picMkLst>
        </pc:picChg>
        <pc:picChg chg="del">
          <ac:chgData name="Thu Huyen Pham" userId="3eb787573b41f7e6" providerId="LiveId" clId="{D21008C1-1F35-4EFD-920C-00227BB11F61}" dt="2019-03-17T12:51:25.915" v="2348" actId="478"/>
          <ac:picMkLst>
            <pc:docMk/>
            <pc:sldMk cId="3167603900" sldId="257"/>
            <ac:picMk id="10" creationId="{D9F5E1F9-81BF-4933-989A-698FB0BC15EA}"/>
          </ac:picMkLst>
        </pc:picChg>
        <pc:picChg chg="del">
          <ac:chgData name="Thu Huyen Pham" userId="3eb787573b41f7e6" providerId="LiveId" clId="{D21008C1-1F35-4EFD-920C-00227BB11F61}" dt="2019-03-17T12:51:25.915" v="2348" actId="478"/>
          <ac:picMkLst>
            <pc:docMk/>
            <pc:sldMk cId="3167603900" sldId="257"/>
            <ac:picMk id="11" creationId="{23D2CAD5-9576-4557-8AFC-598709470CD0}"/>
          </ac:picMkLst>
        </pc:picChg>
        <pc:picChg chg="add del mod modCrop">
          <ac:chgData name="Thu Huyen Pham" userId="3eb787573b41f7e6" providerId="LiveId" clId="{D21008C1-1F35-4EFD-920C-00227BB11F61}" dt="2019-04-09T12:05:11.090" v="3307" actId="478"/>
          <ac:picMkLst>
            <pc:docMk/>
            <pc:sldMk cId="3167603900" sldId="257"/>
            <ac:picMk id="14" creationId="{F6E35B40-EDF7-4FBB-9CE2-210CAF620625}"/>
          </ac:picMkLst>
        </pc:picChg>
        <pc:picChg chg="add del mod modCrop">
          <ac:chgData name="Thu Huyen Pham" userId="3eb787573b41f7e6" providerId="LiveId" clId="{D21008C1-1F35-4EFD-920C-00227BB11F61}" dt="2019-03-16T07:26:43.343" v="1408"/>
          <ac:picMkLst>
            <pc:docMk/>
            <pc:sldMk cId="3167603900" sldId="257"/>
            <ac:picMk id="21" creationId="{D999E8F9-B49F-4B4B-B2FF-4DE66FCE682A}"/>
          </ac:picMkLst>
        </pc:picChg>
        <pc:picChg chg="add del mod modCrop">
          <ac:chgData name="Thu Huyen Pham" userId="3eb787573b41f7e6" providerId="LiveId" clId="{D21008C1-1F35-4EFD-920C-00227BB11F61}" dt="2019-03-17T10:19:25.951" v="1734" actId="478"/>
          <ac:picMkLst>
            <pc:docMk/>
            <pc:sldMk cId="3167603900" sldId="257"/>
            <ac:picMk id="22" creationId="{138EECBF-0373-4181-B75A-619E3FBFCD8A}"/>
          </ac:picMkLst>
        </pc:picChg>
        <pc:picChg chg="add del mod modCrop">
          <ac:chgData name="Thu Huyen Pham" userId="3eb787573b41f7e6" providerId="LiveId" clId="{D21008C1-1F35-4EFD-920C-00227BB11F61}" dt="2019-03-16T07:26:43.343" v="1408"/>
          <ac:picMkLst>
            <pc:docMk/>
            <pc:sldMk cId="3167603900" sldId="257"/>
            <ac:picMk id="25" creationId="{99C9CF6B-7604-45D7-B693-72AC5A4D9588}"/>
          </ac:picMkLst>
        </pc:picChg>
        <pc:picChg chg="add del mod modCrop">
          <ac:chgData name="Thu Huyen Pham" userId="3eb787573b41f7e6" providerId="LiveId" clId="{D21008C1-1F35-4EFD-920C-00227BB11F61}" dt="2019-03-16T07:04:00.099" v="1138" actId="478"/>
          <ac:picMkLst>
            <pc:docMk/>
            <pc:sldMk cId="3167603900" sldId="257"/>
            <ac:picMk id="27" creationId="{D913495A-5E8A-4670-8E32-34C63B64CE67}"/>
          </ac:picMkLst>
        </pc:picChg>
        <pc:picChg chg="add del mod modCrop">
          <ac:chgData name="Thu Huyen Pham" userId="3eb787573b41f7e6" providerId="LiveId" clId="{D21008C1-1F35-4EFD-920C-00227BB11F61}" dt="2019-03-17T10:20:25.621" v="1748" actId="478"/>
          <ac:picMkLst>
            <pc:docMk/>
            <pc:sldMk cId="3167603900" sldId="257"/>
            <ac:picMk id="29" creationId="{D98FB833-FE6A-43DC-A964-191442E1DEFD}"/>
          </ac:picMkLst>
        </pc:picChg>
        <pc:picChg chg="add del mod modCrop">
          <ac:chgData name="Thu Huyen Pham" userId="3eb787573b41f7e6" providerId="LiveId" clId="{D21008C1-1F35-4EFD-920C-00227BB11F61}" dt="2019-03-16T07:26:43.343" v="1408"/>
          <ac:picMkLst>
            <pc:docMk/>
            <pc:sldMk cId="3167603900" sldId="257"/>
            <ac:picMk id="31" creationId="{9007F37B-067A-4C19-9288-EECD6013FE1B}"/>
          </ac:picMkLst>
        </pc:picChg>
        <pc:picChg chg="add del mod modCrop">
          <ac:chgData name="Thu Huyen Pham" userId="3eb787573b41f7e6" providerId="LiveId" clId="{D21008C1-1F35-4EFD-920C-00227BB11F61}" dt="2019-03-17T12:51:25.915" v="2348" actId="478"/>
          <ac:picMkLst>
            <pc:docMk/>
            <pc:sldMk cId="3167603900" sldId="257"/>
            <ac:picMk id="32" creationId="{7A51A03B-A65A-4D41-8BCD-A0E8F56B8DBF}"/>
          </ac:picMkLst>
        </pc:picChg>
        <pc:picChg chg="add del mod modCrop">
          <ac:chgData name="Thu Huyen Pham" userId="3eb787573b41f7e6" providerId="LiveId" clId="{D21008C1-1F35-4EFD-920C-00227BB11F61}" dt="2019-03-17T12:51:25.915" v="2348" actId="478"/>
          <ac:picMkLst>
            <pc:docMk/>
            <pc:sldMk cId="3167603900" sldId="257"/>
            <ac:picMk id="33" creationId="{F5102BBB-8B0A-460F-8425-8185A90F2581}"/>
          </ac:picMkLst>
        </pc:picChg>
        <pc:picChg chg="add del mod">
          <ac:chgData name="Thu Huyen Pham" userId="3eb787573b41f7e6" providerId="LiveId" clId="{D21008C1-1F35-4EFD-920C-00227BB11F61}" dt="2019-03-17T10:20:11.148" v="1744" actId="478"/>
          <ac:picMkLst>
            <pc:docMk/>
            <pc:sldMk cId="3167603900" sldId="257"/>
            <ac:picMk id="36" creationId="{DCF881A7-9032-4FE5-A5F8-0F466B1E9C49}"/>
          </ac:picMkLst>
        </pc:picChg>
        <pc:picChg chg="add mod">
          <ac:chgData name="Thu Huyen Pham" userId="3eb787573b41f7e6" providerId="LiveId" clId="{D21008C1-1F35-4EFD-920C-00227BB11F61}" dt="2019-04-09T11:25:48.336" v="3240" actId="1038"/>
          <ac:picMkLst>
            <pc:docMk/>
            <pc:sldMk cId="3167603900" sldId="257"/>
            <ac:picMk id="38" creationId="{82A9885C-613E-4B15-8C92-40941DA9ABBF}"/>
          </ac:picMkLst>
        </pc:picChg>
        <pc:picChg chg="add mod">
          <ac:chgData name="Thu Huyen Pham" userId="3eb787573b41f7e6" providerId="LiveId" clId="{D21008C1-1F35-4EFD-920C-00227BB11F61}" dt="2019-04-09T11:25:48.336" v="3240" actId="1038"/>
          <ac:picMkLst>
            <pc:docMk/>
            <pc:sldMk cId="3167603900" sldId="257"/>
            <ac:picMk id="40" creationId="{DAD76C37-6A73-4B02-ACAC-6CA6835627FB}"/>
          </ac:picMkLst>
        </pc:picChg>
        <pc:cxnChg chg="del">
          <ac:chgData name="Thu Huyen Pham" userId="3eb787573b41f7e6" providerId="LiveId" clId="{D21008C1-1F35-4EFD-920C-00227BB11F61}" dt="2019-03-17T12:51:25.915" v="2348" actId="478"/>
          <ac:cxnSpMkLst>
            <pc:docMk/>
            <pc:sldMk cId="3167603900" sldId="257"/>
            <ac:cxnSpMk id="15" creationId="{C8D2BCA8-F37E-4464-B323-387FF403292F}"/>
          </ac:cxnSpMkLst>
        </pc:cxnChg>
        <pc:cxnChg chg="del">
          <ac:chgData name="Thu Huyen Pham" userId="3eb787573b41f7e6" providerId="LiveId" clId="{D21008C1-1F35-4EFD-920C-00227BB11F61}" dt="2019-03-17T12:51:25.915" v="2348" actId="478"/>
          <ac:cxnSpMkLst>
            <pc:docMk/>
            <pc:sldMk cId="3167603900" sldId="257"/>
            <ac:cxnSpMk id="17" creationId="{922B123B-6D9A-44C0-A44C-871748345E0A}"/>
          </ac:cxnSpMkLst>
        </pc:cxnChg>
        <pc:cxnChg chg="del">
          <ac:chgData name="Thu Huyen Pham" userId="3eb787573b41f7e6" providerId="LiveId" clId="{D21008C1-1F35-4EFD-920C-00227BB11F61}" dt="2019-03-17T12:51:25.915" v="2348" actId="478"/>
          <ac:cxnSpMkLst>
            <pc:docMk/>
            <pc:sldMk cId="3167603900" sldId="257"/>
            <ac:cxnSpMk id="20" creationId="{CD958E69-A5C4-4A7D-A863-397728BB100A}"/>
          </ac:cxnSpMkLst>
        </pc:cxnChg>
      </pc:sldChg>
      <pc:sldChg chg="addSp delSp modSp">
        <pc:chgData name="Thu Huyen Pham" userId="3eb787573b41f7e6" providerId="LiveId" clId="{D21008C1-1F35-4EFD-920C-00227BB11F61}" dt="2019-03-17T12:59:37.251" v="2425" actId="14100"/>
        <pc:sldMkLst>
          <pc:docMk/>
          <pc:sldMk cId="1298440895" sldId="258"/>
        </pc:sldMkLst>
        <pc:spChg chg="del mod">
          <ac:chgData name="Thu Huyen Pham" userId="3eb787573b41f7e6" providerId="LiveId" clId="{D21008C1-1F35-4EFD-920C-00227BB11F61}" dt="2019-03-17T12:59:27.480" v="2424" actId="478"/>
          <ac:spMkLst>
            <pc:docMk/>
            <pc:sldMk cId="1298440895" sldId="258"/>
            <ac:spMk id="4" creationId="{7E9E08D5-41C2-4AD7-B777-9732F2CADB4D}"/>
          </ac:spMkLst>
        </pc:spChg>
        <pc:spChg chg="mod">
          <ac:chgData name="Thu Huyen Pham" userId="3eb787573b41f7e6" providerId="LiveId" clId="{D21008C1-1F35-4EFD-920C-00227BB11F61}" dt="2019-03-17T12:59:23.970" v="2423" actId="1076"/>
          <ac:spMkLst>
            <pc:docMk/>
            <pc:sldMk cId="1298440895" sldId="258"/>
            <ac:spMk id="5" creationId="{0E8D953B-3C5B-4070-BAFC-6051D24D03EB}"/>
          </ac:spMkLst>
        </pc:spChg>
        <pc:spChg chg="mod">
          <ac:chgData name="Thu Huyen Pham" userId="3eb787573b41f7e6" providerId="LiveId" clId="{D21008C1-1F35-4EFD-920C-00227BB11F61}" dt="2019-03-17T12:53:35.560" v="2369" actId="1036"/>
          <ac:spMkLst>
            <pc:docMk/>
            <pc:sldMk cId="1298440895" sldId="258"/>
            <ac:spMk id="7" creationId="{88EADD01-DDAA-4248-9614-075747192723}"/>
          </ac:spMkLst>
        </pc:spChg>
        <pc:spChg chg="mod">
          <ac:chgData name="Thu Huyen Pham" userId="3eb787573b41f7e6" providerId="LiveId" clId="{D21008C1-1F35-4EFD-920C-00227BB11F61}" dt="2019-03-17T12:53:35.560" v="2369" actId="1036"/>
          <ac:spMkLst>
            <pc:docMk/>
            <pc:sldMk cId="1298440895" sldId="258"/>
            <ac:spMk id="8" creationId="{4CEA4625-7986-4FBD-8289-5F959E24DD19}"/>
          </ac:spMkLst>
        </pc:spChg>
        <pc:spChg chg="mod">
          <ac:chgData name="Thu Huyen Pham" userId="3eb787573b41f7e6" providerId="LiveId" clId="{D21008C1-1F35-4EFD-920C-00227BB11F61}" dt="2019-03-17T12:53:35.560" v="2369" actId="1036"/>
          <ac:spMkLst>
            <pc:docMk/>
            <pc:sldMk cId="1298440895" sldId="258"/>
            <ac:spMk id="9" creationId="{7F923D79-1E85-45CE-B258-6576DEAA8684}"/>
          </ac:spMkLst>
        </pc:spChg>
        <pc:spChg chg="mod">
          <ac:chgData name="Thu Huyen Pham" userId="3eb787573b41f7e6" providerId="LiveId" clId="{D21008C1-1F35-4EFD-920C-00227BB11F61}" dt="2019-03-17T12:53:35.560" v="2369" actId="1036"/>
          <ac:spMkLst>
            <pc:docMk/>
            <pc:sldMk cId="1298440895" sldId="258"/>
            <ac:spMk id="11" creationId="{BBC47B88-6922-4905-B11E-26DCE22F8966}"/>
          </ac:spMkLst>
        </pc:spChg>
        <pc:spChg chg="mod">
          <ac:chgData name="Thu Huyen Pham" userId="3eb787573b41f7e6" providerId="LiveId" clId="{D21008C1-1F35-4EFD-920C-00227BB11F61}" dt="2019-03-17T12:53:35.560" v="2369" actId="1036"/>
          <ac:spMkLst>
            <pc:docMk/>
            <pc:sldMk cId="1298440895" sldId="258"/>
            <ac:spMk id="12" creationId="{F543379A-AE40-4F24-9D21-FAB329581410}"/>
          </ac:spMkLst>
        </pc:spChg>
        <pc:spChg chg="mod">
          <ac:chgData name="Thu Huyen Pham" userId="3eb787573b41f7e6" providerId="LiveId" clId="{D21008C1-1F35-4EFD-920C-00227BB11F61}" dt="2019-03-17T12:53:35.560" v="2369" actId="1036"/>
          <ac:spMkLst>
            <pc:docMk/>
            <pc:sldMk cId="1298440895" sldId="258"/>
            <ac:spMk id="13" creationId="{088CAF68-4D38-41EC-9929-37F7E34066FD}"/>
          </ac:spMkLst>
        </pc:spChg>
        <pc:spChg chg="add mod">
          <ac:chgData name="Thu Huyen Pham" userId="3eb787573b41f7e6" providerId="LiveId" clId="{D21008C1-1F35-4EFD-920C-00227BB11F61}" dt="2019-03-17T12:53:31.471" v="2360" actId="1076"/>
          <ac:spMkLst>
            <pc:docMk/>
            <pc:sldMk cId="1298440895" sldId="258"/>
            <ac:spMk id="33" creationId="{5250EE0E-24BF-4792-ADA6-C5407CA5C806}"/>
          </ac:spMkLst>
        </pc:spChg>
        <pc:spChg chg="add mod">
          <ac:chgData name="Thu Huyen Pham" userId="3eb787573b41f7e6" providerId="LiveId" clId="{D21008C1-1F35-4EFD-920C-00227BB11F61}" dt="2019-03-17T12:59:37.251" v="2425" actId="14100"/>
          <ac:spMkLst>
            <pc:docMk/>
            <pc:sldMk cId="1298440895" sldId="258"/>
            <ac:spMk id="34" creationId="{2928ECD2-3CD5-4FD3-B2BD-C887C4E1CD9F}"/>
          </ac:spMkLst>
        </pc:spChg>
        <pc:spChg chg="add mod">
          <ac:chgData name="Thu Huyen Pham" userId="3eb787573b41f7e6" providerId="LiveId" clId="{D21008C1-1F35-4EFD-920C-00227BB11F61}" dt="2019-03-17T12:54:14.153" v="2375" actId="1076"/>
          <ac:spMkLst>
            <pc:docMk/>
            <pc:sldMk cId="1298440895" sldId="258"/>
            <ac:spMk id="35" creationId="{27707DD0-B93F-4E6D-837A-690074972790}"/>
          </ac:spMkLst>
        </pc:spChg>
        <pc:spChg chg="add mod">
          <ac:chgData name="Thu Huyen Pham" userId="3eb787573b41f7e6" providerId="LiveId" clId="{D21008C1-1F35-4EFD-920C-00227BB11F61}" dt="2019-03-17T12:55:28.251" v="2389" actId="14100"/>
          <ac:spMkLst>
            <pc:docMk/>
            <pc:sldMk cId="1298440895" sldId="258"/>
            <ac:spMk id="36" creationId="{6BCC8588-761B-402A-83E0-7376E9B69396}"/>
          </ac:spMkLst>
        </pc:spChg>
        <pc:spChg chg="add del mod">
          <ac:chgData name="Thu Huyen Pham" userId="3eb787573b41f7e6" providerId="LiveId" clId="{D21008C1-1F35-4EFD-920C-00227BB11F61}" dt="2019-03-17T12:54:26.733" v="2378" actId="478"/>
          <ac:spMkLst>
            <pc:docMk/>
            <pc:sldMk cId="1298440895" sldId="258"/>
            <ac:spMk id="43" creationId="{FD729A7B-157C-4926-896F-200C4ACCB9A1}"/>
          </ac:spMkLst>
        </pc:spChg>
        <pc:spChg chg="add del mod">
          <ac:chgData name="Thu Huyen Pham" userId="3eb787573b41f7e6" providerId="LiveId" clId="{D21008C1-1F35-4EFD-920C-00227BB11F61}" dt="2019-03-17T12:54:28.462" v="2379" actId="478"/>
          <ac:spMkLst>
            <pc:docMk/>
            <pc:sldMk cId="1298440895" sldId="258"/>
            <ac:spMk id="44" creationId="{5AA073A0-4ADA-4A5B-AD2E-49A63CA82581}"/>
          </ac:spMkLst>
        </pc:spChg>
        <pc:spChg chg="add mod">
          <ac:chgData name="Thu Huyen Pham" userId="3eb787573b41f7e6" providerId="LiveId" clId="{D21008C1-1F35-4EFD-920C-00227BB11F61}" dt="2019-03-17T12:53:51.389" v="2371" actId="1076"/>
          <ac:spMkLst>
            <pc:docMk/>
            <pc:sldMk cId="1298440895" sldId="258"/>
            <ac:spMk id="46" creationId="{12114986-ED1A-44F2-B2E8-59BF87BB40EE}"/>
          </ac:spMkLst>
        </pc:spChg>
        <pc:spChg chg="add mod">
          <ac:chgData name="Thu Huyen Pham" userId="3eb787573b41f7e6" providerId="LiveId" clId="{D21008C1-1F35-4EFD-920C-00227BB11F61}" dt="2019-03-17T12:53:51.389" v="2371" actId="1076"/>
          <ac:spMkLst>
            <pc:docMk/>
            <pc:sldMk cId="1298440895" sldId="258"/>
            <ac:spMk id="47" creationId="{808F5F3D-09D4-46C8-8FDC-BB978DE0AD25}"/>
          </ac:spMkLst>
        </pc:spChg>
        <pc:spChg chg="add mod">
          <ac:chgData name="Thu Huyen Pham" userId="3eb787573b41f7e6" providerId="LiveId" clId="{D21008C1-1F35-4EFD-920C-00227BB11F61}" dt="2019-03-17T12:53:51.389" v="2371" actId="1076"/>
          <ac:spMkLst>
            <pc:docMk/>
            <pc:sldMk cId="1298440895" sldId="258"/>
            <ac:spMk id="48" creationId="{8EFFFB30-9062-48B0-A557-CF68B69DB833}"/>
          </ac:spMkLst>
        </pc:spChg>
        <pc:spChg chg="add mod">
          <ac:chgData name="Thu Huyen Pham" userId="3eb787573b41f7e6" providerId="LiveId" clId="{D21008C1-1F35-4EFD-920C-00227BB11F61}" dt="2019-03-17T12:53:51.389" v="2371" actId="1076"/>
          <ac:spMkLst>
            <pc:docMk/>
            <pc:sldMk cId="1298440895" sldId="258"/>
            <ac:spMk id="50" creationId="{6E82EC7A-361E-48EE-85F1-A1EBDE970B5C}"/>
          </ac:spMkLst>
        </pc:spChg>
        <pc:spChg chg="add mod">
          <ac:chgData name="Thu Huyen Pham" userId="3eb787573b41f7e6" providerId="LiveId" clId="{D21008C1-1F35-4EFD-920C-00227BB11F61}" dt="2019-03-17T12:53:51.389" v="2371" actId="1076"/>
          <ac:spMkLst>
            <pc:docMk/>
            <pc:sldMk cId="1298440895" sldId="258"/>
            <ac:spMk id="51" creationId="{084D056D-C48C-4346-87AF-9C283BEC32B7}"/>
          </ac:spMkLst>
        </pc:spChg>
        <pc:spChg chg="add mod">
          <ac:chgData name="Thu Huyen Pham" userId="3eb787573b41f7e6" providerId="LiveId" clId="{D21008C1-1F35-4EFD-920C-00227BB11F61}" dt="2019-03-17T12:53:51.389" v="2371" actId="1076"/>
          <ac:spMkLst>
            <pc:docMk/>
            <pc:sldMk cId="1298440895" sldId="258"/>
            <ac:spMk id="52" creationId="{46131C59-7E33-44F4-82B5-8E74E7C3C3E8}"/>
          </ac:spMkLst>
        </pc:spChg>
        <pc:spChg chg="add mod">
          <ac:chgData name="Thu Huyen Pham" userId="3eb787573b41f7e6" providerId="LiveId" clId="{D21008C1-1F35-4EFD-920C-00227BB11F61}" dt="2019-03-17T12:54:59.142" v="2383" actId="1076"/>
          <ac:spMkLst>
            <pc:docMk/>
            <pc:sldMk cId="1298440895" sldId="258"/>
            <ac:spMk id="54" creationId="{EB6F3E53-C4AE-40C9-8C88-05D01F6EB585}"/>
          </ac:spMkLst>
        </pc:spChg>
        <pc:spChg chg="add mod">
          <ac:chgData name="Thu Huyen Pham" userId="3eb787573b41f7e6" providerId="LiveId" clId="{D21008C1-1F35-4EFD-920C-00227BB11F61}" dt="2019-03-17T12:54:59.142" v="2383" actId="1076"/>
          <ac:spMkLst>
            <pc:docMk/>
            <pc:sldMk cId="1298440895" sldId="258"/>
            <ac:spMk id="55" creationId="{973A8BAE-39F4-46F0-8EA8-C3CD8BF10E7B}"/>
          </ac:spMkLst>
        </pc:spChg>
        <pc:spChg chg="add mod">
          <ac:chgData name="Thu Huyen Pham" userId="3eb787573b41f7e6" providerId="LiveId" clId="{D21008C1-1F35-4EFD-920C-00227BB11F61}" dt="2019-03-17T12:54:59.142" v="2383" actId="1076"/>
          <ac:spMkLst>
            <pc:docMk/>
            <pc:sldMk cId="1298440895" sldId="258"/>
            <ac:spMk id="56" creationId="{429AD8BE-1177-4200-A069-F806D2BAB821}"/>
          </ac:spMkLst>
        </pc:spChg>
        <pc:spChg chg="add mod">
          <ac:chgData name="Thu Huyen Pham" userId="3eb787573b41f7e6" providerId="LiveId" clId="{D21008C1-1F35-4EFD-920C-00227BB11F61}" dt="2019-03-17T12:54:59.142" v="2383" actId="1076"/>
          <ac:spMkLst>
            <pc:docMk/>
            <pc:sldMk cId="1298440895" sldId="258"/>
            <ac:spMk id="58" creationId="{0F6EA5E4-26D5-4CD5-87D3-8A4C47EE29FD}"/>
          </ac:spMkLst>
        </pc:spChg>
        <pc:spChg chg="add mod">
          <ac:chgData name="Thu Huyen Pham" userId="3eb787573b41f7e6" providerId="LiveId" clId="{D21008C1-1F35-4EFD-920C-00227BB11F61}" dt="2019-03-17T12:54:59.142" v="2383" actId="1076"/>
          <ac:spMkLst>
            <pc:docMk/>
            <pc:sldMk cId="1298440895" sldId="258"/>
            <ac:spMk id="59" creationId="{4309513E-DD15-4E93-BC9C-1645584B3F47}"/>
          </ac:spMkLst>
        </pc:spChg>
        <pc:spChg chg="add mod">
          <ac:chgData name="Thu Huyen Pham" userId="3eb787573b41f7e6" providerId="LiveId" clId="{D21008C1-1F35-4EFD-920C-00227BB11F61}" dt="2019-03-17T12:54:59.142" v="2383" actId="1076"/>
          <ac:spMkLst>
            <pc:docMk/>
            <pc:sldMk cId="1298440895" sldId="258"/>
            <ac:spMk id="60" creationId="{7C6387E8-64BC-47D9-8845-C7F4D99276B4}"/>
          </ac:spMkLst>
        </pc:spChg>
        <pc:spChg chg="add mod">
          <ac:chgData name="Thu Huyen Pham" userId="3eb787573b41f7e6" providerId="LiveId" clId="{D21008C1-1F35-4EFD-920C-00227BB11F61}" dt="2019-03-17T12:59:14.757" v="2421" actId="1076"/>
          <ac:spMkLst>
            <pc:docMk/>
            <pc:sldMk cId="1298440895" sldId="258"/>
            <ac:spMk id="61" creationId="{E220AC30-68DF-4274-AE46-2F8982F965DC}"/>
          </ac:spMkLst>
        </pc:spChg>
        <pc:spChg chg="add mod">
          <ac:chgData name="Thu Huyen Pham" userId="3eb787573b41f7e6" providerId="LiveId" clId="{D21008C1-1F35-4EFD-920C-00227BB11F61}" dt="2019-03-17T12:59:07.267" v="2420" actId="1076"/>
          <ac:spMkLst>
            <pc:docMk/>
            <pc:sldMk cId="1298440895" sldId="258"/>
            <ac:spMk id="62" creationId="{359C2DF2-0F24-428D-BF88-1049907B36E1}"/>
          </ac:spMkLst>
        </pc:spChg>
        <pc:picChg chg="del mod">
          <ac:chgData name="Thu Huyen Pham" userId="3eb787573b41f7e6" providerId="LiveId" clId="{D21008C1-1F35-4EFD-920C-00227BB11F61}" dt="2019-03-17T12:59:27.480" v="2424" actId="478"/>
          <ac:picMkLst>
            <pc:docMk/>
            <pc:sldMk cId="1298440895" sldId="258"/>
            <ac:picMk id="14" creationId="{3CD6E552-C012-451B-9C10-C81049129040}"/>
          </ac:picMkLst>
        </pc:picChg>
        <pc:picChg chg="del mod">
          <ac:chgData name="Thu Huyen Pham" userId="3eb787573b41f7e6" providerId="LiveId" clId="{D21008C1-1F35-4EFD-920C-00227BB11F61}" dt="2019-03-17T12:59:27.480" v="2424" actId="478"/>
          <ac:picMkLst>
            <pc:docMk/>
            <pc:sldMk cId="1298440895" sldId="258"/>
            <ac:picMk id="15" creationId="{DB2AFF4B-E449-412C-B3BB-A71BC114193E}"/>
          </ac:picMkLst>
        </pc:picChg>
        <pc:picChg chg="del mod">
          <ac:chgData name="Thu Huyen Pham" userId="3eb787573b41f7e6" providerId="LiveId" clId="{D21008C1-1F35-4EFD-920C-00227BB11F61}" dt="2019-03-17T12:59:27.480" v="2424" actId="478"/>
          <ac:picMkLst>
            <pc:docMk/>
            <pc:sldMk cId="1298440895" sldId="258"/>
            <ac:picMk id="16" creationId="{341D68A3-9E3D-4938-9F2A-CB97272E5709}"/>
          </ac:picMkLst>
        </pc:picChg>
        <pc:picChg chg="add del mod modCrop">
          <ac:chgData name="Thu Huyen Pham" userId="3eb787573b41f7e6" providerId="LiveId" clId="{D21008C1-1F35-4EFD-920C-00227BB11F61}" dt="2019-03-16T02:36:13.923" v="445" actId="478"/>
          <ac:picMkLst>
            <pc:docMk/>
            <pc:sldMk cId="1298440895" sldId="258"/>
            <ac:picMk id="17" creationId="{ED912681-7FB1-4302-BB9B-73BF0BCC0192}"/>
          </ac:picMkLst>
        </pc:picChg>
        <pc:picChg chg="add del mod modCrop">
          <ac:chgData name="Thu Huyen Pham" userId="3eb787573b41f7e6" providerId="LiveId" clId="{D21008C1-1F35-4EFD-920C-00227BB11F61}" dt="2019-03-17T10:31:21.976" v="1885"/>
          <ac:picMkLst>
            <pc:docMk/>
            <pc:sldMk cId="1298440895" sldId="258"/>
            <ac:picMk id="19" creationId="{F78C3AD9-7295-4D29-92E2-171066939457}"/>
          </ac:picMkLst>
        </pc:picChg>
        <pc:picChg chg="add del mod modCrop">
          <ac:chgData name="Thu Huyen Pham" userId="3eb787573b41f7e6" providerId="LiveId" clId="{D21008C1-1F35-4EFD-920C-00227BB11F61}" dt="2019-03-17T10:31:21.976" v="1885"/>
          <ac:picMkLst>
            <pc:docMk/>
            <pc:sldMk cId="1298440895" sldId="258"/>
            <ac:picMk id="20" creationId="{3D093AD0-11C9-42FB-BE12-2CC37394E4BD}"/>
          </ac:picMkLst>
        </pc:picChg>
        <pc:picChg chg="add del mod">
          <ac:chgData name="Thu Huyen Pham" userId="3eb787573b41f7e6" providerId="LiveId" clId="{D21008C1-1F35-4EFD-920C-00227BB11F61}" dt="2019-03-16T04:35:16.619" v="557" actId="478"/>
          <ac:picMkLst>
            <pc:docMk/>
            <pc:sldMk cId="1298440895" sldId="258"/>
            <ac:picMk id="21" creationId="{65FEAFFB-2B76-425F-8F52-B58093B6DCF2}"/>
          </ac:picMkLst>
        </pc:picChg>
        <pc:picChg chg="add del mod">
          <ac:chgData name="Thu Huyen Pham" userId="3eb787573b41f7e6" providerId="LiveId" clId="{D21008C1-1F35-4EFD-920C-00227BB11F61}" dt="2019-03-16T04:23:37.117" v="498" actId="478"/>
          <ac:picMkLst>
            <pc:docMk/>
            <pc:sldMk cId="1298440895" sldId="258"/>
            <ac:picMk id="22" creationId="{59A76593-EB4A-421C-9471-909264B4411C}"/>
          </ac:picMkLst>
        </pc:picChg>
        <pc:picChg chg="add del mod modCrop">
          <ac:chgData name="Thu Huyen Pham" userId="3eb787573b41f7e6" providerId="LiveId" clId="{D21008C1-1F35-4EFD-920C-00227BB11F61}" dt="2019-03-17T12:58:06.363" v="2408"/>
          <ac:picMkLst>
            <pc:docMk/>
            <pc:sldMk cId="1298440895" sldId="258"/>
            <ac:picMk id="23" creationId="{855DFAEF-62A2-43BE-AD18-81624F88B659}"/>
          </ac:picMkLst>
        </pc:picChg>
        <pc:picChg chg="add del mod modCrop">
          <ac:chgData name="Thu Huyen Pham" userId="3eb787573b41f7e6" providerId="LiveId" clId="{D21008C1-1F35-4EFD-920C-00227BB11F61}" dt="2019-03-17T12:58:06.363" v="2408"/>
          <ac:picMkLst>
            <pc:docMk/>
            <pc:sldMk cId="1298440895" sldId="258"/>
            <ac:picMk id="24" creationId="{CABEBEB0-61F0-44CF-A573-3B6919DF93A7}"/>
          </ac:picMkLst>
        </pc:picChg>
        <pc:picChg chg="add del mod modCrop">
          <ac:chgData name="Thu Huyen Pham" userId="3eb787573b41f7e6" providerId="LiveId" clId="{D21008C1-1F35-4EFD-920C-00227BB11F61}" dt="2019-03-17T12:58:06.363" v="2408"/>
          <ac:picMkLst>
            <pc:docMk/>
            <pc:sldMk cId="1298440895" sldId="258"/>
            <ac:picMk id="25" creationId="{32A986C5-DE0B-495C-9131-9BFA73A1C940}"/>
          </ac:picMkLst>
        </pc:picChg>
        <pc:picChg chg="add del mod modCrop">
          <ac:chgData name="Thu Huyen Pham" userId="3eb787573b41f7e6" providerId="LiveId" clId="{D21008C1-1F35-4EFD-920C-00227BB11F61}" dt="2019-03-17T12:57:12.524" v="2390" actId="478"/>
          <ac:picMkLst>
            <pc:docMk/>
            <pc:sldMk cId="1298440895" sldId="258"/>
            <ac:picMk id="26" creationId="{77691BC5-F1DC-4534-9E2E-E9B212F6A7A4}"/>
          </ac:picMkLst>
        </pc:picChg>
        <pc:picChg chg="add del mod modCrop">
          <ac:chgData name="Thu Huyen Pham" userId="3eb787573b41f7e6" providerId="LiveId" clId="{D21008C1-1F35-4EFD-920C-00227BB11F61}" dt="2019-03-17T12:58:06.363" v="2408"/>
          <ac:picMkLst>
            <pc:docMk/>
            <pc:sldMk cId="1298440895" sldId="258"/>
            <ac:picMk id="28" creationId="{4E44F693-4625-4062-860F-F466855E7074}"/>
          </ac:picMkLst>
        </pc:picChg>
        <pc:picChg chg="add del mod">
          <ac:chgData name="Thu Huyen Pham" userId="3eb787573b41f7e6" providerId="LiveId" clId="{D21008C1-1F35-4EFD-920C-00227BB11F61}" dt="2019-03-17T10:31:21.976" v="1885"/>
          <ac:picMkLst>
            <pc:docMk/>
            <pc:sldMk cId="1298440895" sldId="258"/>
            <ac:picMk id="29" creationId="{E36451C1-D391-42D4-BE16-6011D76EF189}"/>
          </ac:picMkLst>
        </pc:picChg>
        <pc:picChg chg="add del mod modCrop">
          <ac:chgData name="Thu Huyen Pham" userId="3eb787573b41f7e6" providerId="LiveId" clId="{D21008C1-1F35-4EFD-920C-00227BB11F61}" dt="2019-03-17T12:58:06.363" v="2408"/>
          <ac:picMkLst>
            <pc:docMk/>
            <pc:sldMk cId="1298440895" sldId="258"/>
            <ac:picMk id="31" creationId="{0A020EC8-B61F-424D-A9E9-D41C6082A335}"/>
          </ac:picMkLst>
        </pc:picChg>
        <pc:picChg chg="add del mod">
          <ac:chgData name="Thu Huyen Pham" userId="3eb787573b41f7e6" providerId="LiveId" clId="{D21008C1-1F35-4EFD-920C-00227BB11F61}" dt="2019-03-16T05:33:39.011" v="803"/>
          <ac:picMkLst>
            <pc:docMk/>
            <pc:sldMk cId="1298440895" sldId="258"/>
            <ac:picMk id="32" creationId="{E16AC9E6-2B3B-436E-9EB6-61E0373CAEC6}"/>
          </ac:picMkLst>
        </pc:picChg>
        <pc:picChg chg="add mod ord">
          <ac:chgData name="Thu Huyen Pham" userId="3eb787573b41f7e6" providerId="LiveId" clId="{D21008C1-1F35-4EFD-920C-00227BB11F61}" dt="2019-03-17T12:55:16.970" v="2387" actId="1076"/>
          <ac:picMkLst>
            <pc:docMk/>
            <pc:sldMk cId="1298440895" sldId="258"/>
            <ac:picMk id="38" creationId="{7B2A5339-D828-405D-8B11-B0DEC55B553F}"/>
          </ac:picMkLst>
        </pc:picChg>
        <pc:picChg chg="add mod ord">
          <ac:chgData name="Thu Huyen Pham" userId="3eb787573b41f7e6" providerId="LiveId" clId="{D21008C1-1F35-4EFD-920C-00227BB11F61}" dt="2019-03-17T12:53:35.560" v="2369" actId="1036"/>
          <ac:picMkLst>
            <pc:docMk/>
            <pc:sldMk cId="1298440895" sldId="258"/>
            <ac:picMk id="40" creationId="{4724F865-D63C-4E38-9531-048D89D2BC87}"/>
          </ac:picMkLst>
        </pc:picChg>
        <pc:picChg chg="add mod ord">
          <ac:chgData name="Thu Huyen Pham" userId="3eb787573b41f7e6" providerId="LiveId" clId="{D21008C1-1F35-4EFD-920C-00227BB11F61}" dt="2019-03-17T12:54:08.901" v="2374" actId="1076"/>
          <ac:picMkLst>
            <pc:docMk/>
            <pc:sldMk cId="1298440895" sldId="258"/>
            <ac:picMk id="42" creationId="{B8BFD923-2E0A-4AFE-B7BB-22AF26844B35}"/>
          </ac:picMkLst>
        </pc:picChg>
        <pc:cxnChg chg="mod">
          <ac:chgData name="Thu Huyen Pham" userId="3eb787573b41f7e6" providerId="LiveId" clId="{D21008C1-1F35-4EFD-920C-00227BB11F61}" dt="2019-03-17T12:53:35.560" v="2369" actId="1036"/>
          <ac:cxnSpMkLst>
            <pc:docMk/>
            <pc:sldMk cId="1298440895" sldId="258"/>
            <ac:cxnSpMk id="6" creationId="{3D3B9303-0095-4330-8BB8-C1B2DC1000F9}"/>
          </ac:cxnSpMkLst>
        </pc:cxnChg>
        <pc:cxnChg chg="mod">
          <ac:chgData name="Thu Huyen Pham" userId="3eb787573b41f7e6" providerId="LiveId" clId="{D21008C1-1F35-4EFD-920C-00227BB11F61}" dt="2019-03-17T12:53:35.560" v="2369" actId="1036"/>
          <ac:cxnSpMkLst>
            <pc:docMk/>
            <pc:sldMk cId="1298440895" sldId="258"/>
            <ac:cxnSpMk id="10" creationId="{62EC7DB2-4F40-4848-A39E-DEDEB68D4E20}"/>
          </ac:cxnSpMkLst>
        </pc:cxnChg>
        <pc:cxnChg chg="add mod">
          <ac:chgData name="Thu Huyen Pham" userId="3eb787573b41f7e6" providerId="LiveId" clId="{D21008C1-1F35-4EFD-920C-00227BB11F61}" dt="2019-03-17T12:53:51.389" v="2371" actId="1076"/>
          <ac:cxnSpMkLst>
            <pc:docMk/>
            <pc:sldMk cId="1298440895" sldId="258"/>
            <ac:cxnSpMk id="45" creationId="{4116A037-27E7-4E9B-A142-53F74E599127}"/>
          </ac:cxnSpMkLst>
        </pc:cxnChg>
        <pc:cxnChg chg="add mod">
          <ac:chgData name="Thu Huyen Pham" userId="3eb787573b41f7e6" providerId="LiveId" clId="{D21008C1-1F35-4EFD-920C-00227BB11F61}" dt="2019-03-17T12:53:51.389" v="2371" actId="1076"/>
          <ac:cxnSpMkLst>
            <pc:docMk/>
            <pc:sldMk cId="1298440895" sldId="258"/>
            <ac:cxnSpMk id="49" creationId="{9AD96578-181B-4AE8-9815-F3A8670A5C08}"/>
          </ac:cxnSpMkLst>
        </pc:cxnChg>
        <pc:cxnChg chg="add mod">
          <ac:chgData name="Thu Huyen Pham" userId="3eb787573b41f7e6" providerId="LiveId" clId="{D21008C1-1F35-4EFD-920C-00227BB11F61}" dt="2019-03-17T12:54:59.142" v="2383" actId="1076"/>
          <ac:cxnSpMkLst>
            <pc:docMk/>
            <pc:sldMk cId="1298440895" sldId="258"/>
            <ac:cxnSpMk id="53" creationId="{164C3896-4E16-47D5-AAD9-FC6D05F4DA7A}"/>
          </ac:cxnSpMkLst>
        </pc:cxnChg>
        <pc:cxnChg chg="add mod">
          <ac:chgData name="Thu Huyen Pham" userId="3eb787573b41f7e6" providerId="LiveId" clId="{D21008C1-1F35-4EFD-920C-00227BB11F61}" dt="2019-03-17T12:54:59.142" v="2383" actId="1076"/>
          <ac:cxnSpMkLst>
            <pc:docMk/>
            <pc:sldMk cId="1298440895" sldId="258"/>
            <ac:cxnSpMk id="57" creationId="{8F3D8BD8-9BC4-4061-876F-AF0D1DF51989}"/>
          </ac:cxnSpMkLst>
        </pc:cxnChg>
      </pc:sldChg>
      <pc:sldChg chg="addSp delSp modSp">
        <pc:chgData name="Thu Huyen Pham" userId="3eb787573b41f7e6" providerId="LiveId" clId="{D21008C1-1F35-4EFD-920C-00227BB11F61}" dt="2019-03-17T12:45:16.134" v="2315" actId="478"/>
        <pc:sldMkLst>
          <pc:docMk/>
          <pc:sldMk cId="2705666942" sldId="259"/>
        </pc:sldMkLst>
        <pc:spChg chg="mod">
          <ac:chgData name="Thu Huyen Pham" userId="3eb787573b41f7e6" providerId="LiveId" clId="{D21008C1-1F35-4EFD-920C-00227BB11F61}" dt="2019-03-17T12:43:08.697" v="2263" actId="1037"/>
          <ac:spMkLst>
            <pc:docMk/>
            <pc:sldMk cId="2705666942" sldId="259"/>
            <ac:spMk id="8" creationId="{DA5AB784-0D47-4268-A045-F33E7A57DE7C}"/>
          </ac:spMkLst>
        </pc:spChg>
        <pc:spChg chg="mod">
          <ac:chgData name="Thu Huyen Pham" userId="3eb787573b41f7e6" providerId="LiveId" clId="{D21008C1-1F35-4EFD-920C-00227BB11F61}" dt="2019-03-17T12:43:08.697" v="2263" actId="1037"/>
          <ac:spMkLst>
            <pc:docMk/>
            <pc:sldMk cId="2705666942" sldId="259"/>
            <ac:spMk id="9" creationId="{645A28B2-27AA-4EA9-99A4-B0D145003D43}"/>
          </ac:spMkLst>
        </pc:spChg>
        <pc:spChg chg="mod">
          <ac:chgData name="Thu Huyen Pham" userId="3eb787573b41f7e6" providerId="LiveId" clId="{D21008C1-1F35-4EFD-920C-00227BB11F61}" dt="2019-03-17T12:44:49.335" v="2310" actId="1036"/>
          <ac:spMkLst>
            <pc:docMk/>
            <pc:sldMk cId="2705666942" sldId="259"/>
            <ac:spMk id="10" creationId="{EC2A1826-94BD-4B16-95DF-8C7F54C4509C}"/>
          </ac:spMkLst>
        </pc:spChg>
        <pc:spChg chg="del">
          <ac:chgData name="Thu Huyen Pham" userId="3eb787573b41f7e6" providerId="LiveId" clId="{D21008C1-1F35-4EFD-920C-00227BB11F61}" dt="2019-03-17T12:45:16.134" v="2315" actId="478"/>
          <ac:spMkLst>
            <pc:docMk/>
            <pc:sldMk cId="2705666942" sldId="259"/>
            <ac:spMk id="11" creationId="{3FF9A0E6-C492-4C91-B15C-BAED9148C3EB}"/>
          </ac:spMkLst>
        </pc:spChg>
        <pc:spChg chg="del">
          <ac:chgData name="Thu Huyen Pham" userId="3eb787573b41f7e6" providerId="LiveId" clId="{D21008C1-1F35-4EFD-920C-00227BB11F61}" dt="2019-03-17T12:45:16.134" v="2315" actId="478"/>
          <ac:spMkLst>
            <pc:docMk/>
            <pc:sldMk cId="2705666942" sldId="259"/>
            <ac:spMk id="12" creationId="{6455F6DF-E804-4F5C-B6C6-B381C3F25B1F}"/>
          </ac:spMkLst>
        </pc:spChg>
        <pc:spChg chg="del">
          <ac:chgData name="Thu Huyen Pham" userId="3eb787573b41f7e6" providerId="LiveId" clId="{D21008C1-1F35-4EFD-920C-00227BB11F61}" dt="2019-03-17T12:45:16.134" v="2315" actId="478"/>
          <ac:spMkLst>
            <pc:docMk/>
            <pc:sldMk cId="2705666942" sldId="259"/>
            <ac:spMk id="13" creationId="{F3D3E424-5812-4875-B430-05C949791DA5}"/>
          </ac:spMkLst>
        </pc:spChg>
        <pc:spChg chg="mod">
          <ac:chgData name="Thu Huyen Pham" userId="3eb787573b41f7e6" providerId="LiveId" clId="{D21008C1-1F35-4EFD-920C-00227BB11F61}" dt="2019-03-17T12:44:49.335" v="2310" actId="1036"/>
          <ac:spMkLst>
            <pc:docMk/>
            <pc:sldMk cId="2705666942" sldId="259"/>
            <ac:spMk id="16" creationId="{FDE204A6-61E4-4ABB-B646-8498BF529592}"/>
          </ac:spMkLst>
        </pc:spChg>
        <pc:spChg chg="del">
          <ac:chgData name="Thu Huyen Pham" userId="3eb787573b41f7e6" providerId="LiveId" clId="{D21008C1-1F35-4EFD-920C-00227BB11F61}" dt="2019-03-17T12:45:16.134" v="2315" actId="478"/>
          <ac:spMkLst>
            <pc:docMk/>
            <pc:sldMk cId="2705666942" sldId="259"/>
            <ac:spMk id="17" creationId="{51E05FFD-A4DA-4F6D-9545-636485E77FDF}"/>
          </ac:spMkLst>
        </pc:spChg>
        <pc:spChg chg="del">
          <ac:chgData name="Thu Huyen Pham" userId="3eb787573b41f7e6" providerId="LiveId" clId="{D21008C1-1F35-4EFD-920C-00227BB11F61}" dt="2019-03-17T12:45:16.134" v="2315" actId="478"/>
          <ac:spMkLst>
            <pc:docMk/>
            <pc:sldMk cId="2705666942" sldId="259"/>
            <ac:spMk id="18" creationId="{177C6C51-E634-4168-975D-53461AD11F57}"/>
          </ac:spMkLst>
        </pc:spChg>
        <pc:spChg chg="add mod">
          <ac:chgData name="Thu Huyen Pham" userId="3eb787573b41f7e6" providerId="LiveId" clId="{D21008C1-1F35-4EFD-920C-00227BB11F61}" dt="2019-03-17T12:44:49.335" v="2310" actId="1036"/>
          <ac:spMkLst>
            <pc:docMk/>
            <pc:sldMk cId="2705666942" sldId="259"/>
            <ac:spMk id="25" creationId="{A906576B-B11D-4645-A98C-C76BE63E2D6C}"/>
          </ac:spMkLst>
        </pc:spChg>
        <pc:spChg chg="add mod">
          <ac:chgData name="Thu Huyen Pham" userId="3eb787573b41f7e6" providerId="LiveId" clId="{D21008C1-1F35-4EFD-920C-00227BB11F61}" dt="2019-03-17T12:44:49.335" v="2310" actId="1036"/>
          <ac:spMkLst>
            <pc:docMk/>
            <pc:sldMk cId="2705666942" sldId="259"/>
            <ac:spMk id="26" creationId="{1EAFBC4D-B4C4-4046-8A90-1411160414CA}"/>
          </ac:spMkLst>
        </pc:spChg>
        <pc:spChg chg="add mod">
          <ac:chgData name="Thu Huyen Pham" userId="3eb787573b41f7e6" providerId="LiveId" clId="{D21008C1-1F35-4EFD-920C-00227BB11F61}" dt="2019-03-17T12:43:30.715" v="2265" actId="1076"/>
          <ac:spMkLst>
            <pc:docMk/>
            <pc:sldMk cId="2705666942" sldId="259"/>
            <ac:spMk id="27" creationId="{E6F88364-3AA8-42CE-937B-773B889259F0}"/>
          </ac:spMkLst>
        </pc:spChg>
        <pc:spChg chg="add mod">
          <ac:chgData name="Thu Huyen Pham" userId="3eb787573b41f7e6" providerId="LiveId" clId="{D21008C1-1F35-4EFD-920C-00227BB11F61}" dt="2019-03-17T12:43:58.384" v="2289" actId="1037"/>
          <ac:spMkLst>
            <pc:docMk/>
            <pc:sldMk cId="2705666942" sldId="259"/>
            <ac:spMk id="28" creationId="{3FFE8A84-3F29-4908-87B4-B6C556C06331}"/>
          </ac:spMkLst>
        </pc:spChg>
        <pc:spChg chg="add mod">
          <ac:chgData name="Thu Huyen Pham" userId="3eb787573b41f7e6" providerId="LiveId" clId="{D21008C1-1F35-4EFD-920C-00227BB11F61}" dt="2019-03-17T12:43:58.384" v="2289" actId="1037"/>
          <ac:spMkLst>
            <pc:docMk/>
            <pc:sldMk cId="2705666942" sldId="259"/>
            <ac:spMk id="29" creationId="{28B1D11F-C188-45D2-A4A6-D5F356A74D11}"/>
          </ac:spMkLst>
        </pc:spChg>
        <pc:spChg chg="add del mod">
          <ac:chgData name="Thu Huyen Pham" userId="3eb787573b41f7e6" providerId="LiveId" clId="{D21008C1-1F35-4EFD-920C-00227BB11F61}" dt="2019-03-17T12:42:41.209" v="2249" actId="478"/>
          <ac:spMkLst>
            <pc:docMk/>
            <pc:sldMk cId="2705666942" sldId="259"/>
            <ac:spMk id="40" creationId="{6583DBBC-0298-4B53-BE97-68F54137DFA5}"/>
          </ac:spMkLst>
        </pc:spChg>
        <pc:spChg chg="add mod">
          <ac:chgData name="Thu Huyen Pham" userId="3eb787573b41f7e6" providerId="LiveId" clId="{D21008C1-1F35-4EFD-920C-00227BB11F61}" dt="2019-03-17T12:43:08.697" v="2263" actId="1037"/>
          <ac:spMkLst>
            <pc:docMk/>
            <pc:sldMk cId="2705666942" sldId="259"/>
            <ac:spMk id="41" creationId="{291919B5-B38D-4599-A70B-98B613CB3CDE}"/>
          </ac:spMkLst>
        </pc:spChg>
        <pc:spChg chg="add mod">
          <ac:chgData name="Thu Huyen Pham" userId="3eb787573b41f7e6" providerId="LiveId" clId="{D21008C1-1F35-4EFD-920C-00227BB11F61}" dt="2019-03-17T12:45:00.030" v="2314" actId="20577"/>
          <ac:spMkLst>
            <pc:docMk/>
            <pc:sldMk cId="2705666942" sldId="259"/>
            <ac:spMk id="42" creationId="{4BAFB814-6103-4E26-BAFE-FA1FCE5CFE1A}"/>
          </ac:spMkLst>
        </pc:spChg>
        <pc:picChg chg="del">
          <ac:chgData name="Thu Huyen Pham" userId="3eb787573b41f7e6" providerId="LiveId" clId="{D21008C1-1F35-4EFD-920C-00227BB11F61}" dt="2019-03-17T12:45:16.134" v="2315" actId="478"/>
          <ac:picMkLst>
            <pc:docMk/>
            <pc:sldMk cId="2705666942" sldId="259"/>
            <ac:picMk id="4" creationId="{E24EF00A-F568-43E4-BEE1-6EEA1D6D646E}"/>
          </ac:picMkLst>
        </pc:picChg>
        <pc:picChg chg="del">
          <ac:chgData name="Thu Huyen Pham" userId="3eb787573b41f7e6" providerId="LiveId" clId="{D21008C1-1F35-4EFD-920C-00227BB11F61}" dt="2019-03-17T12:45:16.134" v="2315" actId="478"/>
          <ac:picMkLst>
            <pc:docMk/>
            <pc:sldMk cId="2705666942" sldId="259"/>
            <ac:picMk id="5" creationId="{7D5172B6-01EC-4E4E-8D29-748F0F5445DF}"/>
          </ac:picMkLst>
        </pc:picChg>
        <pc:picChg chg="del">
          <ac:chgData name="Thu Huyen Pham" userId="3eb787573b41f7e6" providerId="LiveId" clId="{D21008C1-1F35-4EFD-920C-00227BB11F61}" dt="2019-03-17T12:45:16.134" v="2315" actId="478"/>
          <ac:picMkLst>
            <pc:docMk/>
            <pc:sldMk cId="2705666942" sldId="259"/>
            <ac:picMk id="6" creationId="{69F57B9F-7B6A-460A-9C37-3A2C7288D355}"/>
          </ac:picMkLst>
        </pc:picChg>
        <pc:picChg chg="del mod">
          <ac:chgData name="Thu Huyen Pham" userId="3eb787573b41f7e6" providerId="LiveId" clId="{D21008C1-1F35-4EFD-920C-00227BB11F61}" dt="2019-03-17T12:39:37.287" v="2202"/>
          <ac:picMkLst>
            <pc:docMk/>
            <pc:sldMk cId="2705666942" sldId="259"/>
            <ac:picMk id="7" creationId="{32061674-C787-4584-84AB-88FA5B56C255}"/>
          </ac:picMkLst>
        </pc:picChg>
        <pc:picChg chg="del">
          <ac:chgData name="Thu Huyen Pham" userId="3eb787573b41f7e6" providerId="LiveId" clId="{D21008C1-1F35-4EFD-920C-00227BB11F61}" dt="2019-03-17T12:45:16.134" v="2315" actId="478"/>
          <ac:picMkLst>
            <pc:docMk/>
            <pc:sldMk cId="2705666942" sldId="259"/>
            <ac:picMk id="15" creationId="{C51C038C-1E65-4CAD-9BE8-DBA2D9618C72}"/>
          </ac:picMkLst>
        </pc:picChg>
        <pc:picChg chg="del">
          <ac:chgData name="Thu Huyen Pham" userId="3eb787573b41f7e6" providerId="LiveId" clId="{D21008C1-1F35-4EFD-920C-00227BB11F61}" dt="2019-03-17T12:39:37.287" v="2202"/>
          <ac:picMkLst>
            <pc:docMk/>
            <pc:sldMk cId="2705666942" sldId="259"/>
            <ac:picMk id="19" creationId="{339B7D76-3077-4E53-8871-EE4D2249F148}"/>
          </ac:picMkLst>
        </pc:picChg>
        <pc:picChg chg="del">
          <ac:chgData name="Thu Huyen Pham" userId="3eb787573b41f7e6" providerId="LiveId" clId="{D21008C1-1F35-4EFD-920C-00227BB11F61}" dt="2019-03-17T12:39:37.287" v="2202"/>
          <ac:picMkLst>
            <pc:docMk/>
            <pc:sldMk cId="2705666942" sldId="259"/>
            <ac:picMk id="20" creationId="{E09E7106-905D-4B03-BF52-4A59A6BCC16E}"/>
          </ac:picMkLst>
        </pc:picChg>
        <pc:picChg chg="del">
          <ac:chgData name="Thu Huyen Pham" userId="3eb787573b41f7e6" providerId="LiveId" clId="{D21008C1-1F35-4EFD-920C-00227BB11F61}" dt="2019-03-17T12:39:37.287" v="2202"/>
          <ac:picMkLst>
            <pc:docMk/>
            <pc:sldMk cId="2705666942" sldId="259"/>
            <ac:picMk id="21" creationId="{094B0736-FBC5-414C-ADD7-468FB9A96A65}"/>
          </ac:picMkLst>
        </pc:picChg>
        <pc:picChg chg="del mod">
          <ac:chgData name="Thu Huyen Pham" userId="3eb787573b41f7e6" providerId="LiveId" clId="{D21008C1-1F35-4EFD-920C-00227BB11F61}" dt="2019-03-17T12:39:37.287" v="2202"/>
          <ac:picMkLst>
            <pc:docMk/>
            <pc:sldMk cId="2705666942" sldId="259"/>
            <ac:picMk id="22" creationId="{9B0AFB54-3FE5-488C-A2F3-55F820D37C68}"/>
          </ac:picMkLst>
        </pc:picChg>
        <pc:picChg chg="add del mod modCrop">
          <ac:chgData name="Thu Huyen Pham" userId="3eb787573b41f7e6" providerId="LiveId" clId="{D21008C1-1F35-4EFD-920C-00227BB11F61}" dt="2019-03-16T05:32:22.237" v="797"/>
          <ac:picMkLst>
            <pc:docMk/>
            <pc:sldMk cId="2705666942" sldId="259"/>
            <ac:picMk id="24" creationId="{88480D8B-A6FD-4700-8AA8-A1D802AC7383}"/>
          </ac:picMkLst>
        </pc:picChg>
        <pc:picChg chg="add mod ord">
          <ac:chgData name="Thu Huyen Pham" userId="3eb787573b41f7e6" providerId="LiveId" clId="{D21008C1-1F35-4EFD-920C-00227BB11F61}" dt="2019-03-17T12:43:58.384" v="2289" actId="1037"/>
          <ac:picMkLst>
            <pc:docMk/>
            <pc:sldMk cId="2705666942" sldId="259"/>
            <ac:picMk id="31" creationId="{AFA104BC-7AE7-490A-900B-C33204B87D68}"/>
          </ac:picMkLst>
        </pc:picChg>
        <pc:picChg chg="add mod ord">
          <ac:chgData name="Thu Huyen Pham" userId="3eb787573b41f7e6" providerId="LiveId" clId="{D21008C1-1F35-4EFD-920C-00227BB11F61}" dt="2019-03-17T12:44:49.335" v="2310" actId="1036"/>
          <ac:picMkLst>
            <pc:docMk/>
            <pc:sldMk cId="2705666942" sldId="259"/>
            <ac:picMk id="33" creationId="{8BF95E3F-C574-48BA-B13E-07A22E28D257}"/>
          </ac:picMkLst>
        </pc:picChg>
        <pc:picChg chg="add mod ord">
          <ac:chgData name="Thu Huyen Pham" userId="3eb787573b41f7e6" providerId="LiveId" clId="{D21008C1-1F35-4EFD-920C-00227BB11F61}" dt="2019-03-17T12:44:49.335" v="2310" actId="1036"/>
          <ac:picMkLst>
            <pc:docMk/>
            <pc:sldMk cId="2705666942" sldId="259"/>
            <ac:picMk id="35" creationId="{06359D65-946B-4F03-BBAB-9C49C3514CAE}"/>
          </ac:picMkLst>
        </pc:picChg>
        <pc:picChg chg="add mod ord">
          <ac:chgData name="Thu Huyen Pham" userId="3eb787573b41f7e6" providerId="LiveId" clId="{D21008C1-1F35-4EFD-920C-00227BB11F61}" dt="2019-03-17T12:43:30.715" v="2265" actId="1076"/>
          <ac:picMkLst>
            <pc:docMk/>
            <pc:sldMk cId="2705666942" sldId="259"/>
            <ac:picMk id="37" creationId="{60F74843-6DA0-48CA-9BAA-ED9001B4C5E1}"/>
          </ac:picMkLst>
        </pc:picChg>
        <pc:picChg chg="add mod ord">
          <ac:chgData name="Thu Huyen Pham" userId="3eb787573b41f7e6" providerId="LiveId" clId="{D21008C1-1F35-4EFD-920C-00227BB11F61}" dt="2019-03-17T12:43:58.384" v="2289" actId="1037"/>
          <ac:picMkLst>
            <pc:docMk/>
            <pc:sldMk cId="2705666942" sldId="259"/>
            <ac:picMk id="39" creationId="{A1CC91CD-E0EA-4B4F-BD7F-6CCA28B1DF85}"/>
          </ac:picMkLst>
        </pc:picChg>
        <pc:cxnChg chg="del">
          <ac:chgData name="Thu Huyen Pham" userId="3eb787573b41f7e6" providerId="LiveId" clId="{D21008C1-1F35-4EFD-920C-00227BB11F61}" dt="2019-03-17T12:45:16.134" v="2315" actId="478"/>
          <ac:cxnSpMkLst>
            <pc:docMk/>
            <pc:sldMk cId="2705666942" sldId="259"/>
            <ac:cxnSpMk id="14" creationId="{7B7E555A-76CF-4457-821D-EB1902D4E60C}"/>
          </ac:cxnSpMkLst>
        </pc:cxnChg>
      </pc:sldChg>
      <pc:sldChg chg="addSp delSp modSp">
        <pc:chgData name="Thu Huyen Pham" userId="3eb787573b41f7e6" providerId="LiveId" clId="{D21008C1-1F35-4EFD-920C-00227BB11F61}" dt="2019-03-18T01:16:55.076" v="3174" actId="1076"/>
        <pc:sldMkLst>
          <pc:docMk/>
          <pc:sldMk cId="2945457629" sldId="260"/>
        </pc:sldMkLst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4" creationId="{C1096AA9-EA11-403E-B495-620A930251E5}"/>
          </ac:spMkLst>
        </pc:spChg>
        <pc:spChg chg="del">
          <ac:chgData name="Thu Huyen Pham" userId="3eb787573b41f7e6" providerId="LiveId" clId="{D21008C1-1F35-4EFD-920C-00227BB11F61}" dt="2019-03-16T01:36:52.125" v="44" actId="478"/>
          <ac:spMkLst>
            <pc:docMk/>
            <pc:sldMk cId="2945457629" sldId="260"/>
            <ac:spMk id="5" creationId="{2034E6C5-391D-4FD0-8A9A-C289BA300322}"/>
          </ac:spMkLst>
        </pc:spChg>
        <pc:spChg chg="del">
          <ac:chgData name="Thu Huyen Pham" userId="3eb787573b41f7e6" providerId="LiveId" clId="{D21008C1-1F35-4EFD-920C-00227BB11F61}" dt="2019-03-16T01:36:52.125" v="44" actId="478"/>
          <ac:spMkLst>
            <pc:docMk/>
            <pc:sldMk cId="2945457629" sldId="260"/>
            <ac:spMk id="9" creationId="{595F7116-E6C0-413A-B59B-C8EAF6664720}"/>
          </ac:spMkLst>
        </pc:spChg>
        <pc:spChg chg="del">
          <ac:chgData name="Thu Huyen Pham" userId="3eb787573b41f7e6" providerId="LiveId" clId="{D21008C1-1F35-4EFD-920C-00227BB11F61}" dt="2019-03-16T01:36:52.125" v="44" actId="478"/>
          <ac:spMkLst>
            <pc:docMk/>
            <pc:sldMk cId="2945457629" sldId="260"/>
            <ac:spMk id="11" creationId="{98134DB2-2EA0-4CFF-B4FE-4968DF3DEE5C}"/>
          </ac:spMkLst>
        </pc:spChg>
        <pc:spChg chg="del">
          <ac:chgData name="Thu Huyen Pham" userId="3eb787573b41f7e6" providerId="LiveId" clId="{D21008C1-1F35-4EFD-920C-00227BB11F61}" dt="2019-03-16T01:36:52.125" v="44" actId="478"/>
          <ac:spMkLst>
            <pc:docMk/>
            <pc:sldMk cId="2945457629" sldId="260"/>
            <ac:spMk id="12" creationId="{21071A13-81FB-4493-8F73-CDC657153614}"/>
          </ac:spMkLst>
        </pc:spChg>
        <pc:spChg chg="del">
          <ac:chgData name="Thu Huyen Pham" userId="3eb787573b41f7e6" providerId="LiveId" clId="{D21008C1-1F35-4EFD-920C-00227BB11F61}" dt="2019-03-16T01:36:52.125" v="44" actId="478"/>
          <ac:spMkLst>
            <pc:docMk/>
            <pc:sldMk cId="2945457629" sldId="260"/>
            <ac:spMk id="13" creationId="{EA1E1DF5-B7E1-46E9-ABCD-FEBED6FEF753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14" creationId="{BA3A4128-EF15-405A-B15D-C957B087C37B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15" creationId="{B55BEF08-6C86-4D03-B72D-AF791E77A97D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16" creationId="{5336B823-4811-43F7-9590-71BAFF33E064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17" creationId="{67E23AAA-4CDA-4737-A882-B3FDC69D29E8}"/>
          </ac:spMkLst>
        </pc:spChg>
        <pc:spChg chg="mod">
          <ac:chgData name="Thu Huyen Pham" userId="3eb787573b41f7e6" providerId="LiveId" clId="{D21008C1-1F35-4EFD-920C-00227BB11F61}" dt="2019-03-18T01:14:37.946" v="3137" actId="1076"/>
          <ac:spMkLst>
            <pc:docMk/>
            <pc:sldMk cId="2945457629" sldId="260"/>
            <ac:spMk id="18" creationId="{760FCC67-E355-4F17-AD04-DDF4B2F81342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19" creationId="{35106F72-588F-4883-B24E-90410C239CF6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20" creationId="{968C6ED7-59D0-414C-824C-2BBD674B6793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21" creationId="{6C421A22-5331-417D-B8FE-A1F019F7C3D3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22" creationId="{6BC151E5-838B-4C37-AC34-4FA268AB50BD}"/>
          </ac:spMkLst>
        </pc:spChg>
        <pc:spChg chg="mod">
          <ac:chgData name="Thu Huyen Pham" userId="3eb787573b41f7e6" providerId="LiveId" clId="{D21008C1-1F35-4EFD-920C-00227BB11F61}" dt="2019-03-17T14:28:21.679" v="2915" actId="1076"/>
          <ac:spMkLst>
            <pc:docMk/>
            <pc:sldMk cId="2945457629" sldId="260"/>
            <ac:spMk id="23" creationId="{8215567B-5BEA-46AF-8F10-64FB3E0A9ECB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24" creationId="{6FD7C82B-78DB-40E6-B6DF-B9EF5B50405D}"/>
          </ac:spMkLst>
        </pc:spChg>
        <pc:spChg chg="mod">
          <ac:chgData name="Thu Huyen Pham" userId="3eb787573b41f7e6" providerId="LiveId" clId="{D21008C1-1F35-4EFD-920C-00227BB11F61}" dt="2019-03-18T01:14:37.946" v="3137" actId="1076"/>
          <ac:spMkLst>
            <pc:docMk/>
            <pc:sldMk cId="2945457629" sldId="260"/>
            <ac:spMk id="25" creationId="{E30206BA-58BE-4E7A-8BE7-0B90D5DD9BBD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26" creationId="{653D59D7-2DB7-4F8F-9684-D2FF683CD310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27" creationId="{842FEBCD-EE3F-4F09-BAB1-DDE312B8C7D8}"/>
          </ac:spMkLst>
        </pc:spChg>
        <pc:spChg chg="mod">
          <ac:chgData name="Thu Huyen Pham" userId="3eb787573b41f7e6" providerId="LiveId" clId="{D21008C1-1F35-4EFD-920C-00227BB11F61}" dt="2019-03-18T01:14:37.946" v="3137" actId="1076"/>
          <ac:spMkLst>
            <pc:docMk/>
            <pc:sldMk cId="2945457629" sldId="260"/>
            <ac:spMk id="28" creationId="{67FB579B-C431-4843-8CDB-8AFE17B88962}"/>
          </ac:spMkLst>
        </pc:spChg>
        <pc:spChg chg="mod">
          <ac:chgData name="Thu Huyen Pham" userId="3eb787573b41f7e6" providerId="LiveId" clId="{D21008C1-1F35-4EFD-920C-00227BB11F61}" dt="2019-03-17T14:28:21.679" v="2915" actId="1076"/>
          <ac:spMkLst>
            <pc:docMk/>
            <pc:sldMk cId="2945457629" sldId="260"/>
            <ac:spMk id="29" creationId="{C5F22A15-D243-42AA-9A84-E417D5C468CF}"/>
          </ac:spMkLst>
        </pc:spChg>
        <pc:spChg chg="add mod">
          <ac:chgData name="Thu Huyen Pham" userId="3eb787573b41f7e6" providerId="LiveId" clId="{D21008C1-1F35-4EFD-920C-00227BB11F61}" dt="2019-03-18T01:16:34.640" v="3172" actId="1076"/>
          <ac:spMkLst>
            <pc:docMk/>
            <pc:sldMk cId="2945457629" sldId="260"/>
            <ac:spMk id="30" creationId="{6AE2ABFA-7A30-451C-A98E-9638D4F89C43}"/>
          </ac:spMkLst>
        </pc:spChg>
        <pc:spChg chg="add mod">
          <ac:chgData name="Thu Huyen Pham" userId="3eb787573b41f7e6" providerId="LiveId" clId="{D21008C1-1F35-4EFD-920C-00227BB11F61}" dt="2019-03-18T01:16:50.906" v="3173" actId="1076"/>
          <ac:spMkLst>
            <pc:docMk/>
            <pc:sldMk cId="2945457629" sldId="260"/>
            <ac:spMk id="31" creationId="{2A1102C7-BB8A-4CAC-AC32-BA86B53FE41B}"/>
          </ac:spMkLst>
        </pc:spChg>
        <pc:spChg chg="add mod">
          <ac:chgData name="Thu Huyen Pham" userId="3eb787573b41f7e6" providerId="LiveId" clId="{D21008C1-1F35-4EFD-920C-00227BB11F61}" dt="2019-03-18T01:16:55.076" v="3174" actId="1076"/>
          <ac:spMkLst>
            <pc:docMk/>
            <pc:sldMk cId="2945457629" sldId="260"/>
            <ac:spMk id="32" creationId="{7F72CC20-FC2F-43A5-B0F1-AD2856FF92B5}"/>
          </ac:spMkLst>
        </pc:spChg>
        <pc:spChg chg="add mod">
          <ac:chgData name="Thu Huyen Pham" userId="3eb787573b41f7e6" providerId="LiveId" clId="{D21008C1-1F35-4EFD-920C-00227BB11F61}" dt="2019-03-18T01:15:31.226" v="3151" actId="1076"/>
          <ac:spMkLst>
            <pc:docMk/>
            <pc:sldMk cId="2945457629" sldId="260"/>
            <ac:spMk id="33" creationId="{1313BDD0-BE43-46F9-9F7E-6E168A5E2718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34" creationId="{0E6F75D2-397E-466F-A8E2-A82AC0928FDB}"/>
          </ac:spMkLst>
        </pc:spChg>
        <pc:spChg chg="add mod">
          <ac:chgData name="Thu Huyen Pham" userId="3eb787573b41f7e6" providerId="LiveId" clId="{D21008C1-1F35-4EFD-920C-00227BB11F61}" dt="2019-03-18T01:15:53.021" v="3156" actId="1076"/>
          <ac:spMkLst>
            <pc:docMk/>
            <pc:sldMk cId="2945457629" sldId="260"/>
            <ac:spMk id="34" creationId="{B37076F6-FF15-43F5-839B-9070B6F694AE}"/>
          </ac:spMkLst>
        </pc:spChg>
        <pc:spChg chg="add mod">
          <ac:chgData name="Thu Huyen Pham" userId="3eb787573b41f7e6" providerId="LiveId" clId="{D21008C1-1F35-4EFD-920C-00227BB11F61}" dt="2019-03-18T01:16:00.506" v="3158" actId="1076"/>
          <ac:spMkLst>
            <pc:docMk/>
            <pc:sldMk cId="2945457629" sldId="260"/>
            <ac:spMk id="35" creationId="{BC0E6B67-36E3-49FA-957B-861A4692FDB6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35" creationId="{D45211EA-0742-4FB7-987C-52F1868FAA68}"/>
          </ac:spMkLst>
        </pc:spChg>
        <pc:spChg chg="add mod">
          <ac:chgData name="Thu Huyen Pham" userId="3eb787573b41f7e6" providerId="LiveId" clId="{D21008C1-1F35-4EFD-920C-00227BB11F61}" dt="2019-03-18T01:16:10.255" v="3165" actId="20577"/>
          <ac:spMkLst>
            <pc:docMk/>
            <pc:sldMk cId="2945457629" sldId="260"/>
            <ac:spMk id="36" creationId="{119D6081-FCB0-48F1-8360-9ED1287B07CF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36" creationId="{BDF70EDF-571D-487E-B034-3EFBDD75BA47}"/>
          </ac:spMkLst>
        </pc:spChg>
        <pc:spChg chg="add mod">
          <ac:chgData name="Thu Huyen Pham" userId="3eb787573b41f7e6" providerId="LiveId" clId="{D21008C1-1F35-4EFD-920C-00227BB11F61}" dt="2019-03-18T01:16:17.156" v="3167" actId="1076"/>
          <ac:spMkLst>
            <pc:docMk/>
            <pc:sldMk cId="2945457629" sldId="260"/>
            <ac:spMk id="37" creationId="{63F520F5-95A7-4AB8-BBAD-247FC1571E07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37" creationId="{E1ADEF80-ACDA-4363-9F6C-4F8402FED8A2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38" creationId="{429FF2F7-F27F-4B1B-92A2-395D2B7EB28F}"/>
          </ac:spMkLst>
        </pc:spChg>
        <pc:spChg chg="add mod">
          <ac:chgData name="Thu Huyen Pham" userId="3eb787573b41f7e6" providerId="LiveId" clId="{D21008C1-1F35-4EFD-920C-00227BB11F61}" dt="2019-03-18T01:16:24.779" v="3169" actId="1076"/>
          <ac:spMkLst>
            <pc:docMk/>
            <pc:sldMk cId="2945457629" sldId="260"/>
            <ac:spMk id="38" creationId="{FB9ADB4D-4EEE-4E6C-812F-5BE053F30705}"/>
          </ac:spMkLst>
        </pc:spChg>
        <pc:spChg chg="add mod">
          <ac:chgData name="Thu Huyen Pham" userId="3eb787573b41f7e6" providerId="LiveId" clId="{D21008C1-1F35-4EFD-920C-00227BB11F61}" dt="2019-03-18T01:16:30.684" v="3171" actId="1076"/>
          <ac:spMkLst>
            <pc:docMk/>
            <pc:sldMk cId="2945457629" sldId="260"/>
            <ac:spMk id="39" creationId="{0B687803-0A6B-4509-A2D6-5F9A10BF2EAC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39" creationId="{E6B7211F-05EE-4609-BFE8-43F1FA5D3EC2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40" creationId="{494B1E61-AEA4-416D-8D81-D6DD87D7A5CE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41" creationId="{560CA2A6-8DA8-4972-B4FE-775C38C2B615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42" creationId="{4BFBDF48-CF53-419A-87FC-3B004F8D482A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43" creationId="{C641CF8E-6AF1-447D-8812-55BB6FF8CD56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44" creationId="{2D923AA2-92D5-45A3-8ACD-B5E167842D71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45" creationId="{226EF860-1404-4D8B-A006-4AB81E9B537F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46" creationId="{4231494F-A0C6-41A5-BAE6-EF358DE56912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47" creationId="{9D409E2B-6052-49CA-8907-AF469F4B47E6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48" creationId="{D7E6ED71-ECEE-45DC-BA9F-AE7D572D4857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49" creationId="{6395BFDA-6972-47BA-A2CC-F652FFF6FE3B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50" creationId="{D89BDC6E-0509-4DA7-986D-67225905921F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51" creationId="{E560E610-3541-4D85-A86D-60D6FA0F9353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52" creationId="{6F82FA78-AA0E-4C3A-8968-AFE6352D84E7}"/>
          </ac:spMkLst>
        </pc:spChg>
        <pc:spChg chg="mod">
          <ac:chgData name="Thu Huyen Pham" userId="3eb787573b41f7e6" providerId="LiveId" clId="{D21008C1-1F35-4EFD-920C-00227BB11F61}" dt="2019-03-18T01:14:37.946" v="3137" actId="1076"/>
          <ac:spMkLst>
            <pc:docMk/>
            <pc:sldMk cId="2945457629" sldId="260"/>
            <ac:spMk id="53" creationId="{AC122B73-7F06-467E-AB92-030BD25F11EE}"/>
          </ac:spMkLst>
        </pc:spChg>
        <pc:spChg chg="del">
          <ac:chgData name="Thu Huyen Pham" userId="3eb787573b41f7e6" providerId="LiveId" clId="{D21008C1-1F35-4EFD-920C-00227BB11F61}" dt="2019-03-16T01:36:52.125" v="44" actId="478"/>
          <ac:spMkLst>
            <pc:docMk/>
            <pc:sldMk cId="2945457629" sldId="260"/>
            <ac:spMk id="54" creationId="{F7E52E83-D27E-44CF-A71F-479A80427CC2}"/>
          </ac:spMkLst>
        </pc:spChg>
        <pc:spChg chg="del">
          <ac:chgData name="Thu Huyen Pham" userId="3eb787573b41f7e6" providerId="LiveId" clId="{D21008C1-1F35-4EFD-920C-00227BB11F61}" dt="2019-03-16T01:36:52.125" v="44" actId="478"/>
          <ac:spMkLst>
            <pc:docMk/>
            <pc:sldMk cId="2945457629" sldId="260"/>
            <ac:spMk id="55" creationId="{D2194F37-D29A-4559-9BEA-1355065A7F82}"/>
          </ac:spMkLst>
        </pc:spChg>
        <pc:spChg chg="del">
          <ac:chgData name="Thu Huyen Pham" userId="3eb787573b41f7e6" providerId="LiveId" clId="{D21008C1-1F35-4EFD-920C-00227BB11F61}" dt="2019-03-16T01:36:52.125" v="44" actId="478"/>
          <ac:spMkLst>
            <pc:docMk/>
            <pc:sldMk cId="2945457629" sldId="260"/>
            <ac:spMk id="57" creationId="{B7B03D70-BD0B-4D24-BC51-1D3194D3DED5}"/>
          </ac:spMkLst>
        </pc:spChg>
        <pc:spChg chg="del">
          <ac:chgData name="Thu Huyen Pham" userId="3eb787573b41f7e6" providerId="LiveId" clId="{D21008C1-1F35-4EFD-920C-00227BB11F61}" dt="2019-03-16T01:36:52.125" v="44" actId="478"/>
          <ac:spMkLst>
            <pc:docMk/>
            <pc:sldMk cId="2945457629" sldId="260"/>
            <ac:spMk id="59" creationId="{BE602120-F48E-49D6-BDB3-F55822374282}"/>
          </ac:spMkLst>
        </pc:spChg>
        <pc:spChg chg="del">
          <ac:chgData name="Thu Huyen Pham" userId="3eb787573b41f7e6" providerId="LiveId" clId="{D21008C1-1F35-4EFD-920C-00227BB11F61}" dt="2019-03-16T01:36:52.125" v="44" actId="478"/>
          <ac:spMkLst>
            <pc:docMk/>
            <pc:sldMk cId="2945457629" sldId="260"/>
            <ac:spMk id="60" creationId="{CED6E099-D0BA-4B40-823D-79A7D0B72330}"/>
          </ac:spMkLst>
        </pc:spChg>
        <pc:spChg chg="del">
          <ac:chgData name="Thu Huyen Pham" userId="3eb787573b41f7e6" providerId="LiveId" clId="{D21008C1-1F35-4EFD-920C-00227BB11F61}" dt="2019-03-16T01:36:52.125" v="44" actId="478"/>
          <ac:spMkLst>
            <pc:docMk/>
            <pc:sldMk cId="2945457629" sldId="260"/>
            <ac:spMk id="61" creationId="{3A85A495-64E9-4388-9B87-2EA59B09BF19}"/>
          </ac:spMkLst>
        </pc:spChg>
        <pc:spChg chg="del">
          <ac:chgData name="Thu Huyen Pham" userId="3eb787573b41f7e6" providerId="LiveId" clId="{D21008C1-1F35-4EFD-920C-00227BB11F61}" dt="2019-03-16T01:36:52.125" v="44" actId="478"/>
          <ac:spMkLst>
            <pc:docMk/>
            <pc:sldMk cId="2945457629" sldId="260"/>
            <ac:spMk id="62" creationId="{D921C273-AFF7-4707-A3A5-83CF8B1A295C}"/>
          </ac:spMkLst>
        </pc:spChg>
        <pc:spChg chg="del">
          <ac:chgData name="Thu Huyen Pham" userId="3eb787573b41f7e6" providerId="LiveId" clId="{D21008C1-1F35-4EFD-920C-00227BB11F61}" dt="2019-03-16T01:36:32.354" v="40"/>
          <ac:spMkLst>
            <pc:docMk/>
            <pc:sldMk cId="2945457629" sldId="260"/>
            <ac:spMk id="63" creationId="{611FDCBB-E4F1-4407-B2E3-8C3FCDC38964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64" creationId="{A30D9F7F-9A51-4BEB-9163-34113B2C0366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65" creationId="{74D6D881-9F2A-463D-8C2F-7DA08A68A4D3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66" creationId="{AF447719-D160-4C92-B871-65A60E6B3096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67" creationId="{90218169-9ADA-40FF-8DE2-D484EE4FBA08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68" creationId="{1BCEB672-60A0-43FC-8BE7-801FFF317BE0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72" creationId="{BEE4C88E-899A-40FA-9291-4ED5F398F1E7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73" creationId="{B96A9F5C-901F-475A-BE78-E96690F4D8A3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76" creationId="{3BCE8D01-D2AB-47B8-8ED0-A9D529E3C0CF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77" creationId="{6CBDFE3F-1BF2-4F83-9915-08BC7BC243B7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79" creationId="{FA25FEA5-0A9E-4D40-A5E2-5365343E3198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80" creationId="{DD79565C-E5DB-4D10-BDE1-BAD059DDDD66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94" creationId="{2BD697DF-422E-4EB3-9FCD-36D50A26482A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95" creationId="{7B94AC68-1AC9-4E33-9657-E0BBD230A3F6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96" creationId="{4419D86F-70BD-4C6C-B460-96B0BA170412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97" creationId="{79F02EEA-41E2-465B-A05F-1ECCA9B05EA1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98" creationId="{D120D216-403D-4CE7-8D17-B0A6ED5EF3A5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99" creationId="{B4D00FF1-6A66-4A64-B3A3-356C9606CD41}"/>
          </ac:spMkLst>
        </pc:spChg>
        <pc:spChg chg="del">
          <ac:chgData name="Thu Huyen Pham" userId="3eb787573b41f7e6" providerId="LiveId" clId="{D21008C1-1F35-4EFD-920C-00227BB11F61}" dt="2019-03-16T01:36:15.336" v="34"/>
          <ac:spMkLst>
            <pc:docMk/>
            <pc:sldMk cId="2945457629" sldId="260"/>
            <ac:spMk id="100" creationId="{E0E9839A-3F43-4757-9764-0B43CCF62B0C}"/>
          </ac:spMkLst>
        </pc:spChg>
        <pc:spChg chg="del mod">
          <ac:chgData name="Thu Huyen Pham" userId="3eb787573b41f7e6" providerId="LiveId" clId="{D21008C1-1F35-4EFD-920C-00227BB11F61}" dt="2019-03-17T14:29:15.487" v="2927" actId="478"/>
          <ac:spMkLst>
            <pc:docMk/>
            <pc:sldMk cId="2945457629" sldId="260"/>
            <ac:spMk id="102" creationId="{857E4D90-D68A-48DD-BE11-67EAD2CD183A}"/>
          </ac:spMkLst>
        </pc:spChg>
        <pc:spChg chg="del mod topLvl">
          <ac:chgData name="Thu Huyen Pham" userId="3eb787573b41f7e6" providerId="LiveId" clId="{D21008C1-1F35-4EFD-920C-00227BB11F61}" dt="2019-03-16T06:47:38.266" v="903" actId="478"/>
          <ac:spMkLst>
            <pc:docMk/>
            <pc:sldMk cId="2945457629" sldId="260"/>
            <ac:spMk id="123" creationId="{D78F11EA-1EE5-473A-AD02-E233BCBDDA5E}"/>
          </ac:spMkLst>
        </pc:spChg>
        <pc:spChg chg="del mod topLvl">
          <ac:chgData name="Thu Huyen Pham" userId="3eb787573b41f7e6" providerId="LiveId" clId="{D21008C1-1F35-4EFD-920C-00227BB11F61}" dt="2019-03-16T06:47:38.266" v="903" actId="478"/>
          <ac:spMkLst>
            <pc:docMk/>
            <pc:sldMk cId="2945457629" sldId="260"/>
            <ac:spMk id="124" creationId="{3AB19BBA-82A3-4277-8A31-0ED1A5CA0680}"/>
          </ac:spMkLst>
        </pc:spChg>
        <pc:spChg chg="add mod ord">
          <ac:chgData name="Thu Huyen Pham" userId="3eb787573b41f7e6" providerId="LiveId" clId="{D21008C1-1F35-4EFD-920C-00227BB11F61}" dt="2019-03-18T01:14:37.946" v="3137" actId="1076"/>
          <ac:spMkLst>
            <pc:docMk/>
            <pc:sldMk cId="2945457629" sldId="260"/>
            <ac:spMk id="148" creationId="{E9B81C9E-FCDC-49F5-8891-4B7EEB539771}"/>
          </ac:spMkLst>
        </pc:spChg>
        <pc:spChg chg="add mod">
          <ac:chgData name="Thu Huyen Pham" userId="3eb787573b41f7e6" providerId="LiveId" clId="{D21008C1-1F35-4EFD-920C-00227BB11F61}" dt="2019-03-17T13:46:51.455" v="2557" actId="1076"/>
          <ac:spMkLst>
            <pc:docMk/>
            <pc:sldMk cId="2945457629" sldId="260"/>
            <ac:spMk id="149" creationId="{B8AE3FD5-CF94-4C25-BBA3-A736D4915767}"/>
          </ac:spMkLst>
        </pc:spChg>
        <pc:spChg chg="add mod">
          <ac:chgData name="Thu Huyen Pham" userId="3eb787573b41f7e6" providerId="LiveId" clId="{D21008C1-1F35-4EFD-920C-00227BB11F61}" dt="2019-03-18T01:14:37.946" v="3137" actId="1076"/>
          <ac:spMkLst>
            <pc:docMk/>
            <pc:sldMk cId="2945457629" sldId="260"/>
            <ac:spMk id="162" creationId="{FB9B66D8-BCC4-435C-AEEB-62B5ED057309}"/>
          </ac:spMkLst>
        </pc:spChg>
        <pc:spChg chg="add mod">
          <ac:chgData name="Thu Huyen Pham" userId="3eb787573b41f7e6" providerId="LiveId" clId="{D21008C1-1F35-4EFD-920C-00227BB11F61}" dt="2019-03-18T01:14:37.946" v="3137" actId="1076"/>
          <ac:spMkLst>
            <pc:docMk/>
            <pc:sldMk cId="2945457629" sldId="260"/>
            <ac:spMk id="163" creationId="{CE365A73-1C2F-4DE4-B415-2A091F38B487}"/>
          </ac:spMkLst>
        </pc:spChg>
        <pc:spChg chg="add mod">
          <ac:chgData name="Thu Huyen Pham" userId="3eb787573b41f7e6" providerId="LiveId" clId="{D21008C1-1F35-4EFD-920C-00227BB11F61}" dt="2019-03-18T01:14:37.946" v="3137" actId="1076"/>
          <ac:spMkLst>
            <pc:docMk/>
            <pc:sldMk cId="2945457629" sldId="260"/>
            <ac:spMk id="164" creationId="{04B234A5-69B7-4C07-A1F7-EA83BC20DB11}"/>
          </ac:spMkLst>
        </pc:spChg>
        <pc:spChg chg="add mod">
          <ac:chgData name="Thu Huyen Pham" userId="3eb787573b41f7e6" providerId="LiveId" clId="{D21008C1-1F35-4EFD-920C-00227BB11F61}" dt="2019-03-17T14:28:21.679" v="2915" actId="1076"/>
          <ac:spMkLst>
            <pc:docMk/>
            <pc:sldMk cId="2945457629" sldId="260"/>
            <ac:spMk id="165" creationId="{B74FEDC5-A7E3-4590-AAFF-2DD127A810C3}"/>
          </ac:spMkLst>
        </pc:spChg>
        <pc:spChg chg="add mod">
          <ac:chgData name="Thu Huyen Pham" userId="3eb787573b41f7e6" providerId="LiveId" clId="{D21008C1-1F35-4EFD-920C-00227BB11F61}" dt="2019-03-17T14:28:21.679" v="2915" actId="1076"/>
          <ac:spMkLst>
            <pc:docMk/>
            <pc:sldMk cId="2945457629" sldId="260"/>
            <ac:spMk id="173" creationId="{51C6ED41-D10E-4D47-801E-C7D35DF30A09}"/>
          </ac:spMkLst>
        </pc:spChg>
        <pc:spChg chg="add mod">
          <ac:chgData name="Thu Huyen Pham" userId="3eb787573b41f7e6" providerId="LiveId" clId="{D21008C1-1F35-4EFD-920C-00227BB11F61}" dt="2019-03-17T14:28:28.825" v="2917" actId="1076"/>
          <ac:spMkLst>
            <pc:docMk/>
            <pc:sldMk cId="2945457629" sldId="260"/>
            <ac:spMk id="174" creationId="{8DCCB108-9657-4CDD-8DAA-B81923DEB3AA}"/>
          </ac:spMkLst>
        </pc:spChg>
        <pc:spChg chg="add mod">
          <ac:chgData name="Thu Huyen Pham" userId="3eb787573b41f7e6" providerId="LiveId" clId="{D21008C1-1F35-4EFD-920C-00227BB11F61}" dt="2019-03-17T14:28:28.825" v="2917" actId="1076"/>
          <ac:spMkLst>
            <pc:docMk/>
            <pc:sldMk cId="2945457629" sldId="260"/>
            <ac:spMk id="175" creationId="{E6896EDF-F3B4-4168-ADFF-2F67BA3C2B49}"/>
          </ac:spMkLst>
        </pc:spChg>
        <pc:spChg chg="add mod">
          <ac:chgData name="Thu Huyen Pham" userId="3eb787573b41f7e6" providerId="LiveId" clId="{D21008C1-1F35-4EFD-920C-00227BB11F61}" dt="2019-03-17T14:28:39.744" v="2919" actId="1076"/>
          <ac:spMkLst>
            <pc:docMk/>
            <pc:sldMk cId="2945457629" sldId="260"/>
            <ac:spMk id="176" creationId="{336EC113-159B-43EF-AA80-94AD2A737BBE}"/>
          </ac:spMkLst>
        </pc:spChg>
        <pc:spChg chg="add mod">
          <ac:chgData name="Thu Huyen Pham" userId="3eb787573b41f7e6" providerId="LiveId" clId="{D21008C1-1F35-4EFD-920C-00227BB11F61}" dt="2019-03-17T14:28:49.626" v="2926" actId="20577"/>
          <ac:spMkLst>
            <pc:docMk/>
            <pc:sldMk cId="2945457629" sldId="260"/>
            <ac:spMk id="177" creationId="{4694C529-93F1-4899-B839-0B5B3923B77E}"/>
          </ac:spMkLst>
        </pc:spChg>
        <pc:spChg chg="add mod">
          <ac:chgData name="Thu Huyen Pham" userId="3eb787573b41f7e6" providerId="LiveId" clId="{D21008C1-1F35-4EFD-920C-00227BB11F61}" dt="2019-03-17T14:29:45.775" v="2932" actId="14100"/>
          <ac:spMkLst>
            <pc:docMk/>
            <pc:sldMk cId="2945457629" sldId="260"/>
            <ac:spMk id="178" creationId="{CC51ED9C-F803-494E-A096-4474EB7C25E2}"/>
          </ac:spMkLst>
        </pc:spChg>
        <pc:spChg chg="add mod">
          <ac:chgData name="Thu Huyen Pham" userId="3eb787573b41f7e6" providerId="LiveId" clId="{D21008C1-1F35-4EFD-920C-00227BB11F61}" dt="2019-03-18T01:15:24.392" v="3149" actId="14100"/>
          <ac:spMkLst>
            <pc:docMk/>
            <pc:sldMk cId="2945457629" sldId="260"/>
            <ac:spMk id="179" creationId="{8ECFC35E-3AC1-42D7-81FA-CD80EC1F32D2}"/>
          </ac:spMkLst>
        </pc:spChg>
        <pc:spChg chg="add mod">
          <ac:chgData name="Thu Huyen Pham" userId="3eb787573b41f7e6" providerId="LiveId" clId="{D21008C1-1F35-4EFD-920C-00227BB11F61}" dt="2019-03-18T01:15:40.176" v="3152" actId="14100"/>
          <ac:spMkLst>
            <pc:docMk/>
            <pc:sldMk cId="2945457629" sldId="260"/>
            <ac:spMk id="180" creationId="{1A9BE1DF-18BC-4DFB-A06E-F7E71E617BD6}"/>
          </ac:spMkLst>
        </pc:spChg>
        <pc:grpChg chg="add del mod">
          <ac:chgData name="Thu Huyen Pham" userId="3eb787573b41f7e6" providerId="LiveId" clId="{D21008C1-1F35-4EFD-920C-00227BB11F61}" dt="2019-03-16T06:46:34.165" v="894" actId="165"/>
          <ac:grpSpMkLst>
            <pc:docMk/>
            <pc:sldMk cId="2945457629" sldId="260"/>
            <ac:grpSpMk id="118" creationId="{59F748D6-E624-4C5E-90C9-A20ABB9AEBCB}"/>
          </ac:grpSpMkLst>
        </pc:grpChg>
        <pc:grpChg chg="add del mod">
          <ac:chgData name="Thu Huyen Pham" userId="3eb787573b41f7e6" providerId="LiveId" clId="{D21008C1-1F35-4EFD-920C-00227BB11F61}" dt="2019-03-16T06:47:07.604" v="899" actId="165"/>
          <ac:grpSpMkLst>
            <pc:docMk/>
            <pc:sldMk cId="2945457629" sldId="260"/>
            <ac:grpSpMk id="121" creationId="{5CDAADC3-1EFD-4C92-BF04-46E79554025F}"/>
          </ac:grpSpMkLst>
        </pc:grpChg>
        <pc:grpChg chg="del mod topLvl">
          <ac:chgData name="Thu Huyen Pham" userId="3eb787573b41f7e6" providerId="LiveId" clId="{D21008C1-1F35-4EFD-920C-00227BB11F61}" dt="2019-03-16T06:47:27.551" v="902" actId="165"/>
          <ac:grpSpMkLst>
            <pc:docMk/>
            <pc:sldMk cId="2945457629" sldId="260"/>
            <ac:grpSpMk id="122" creationId="{F4B6714B-FD9D-49AE-8869-E753737607C6}"/>
          </ac:grpSpMkLst>
        </pc:grpChg>
        <pc:picChg chg="del">
          <ac:chgData name="Thu Huyen Pham" userId="3eb787573b41f7e6" providerId="LiveId" clId="{D21008C1-1F35-4EFD-920C-00227BB11F61}" dt="2019-03-16T01:36:15.336" v="34"/>
          <ac:picMkLst>
            <pc:docMk/>
            <pc:sldMk cId="2945457629" sldId="260"/>
            <ac:picMk id="7" creationId="{11991723-B785-4C9C-BD10-3B0D7D7F502F}"/>
          </ac:picMkLst>
        </pc:picChg>
        <pc:picChg chg="del">
          <ac:chgData name="Thu Huyen Pham" userId="3eb787573b41f7e6" providerId="LiveId" clId="{D21008C1-1F35-4EFD-920C-00227BB11F61}" dt="2019-03-16T01:36:52.125" v="44" actId="478"/>
          <ac:picMkLst>
            <pc:docMk/>
            <pc:sldMk cId="2945457629" sldId="260"/>
            <ac:picMk id="8" creationId="{703D672C-0135-4B3B-809C-D9BDF5676219}"/>
          </ac:picMkLst>
        </pc:picChg>
        <pc:picChg chg="del mod">
          <ac:chgData name="Thu Huyen Pham" userId="3eb787573b41f7e6" providerId="LiveId" clId="{D21008C1-1F35-4EFD-920C-00227BB11F61}" dt="2019-03-17T14:29:15.487" v="2927" actId="478"/>
          <ac:picMkLst>
            <pc:docMk/>
            <pc:sldMk cId="2945457629" sldId="260"/>
            <ac:picMk id="30" creationId="{E925468D-10F0-456C-B93B-20785BBA6AEC}"/>
          </ac:picMkLst>
        </pc:picChg>
        <pc:picChg chg="del mod">
          <ac:chgData name="Thu Huyen Pham" userId="3eb787573b41f7e6" providerId="LiveId" clId="{D21008C1-1F35-4EFD-920C-00227BB11F61}" dt="2019-03-17T14:29:15.487" v="2927" actId="478"/>
          <ac:picMkLst>
            <pc:docMk/>
            <pc:sldMk cId="2945457629" sldId="260"/>
            <ac:picMk id="31" creationId="{7AD4CF36-0E44-4A18-8F96-DAEB56818F9F}"/>
          </ac:picMkLst>
        </pc:picChg>
        <pc:picChg chg="del mod">
          <ac:chgData name="Thu Huyen Pham" userId="3eb787573b41f7e6" providerId="LiveId" clId="{D21008C1-1F35-4EFD-920C-00227BB11F61}" dt="2019-03-17T13:19:21.915" v="2508"/>
          <ac:picMkLst>
            <pc:docMk/>
            <pc:sldMk cId="2945457629" sldId="260"/>
            <ac:picMk id="32" creationId="{8DC2DB44-B426-4B30-AF8A-1F0CADEBCF31}"/>
          </ac:picMkLst>
        </pc:picChg>
        <pc:picChg chg="del mod">
          <ac:chgData name="Thu Huyen Pham" userId="3eb787573b41f7e6" providerId="LiveId" clId="{D21008C1-1F35-4EFD-920C-00227BB11F61}" dt="2019-03-17T14:29:15.487" v="2927" actId="478"/>
          <ac:picMkLst>
            <pc:docMk/>
            <pc:sldMk cId="2945457629" sldId="260"/>
            <ac:picMk id="33" creationId="{75F83892-E88E-4112-95AF-29F2D0A36339}"/>
          </ac:picMkLst>
        </pc:picChg>
        <pc:picChg chg="del">
          <ac:chgData name="Thu Huyen Pham" userId="3eb787573b41f7e6" providerId="LiveId" clId="{D21008C1-1F35-4EFD-920C-00227BB11F61}" dt="2019-03-16T01:36:15.336" v="34"/>
          <ac:picMkLst>
            <pc:docMk/>
            <pc:sldMk cId="2945457629" sldId="260"/>
            <ac:picMk id="70" creationId="{1DE4A70E-E32D-4DF4-9503-6E2C987F0CFC}"/>
          </ac:picMkLst>
        </pc:picChg>
        <pc:picChg chg="del">
          <ac:chgData name="Thu Huyen Pham" userId="3eb787573b41f7e6" providerId="LiveId" clId="{D21008C1-1F35-4EFD-920C-00227BB11F61}" dt="2019-03-16T01:36:15.336" v="34"/>
          <ac:picMkLst>
            <pc:docMk/>
            <pc:sldMk cId="2945457629" sldId="260"/>
            <ac:picMk id="71" creationId="{DB4058F9-5E12-4E43-8FA8-469BF66779E4}"/>
          </ac:picMkLst>
        </pc:picChg>
        <pc:picChg chg="del">
          <ac:chgData name="Thu Huyen Pham" userId="3eb787573b41f7e6" providerId="LiveId" clId="{D21008C1-1F35-4EFD-920C-00227BB11F61}" dt="2019-03-16T01:36:15.336" v="34"/>
          <ac:picMkLst>
            <pc:docMk/>
            <pc:sldMk cId="2945457629" sldId="260"/>
            <ac:picMk id="74" creationId="{452F25F6-0470-4FA9-80B7-BD0910763B6C}"/>
          </ac:picMkLst>
        </pc:picChg>
        <pc:picChg chg="del mod">
          <ac:chgData name="Thu Huyen Pham" userId="3eb787573b41f7e6" providerId="LiveId" clId="{D21008C1-1F35-4EFD-920C-00227BB11F61}" dt="2019-03-16T08:53:39.794" v="1600" actId="478"/>
          <ac:picMkLst>
            <pc:docMk/>
            <pc:sldMk cId="2945457629" sldId="260"/>
            <ac:picMk id="84" creationId="{0FEF0367-3487-4D03-903E-53B514E0A809}"/>
          </ac:picMkLst>
        </pc:picChg>
        <pc:picChg chg="del mod">
          <ac:chgData name="Thu Huyen Pham" userId="3eb787573b41f7e6" providerId="LiveId" clId="{D21008C1-1F35-4EFD-920C-00227BB11F61}" dt="2019-03-16T06:54:18.706" v="1067" actId="478"/>
          <ac:picMkLst>
            <pc:docMk/>
            <pc:sldMk cId="2945457629" sldId="260"/>
            <ac:picMk id="85" creationId="{FA81BB0F-08B2-40A0-8F55-A967FE8AF713}"/>
          </ac:picMkLst>
        </pc:picChg>
        <pc:picChg chg="del mod modCrop">
          <ac:chgData name="Thu Huyen Pham" userId="3eb787573b41f7e6" providerId="LiveId" clId="{D21008C1-1F35-4EFD-920C-00227BB11F61}" dt="2019-03-17T14:23:27.957" v="2873" actId="478"/>
          <ac:picMkLst>
            <pc:docMk/>
            <pc:sldMk cId="2945457629" sldId="260"/>
            <ac:picMk id="86" creationId="{B77AF554-C0A7-443F-8A0B-510D1BBAEDB5}"/>
          </ac:picMkLst>
        </pc:picChg>
        <pc:picChg chg="del">
          <ac:chgData name="Thu Huyen Pham" userId="3eb787573b41f7e6" providerId="LiveId" clId="{D21008C1-1F35-4EFD-920C-00227BB11F61}" dt="2019-03-16T08:35:27.269" v="1537" actId="478"/>
          <ac:picMkLst>
            <pc:docMk/>
            <pc:sldMk cId="2945457629" sldId="260"/>
            <ac:picMk id="87" creationId="{E9675D39-AA6C-4717-9D91-AA6838CD94E4}"/>
          </ac:picMkLst>
        </pc:picChg>
        <pc:picChg chg="del">
          <ac:chgData name="Thu Huyen Pham" userId="3eb787573b41f7e6" providerId="LiveId" clId="{D21008C1-1F35-4EFD-920C-00227BB11F61}" dt="2019-03-16T01:36:52.125" v="44" actId="478"/>
          <ac:picMkLst>
            <pc:docMk/>
            <pc:sldMk cId="2945457629" sldId="260"/>
            <ac:picMk id="88" creationId="{662C08DC-E70E-4E77-BF21-6096443D32B7}"/>
          </ac:picMkLst>
        </pc:picChg>
        <pc:picChg chg="del">
          <ac:chgData name="Thu Huyen Pham" userId="3eb787573b41f7e6" providerId="LiveId" clId="{D21008C1-1F35-4EFD-920C-00227BB11F61}" dt="2019-03-16T01:36:52.125" v="44" actId="478"/>
          <ac:picMkLst>
            <pc:docMk/>
            <pc:sldMk cId="2945457629" sldId="260"/>
            <ac:picMk id="89" creationId="{876A3850-FBEA-4619-9115-17D27DAC3DF0}"/>
          </ac:picMkLst>
        </pc:picChg>
        <pc:picChg chg="del">
          <ac:chgData name="Thu Huyen Pham" userId="3eb787573b41f7e6" providerId="LiveId" clId="{D21008C1-1F35-4EFD-920C-00227BB11F61}" dt="2019-03-16T01:36:15.336" v="34"/>
          <ac:picMkLst>
            <pc:docMk/>
            <pc:sldMk cId="2945457629" sldId="260"/>
            <ac:picMk id="90" creationId="{DA657FC7-82C9-4EA8-A5C9-5E6CCD3560E4}"/>
          </ac:picMkLst>
        </pc:picChg>
        <pc:picChg chg="del">
          <ac:chgData name="Thu Huyen Pham" userId="3eb787573b41f7e6" providerId="LiveId" clId="{D21008C1-1F35-4EFD-920C-00227BB11F61}" dt="2019-03-16T01:36:52.125" v="44" actId="478"/>
          <ac:picMkLst>
            <pc:docMk/>
            <pc:sldMk cId="2945457629" sldId="260"/>
            <ac:picMk id="91" creationId="{53B4F112-6093-433A-A933-7BC1D3FF5E74}"/>
          </ac:picMkLst>
        </pc:picChg>
        <pc:picChg chg="del">
          <ac:chgData name="Thu Huyen Pham" userId="3eb787573b41f7e6" providerId="LiveId" clId="{D21008C1-1F35-4EFD-920C-00227BB11F61}" dt="2019-03-16T01:36:15.336" v="34"/>
          <ac:picMkLst>
            <pc:docMk/>
            <pc:sldMk cId="2945457629" sldId="260"/>
            <ac:picMk id="92" creationId="{812AA0AB-2431-423B-AAF0-1A1E63955C29}"/>
          </ac:picMkLst>
        </pc:picChg>
        <pc:picChg chg="del">
          <ac:chgData name="Thu Huyen Pham" userId="3eb787573b41f7e6" providerId="LiveId" clId="{D21008C1-1F35-4EFD-920C-00227BB11F61}" dt="2019-03-16T01:36:15.336" v="34"/>
          <ac:picMkLst>
            <pc:docMk/>
            <pc:sldMk cId="2945457629" sldId="260"/>
            <ac:picMk id="93" creationId="{C0565040-9632-4983-A7F8-E00780EF329A}"/>
          </ac:picMkLst>
        </pc:picChg>
        <pc:picChg chg="del">
          <ac:chgData name="Thu Huyen Pham" userId="3eb787573b41f7e6" providerId="LiveId" clId="{D21008C1-1F35-4EFD-920C-00227BB11F61}" dt="2019-03-16T01:36:15.336" v="34"/>
          <ac:picMkLst>
            <pc:docMk/>
            <pc:sldMk cId="2945457629" sldId="260"/>
            <ac:picMk id="101" creationId="{72A87A91-1B8E-42E1-B210-2D1E50080EA8}"/>
          </ac:picMkLst>
        </pc:picChg>
        <pc:picChg chg="del">
          <ac:chgData name="Thu Huyen Pham" userId="3eb787573b41f7e6" providerId="LiveId" clId="{D21008C1-1F35-4EFD-920C-00227BB11F61}" dt="2019-03-16T07:32:49.864" v="1440" actId="478"/>
          <ac:picMkLst>
            <pc:docMk/>
            <pc:sldMk cId="2945457629" sldId="260"/>
            <ac:picMk id="103" creationId="{FE3F8D4A-2CD5-40CE-A8BE-717BAA70DA0C}"/>
          </ac:picMkLst>
        </pc:picChg>
        <pc:picChg chg="del mod">
          <ac:chgData name="Thu Huyen Pham" userId="3eb787573b41f7e6" providerId="LiveId" clId="{D21008C1-1F35-4EFD-920C-00227BB11F61}" dt="2019-03-16T07:11:34.287" v="1241"/>
          <ac:picMkLst>
            <pc:docMk/>
            <pc:sldMk cId="2945457629" sldId="260"/>
            <ac:picMk id="104" creationId="{F90386B3-E06F-4ACD-8C98-0CBD74C4BAFF}"/>
          </ac:picMkLst>
        </pc:picChg>
        <pc:picChg chg="del mod">
          <ac:chgData name="Thu Huyen Pham" userId="3eb787573b41f7e6" providerId="LiveId" clId="{D21008C1-1F35-4EFD-920C-00227BB11F61}" dt="2019-03-17T13:19:21.915" v="2508"/>
          <ac:picMkLst>
            <pc:docMk/>
            <pc:sldMk cId="2945457629" sldId="260"/>
            <ac:picMk id="105" creationId="{517C7BA0-7DC5-449A-A830-6B07D8739346}"/>
          </ac:picMkLst>
        </pc:picChg>
        <pc:picChg chg="del mod modCrop">
          <ac:chgData name="Thu Huyen Pham" userId="3eb787573b41f7e6" providerId="LiveId" clId="{D21008C1-1F35-4EFD-920C-00227BB11F61}" dt="2019-03-17T13:42:22.457" v="2525" actId="478"/>
          <ac:picMkLst>
            <pc:docMk/>
            <pc:sldMk cId="2945457629" sldId="260"/>
            <ac:picMk id="106" creationId="{1E45E393-AC02-406E-808E-B55AD5B764DC}"/>
          </ac:picMkLst>
        </pc:picChg>
        <pc:picChg chg="del mod">
          <ac:chgData name="Thu Huyen Pham" userId="3eb787573b41f7e6" providerId="LiveId" clId="{D21008C1-1F35-4EFD-920C-00227BB11F61}" dt="2019-03-16T06:56:57.128" v="1069" actId="478"/>
          <ac:picMkLst>
            <pc:docMk/>
            <pc:sldMk cId="2945457629" sldId="260"/>
            <ac:picMk id="107" creationId="{4A78BE66-AB5B-4782-9AA3-5F15F63F8BBC}"/>
          </ac:picMkLst>
        </pc:picChg>
        <pc:picChg chg="add del mod modCrop">
          <ac:chgData name="Thu Huyen Pham" userId="3eb787573b41f7e6" providerId="LiveId" clId="{D21008C1-1F35-4EFD-920C-00227BB11F61}" dt="2019-03-17T13:42:22.457" v="2525" actId="478"/>
          <ac:picMkLst>
            <pc:docMk/>
            <pc:sldMk cId="2945457629" sldId="260"/>
            <ac:picMk id="108" creationId="{D1CAA9FB-EAE1-436E-A8BB-6488AA009211}"/>
          </ac:picMkLst>
        </pc:picChg>
        <pc:picChg chg="add del mod modCrop">
          <ac:chgData name="Thu Huyen Pham" userId="3eb787573b41f7e6" providerId="LiveId" clId="{D21008C1-1F35-4EFD-920C-00227BB11F61}" dt="2019-03-16T08:56:40.199" v="1664" actId="478"/>
          <ac:picMkLst>
            <pc:docMk/>
            <pc:sldMk cId="2945457629" sldId="260"/>
            <ac:picMk id="109" creationId="{02284C00-2B60-4CA8-B44A-282EB7F77B9D}"/>
          </ac:picMkLst>
        </pc:picChg>
        <pc:picChg chg="add del mod modCrop">
          <ac:chgData name="Thu Huyen Pham" userId="3eb787573b41f7e6" providerId="LiveId" clId="{D21008C1-1F35-4EFD-920C-00227BB11F61}" dt="2019-03-16T01:33:13.181" v="27" actId="478"/>
          <ac:picMkLst>
            <pc:docMk/>
            <pc:sldMk cId="2945457629" sldId="260"/>
            <ac:picMk id="110" creationId="{B7BEC6F4-AB69-4DB3-AE58-7D3711434E86}"/>
          </ac:picMkLst>
        </pc:picChg>
        <pc:picChg chg="add del mod">
          <ac:chgData name="Thu Huyen Pham" userId="3eb787573b41f7e6" providerId="LiveId" clId="{D21008C1-1F35-4EFD-920C-00227BB11F61}" dt="2019-03-16T06:37:17.383" v="837"/>
          <ac:picMkLst>
            <pc:docMk/>
            <pc:sldMk cId="2945457629" sldId="260"/>
            <ac:picMk id="112" creationId="{807206E8-D4E0-4D36-AC1D-6EE6274671EB}"/>
          </ac:picMkLst>
        </pc:picChg>
        <pc:picChg chg="add del mod modCrop">
          <ac:chgData name="Thu Huyen Pham" userId="3eb787573b41f7e6" providerId="LiveId" clId="{D21008C1-1F35-4EFD-920C-00227BB11F61}" dt="2019-03-17T13:42:22.457" v="2525" actId="478"/>
          <ac:picMkLst>
            <pc:docMk/>
            <pc:sldMk cId="2945457629" sldId="260"/>
            <ac:picMk id="114" creationId="{ECAEA474-AA85-472C-B12E-DAF80903CB6D}"/>
          </ac:picMkLst>
        </pc:picChg>
        <pc:picChg chg="add del mod">
          <ac:chgData name="Thu Huyen Pham" userId="3eb787573b41f7e6" providerId="LiveId" clId="{D21008C1-1F35-4EFD-920C-00227BB11F61}" dt="2019-03-17T13:19:21.915" v="2508"/>
          <ac:picMkLst>
            <pc:docMk/>
            <pc:sldMk cId="2945457629" sldId="260"/>
            <ac:picMk id="115" creationId="{5333C13B-EB7B-493A-BA2D-2DB14F00779D}"/>
          </ac:picMkLst>
        </pc:picChg>
        <pc:picChg chg="add del mod">
          <ac:chgData name="Thu Huyen Pham" userId="3eb787573b41f7e6" providerId="LiveId" clId="{D21008C1-1F35-4EFD-920C-00227BB11F61}" dt="2019-03-16T06:45:51.810" v="888" actId="478"/>
          <ac:picMkLst>
            <pc:docMk/>
            <pc:sldMk cId="2945457629" sldId="260"/>
            <ac:picMk id="116" creationId="{847313A4-AE34-4542-A8F7-F8722A51368C}"/>
          </ac:picMkLst>
        </pc:picChg>
        <pc:picChg chg="del mod topLvl">
          <ac:chgData name="Thu Huyen Pham" userId="3eb787573b41f7e6" providerId="LiveId" clId="{D21008C1-1F35-4EFD-920C-00227BB11F61}" dt="2019-03-16T06:46:58.886" v="895" actId="478"/>
          <ac:picMkLst>
            <pc:docMk/>
            <pc:sldMk cId="2945457629" sldId="260"/>
            <ac:picMk id="119" creationId="{A631AAAA-8ECE-436A-9865-0A1E753DE919}"/>
          </ac:picMkLst>
        </pc:picChg>
        <pc:picChg chg="del mod topLvl">
          <ac:chgData name="Thu Huyen Pham" userId="3eb787573b41f7e6" providerId="LiveId" clId="{D21008C1-1F35-4EFD-920C-00227BB11F61}" dt="2019-03-16T06:46:59.861" v="896" actId="478"/>
          <ac:picMkLst>
            <pc:docMk/>
            <pc:sldMk cId="2945457629" sldId="260"/>
            <ac:picMk id="120" creationId="{6B68AE8D-F7E5-4131-AE0F-870EE497E213}"/>
          </ac:picMkLst>
        </pc:picChg>
        <pc:picChg chg="del mod topLvl">
          <ac:chgData name="Thu Huyen Pham" userId="3eb787573b41f7e6" providerId="LiveId" clId="{D21008C1-1F35-4EFD-920C-00227BB11F61}" dt="2019-03-16T06:47:38.266" v="903" actId="478"/>
          <ac:picMkLst>
            <pc:docMk/>
            <pc:sldMk cId="2945457629" sldId="260"/>
            <ac:picMk id="127" creationId="{BA1DEA87-95C1-41BE-8B6E-F3577CE4B1E3}"/>
          </ac:picMkLst>
        </pc:picChg>
        <pc:picChg chg="del mod topLvl">
          <ac:chgData name="Thu Huyen Pham" userId="3eb787573b41f7e6" providerId="LiveId" clId="{D21008C1-1F35-4EFD-920C-00227BB11F61}" dt="2019-03-16T06:47:38.266" v="903" actId="478"/>
          <ac:picMkLst>
            <pc:docMk/>
            <pc:sldMk cId="2945457629" sldId="260"/>
            <ac:picMk id="128" creationId="{F66DFBC6-85D6-4FD1-90B3-DC8C067531A0}"/>
          </ac:picMkLst>
        </pc:picChg>
        <pc:picChg chg="add del mod">
          <ac:chgData name="Thu Huyen Pham" userId="3eb787573b41f7e6" providerId="LiveId" clId="{D21008C1-1F35-4EFD-920C-00227BB11F61}" dt="2019-03-16T06:50:42.114" v="1033" actId="478"/>
          <ac:picMkLst>
            <pc:docMk/>
            <pc:sldMk cId="2945457629" sldId="260"/>
            <ac:picMk id="129" creationId="{C09A559F-9EC2-4F21-B478-036D4410E9FA}"/>
          </ac:picMkLst>
        </pc:picChg>
        <pc:picChg chg="add del mod modCrop">
          <ac:chgData name="Thu Huyen Pham" userId="3eb787573b41f7e6" providerId="LiveId" clId="{D21008C1-1F35-4EFD-920C-00227BB11F61}" dt="2019-03-17T14:29:15.487" v="2927" actId="478"/>
          <ac:picMkLst>
            <pc:docMk/>
            <pc:sldMk cId="2945457629" sldId="260"/>
            <ac:picMk id="130" creationId="{6C4F2A5D-C257-4DEE-B290-1FE1B47FB930}"/>
          </ac:picMkLst>
        </pc:picChg>
        <pc:picChg chg="add del mod modCrop">
          <ac:chgData name="Thu Huyen Pham" userId="3eb787573b41f7e6" providerId="LiveId" clId="{D21008C1-1F35-4EFD-920C-00227BB11F61}" dt="2019-03-17T13:42:22.457" v="2525" actId="478"/>
          <ac:picMkLst>
            <pc:docMk/>
            <pc:sldMk cId="2945457629" sldId="260"/>
            <ac:picMk id="131" creationId="{E0298B9E-8963-4D63-8731-B6231F0CFB91}"/>
          </ac:picMkLst>
        </pc:picChg>
        <pc:picChg chg="add del mod modCrop">
          <ac:chgData name="Thu Huyen Pham" userId="3eb787573b41f7e6" providerId="LiveId" clId="{D21008C1-1F35-4EFD-920C-00227BB11F61}" dt="2019-03-16T07:32:58.895" v="1442" actId="478"/>
          <ac:picMkLst>
            <pc:docMk/>
            <pc:sldMk cId="2945457629" sldId="260"/>
            <ac:picMk id="132" creationId="{FFDFA67C-BB7D-4474-9AF8-11442DED4634}"/>
          </ac:picMkLst>
        </pc:picChg>
        <pc:picChg chg="add del mod">
          <ac:chgData name="Thu Huyen Pham" userId="3eb787573b41f7e6" providerId="LiveId" clId="{D21008C1-1F35-4EFD-920C-00227BB11F61}" dt="2019-03-16T07:30:22.155" v="1423" actId="478"/>
          <ac:picMkLst>
            <pc:docMk/>
            <pc:sldMk cId="2945457629" sldId="260"/>
            <ac:picMk id="134" creationId="{4337C520-01D2-4EF3-924E-F0C4BDC8BB34}"/>
          </ac:picMkLst>
        </pc:picChg>
        <pc:picChg chg="add del mod modCrop">
          <ac:chgData name="Thu Huyen Pham" userId="3eb787573b41f7e6" providerId="LiveId" clId="{D21008C1-1F35-4EFD-920C-00227BB11F61}" dt="2019-03-17T13:42:22.457" v="2525" actId="478"/>
          <ac:picMkLst>
            <pc:docMk/>
            <pc:sldMk cId="2945457629" sldId="260"/>
            <ac:picMk id="136" creationId="{4DC334A2-2450-485D-B0DC-1453F65D989E}"/>
          </ac:picMkLst>
        </pc:picChg>
        <pc:picChg chg="add del mod modCrop">
          <ac:chgData name="Thu Huyen Pham" userId="3eb787573b41f7e6" providerId="LiveId" clId="{D21008C1-1F35-4EFD-920C-00227BB11F61}" dt="2019-03-16T08:36:54.391" v="1542" actId="478"/>
          <ac:picMkLst>
            <pc:docMk/>
            <pc:sldMk cId="2945457629" sldId="260"/>
            <ac:picMk id="137" creationId="{6D30FD73-219B-4F41-A052-2EC9123CB031}"/>
          </ac:picMkLst>
        </pc:picChg>
        <pc:picChg chg="add del mod modCrop">
          <ac:chgData name="Thu Huyen Pham" userId="3eb787573b41f7e6" providerId="LiveId" clId="{D21008C1-1F35-4EFD-920C-00227BB11F61}" dt="2019-03-17T13:42:22.457" v="2525" actId="478"/>
          <ac:picMkLst>
            <pc:docMk/>
            <pc:sldMk cId="2945457629" sldId="260"/>
            <ac:picMk id="139" creationId="{5A4E92F6-0CFF-41BD-979C-7953EB862693}"/>
          </ac:picMkLst>
        </pc:picChg>
        <pc:picChg chg="add del mod modCrop">
          <ac:chgData name="Thu Huyen Pham" userId="3eb787573b41f7e6" providerId="LiveId" clId="{D21008C1-1F35-4EFD-920C-00227BB11F61}" dt="2019-03-17T14:29:15.487" v="2927" actId="478"/>
          <ac:picMkLst>
            <pc:docMk/>
            <pc:sldMk cId="2945457629" sldId="260"/>
            <ac:picMk id="141" creationId="{FDC32AFB-59DA-469B-AD5F-C20418462AD5}"/>
          </ac:picMkLst>
        </pc:picChg>
        <pc:picChg chg="add del mod modCrop">
          <ac:chgData name="Thu Huyen Pham" userId="3eb787573b41f7e6" providerId="LiveId" clId="{D21008C1-1F35-4EFD-920C-00227BB11F61}" dt="2019-03-17T13:42:22.457" v="2525" actId="478"/>
          <ac:picMkLst>
            <pc:docMk/>
            <pc:sldMk cId="2945457629" sldId="260"/>
            <ac:picMk id="142" creationId="{8B7AEAA6-F3DA-4304-BC2B-01F60E14BAC9}"/>
          </ac:picMkLst>
        </pc:picChg>
        <pc:picChg chg="add del mod modCrop">
          <ac:chgData name="Thu Huyen Pham" userId="3eb787573b41f7e6" providerId="LiveId" clId="{D21008C1-1F35-4EFD-920C-00227BB11F61}" dt="2019-03-17T14:29:15.487" v="2927" actId="478"/>
          <ac:picMkLst>
            <pc:docMk/>
            <pc:sldMk cId="2945457629" sldId="260"/>
            <ac:picMk id="143" creationId="{451B9936-3BAF-4361-8E9C-4BA4A11DE161}"/>
          </ac:picMkLst>
        </pc:picChg>
        <pc:picChg chg="add del mod modCrop">
          <ac:chgData name="Thu Huyen Pham" userId="3eb787573b41f7e6" providerId="LiveId" clId="{D21008C1-1F35-4EFD-920C-00227BB11F61}" dt="2019-03-17T14:29:15.487" v="2927" actId="478"/>
          <ac:picMkLst>
            <pc:docMk/>
            <pc:sldMk cId="2945457629" sldId="260"/>
            <ac:picMk id="144" creationId="{0815BEB4-C364-4C00-814B-9F19657EC55C}"/>
          </ac:picMkLst>
        </pc:picChg>
        <pc:picChg chg="add del mod modCrop">
          <ac:chgData name="Thu Huyen Pham" userId="3eb787573b41f7e6" providerId="LiveId" clId="{D21008C1-1F35-4EFD-920C-00227BB11F61}" dt="2019-03-17T14:29:15.487" v="2927" actId="478"/>
          <ac:picMkLst>
            <pc:docMk/>
            <pc:sldMk cId="2945457629" sldId="260"/>
            <ac:picMk id="145" creationId="{34D7E7AC-CEA4-43DB-91E9-ACDCBACB910B}"/>
          </ac:picMkLst>
        </pc:picChg>
        <pc:picChg chg="add del mod modCrop">
          <ac:chgData name="Thu Huyen Pham" userId="3eb787573b41f7e6" providerId="LiveId" clId="{D21008C1-1F35-4EFD-920C-00227BB11F61}" dt="2019-03-17T14:29:15.487" v="2927" actId="478"/>
          <ac:picMkLst>
            <pc:docMk/>
            <pc:sldMk cId="2945457629" sldId="260"/>
            <ac:picMk id="146" creationId="{5ADE31CB-A7CA-4E04-BB2C-EC574FDB7A39}"/>
          </ac:picMkLst>
        </pc:picChg>
        <pc:picChg chg="add del mod">
          <ac:chgData name="Thu Huyen Pham" userId="3eb787573b41f7e6" providerId="LiveId" clId="{D21008C1-1F35-4EFD-920C-00227BB11F61}" dt="2019-03-17T13:19:21.915" v="2508"/>
          <ac:picMkLst>
            <pc:docMk/>
            <pc:sldMk cId="2945457629" sldId="260"/>
            <ac:picMk id="147" creationId="{E9CC71DA-43AF-4CB7-87AB-DE5C1BB4911C}"/>
          </ac:picMkLst>
        </pc:picChg>
        <pc:picChg chg="add mod">
          <ac:chgData name="Thu Huyen Pham" userId="3eb787573b41f7e6" providerId="LiveId" clId="{D21008C1-1F35-4EFD-920C-00227BB11F61}" dt="2019-03-18T01:15:43.995" v="3155" actId="1076"/>
          <ac:picMkLst>
            <pc:docMk/>
            <pc:sldMk cId="2945457629" sldId="260"/>
            <ac:picMk id="151" creationId="{608FDCE2-E7A4-4D88-B88A-01D872E6F377}"/>
          </ac:picMkLst>
        </pc:picChg>
        <pc:picChg chg="add mod">
          <ac:chgData name="Thu Huyen Pham" userId="3eb787573b41f7e6" providerId="LiveId" clId="{D21008C1-1F35-4EFD-920C-00227BB11F61}" dt="2019-03-18T01:14:37.946" v="3137" actId="1076"/>
          <ac:picMkLst>
            <pc:docMk/>
            <pc:sldMk cId="2945457629" sldId="260"/>
            <ac:picMk id="153" creationId="{B8C0FCDD-A46F-4C85-8B76-CF2750457F2F}"/>
          </ac:picMkLst>
        </pc:picChg>
        <pc:picChg chg="add mod">
          <ac:chgData name="Thu Huyen Pham" userId="3eb787573b41f7e6" providerId="LiveId" clId="{D21008C1-1F35-4EFD-920C-00227BB11F61}" dt="2019-03-18T01:14:37.946" v="3137" actId="1076"/>
          <ac:picMkLst>
            <pc:docMk/>
            <pc:sldMk cId="2945457629" sldId="260"/>
            <ac:picMk id="155" creationId="{6565E33E-0D66-452C-84CB-79D1C0BB342E}"/>
          </ac:picMkLst>
        </pc:picChg>
        <pc:picChg chg="add mod">
          <ac:chgData name="Thu Huyen Pham" userId="3eb787573b41f7e6" providerId="LiveId" clId="{D21008C1-1F35-4EFD-920C-00227BB11F61}" dt="2019-03-18T01:14:37.946" v="3137" actId="1076"/>
          <ac:picMkLst>
            <pc:docMk/>
            <pc:sldMk cId="2945457629" sldId="260"/>
            <ac:picMk id="157" creationId="{C7E26B83-44E2-4210-A25B-79075B5E9CD3}"/>
          </ac:picMkLst>
        </pc:picChg>
        <pc:picChg chg="add mod">
          <ac:chgData name="Thu Huyen Pham" userId="3eb787573b41f7e6" providerId="LiveId" clId="{D21008C1-1F35-4EFD-920C-00227BB11F61}" dt="2019-03-17T14:28:21.679" v="2915" actId="1076"/>
          <ac:picMkLst>
            <pc:docMk/>
            <pc:sldMk cId="2945457629" sldId="260"/>
            <ac:picMk id="159" creationId="{14B73C28-3F4C-417E-BCEC-7543F8C46646}"/>
          </ac:picMkLst>
        </pc:picChg>
        <pc:picChg chg="add mod">
          <ac:chgData name="Thu Huyen Pham" userId="3eb787573b41f7e6" providerId="LiveId" clId="{D21008C1-1F35-4EFD-920C-00227BB11F61}" dt="2019-03-17T14:28:28.825" v="2917" actId="1076"/>
          <ac:picMkLst>
            <pc:docMk/>
            <pc:sldMk cId="2945457629" sldId="260"/>
            <ac:picMk id="161" creationId="{06B41AA4-E217-4A7C-A89C-1DF7AB40CC56}"/>
          </ac:picMkLst>
        </pc:picChg>
        <pc:picChg chg="add del mod modCrop">
          <ac:chgData name="Thu Huyen Pham" userId="3eb787573b41f7e6" providerId="LiveId" clId="{D21008C1-1F35-4EFD-920C-00227BB11F61}" dt="2019-03-17T14:31:22.066" v="2939" actId="478"/>
          <ac:picMkLst>
            <pc:docMk/>
            <pc:sldMk cId="2945457629" sldId="260"/>
            <ac:picMk id="167" creationId="{41A89B79-C65A-4F8E-9DF4-7CEEC23CF328}"/>
          </ac:picMkLst>
        </pc:picChg>
        <pc:picChg chg="add del mod">
          <ac:chgData name="Thu Huyen Pham" userId="3eb787573b41f7e6" providerId="LiveId" clId="{D21008C1-1F35-4EFD-920C-00227BB11F61}" dt="2019-03-17T14:18:12.019" v="2760" actId="478"/>
          <ac:picMkLst>
            <pc:docMk/>
            <pc:sldMk cId="2945457629" sldId="260"/>
            <ac:picMk id="169" creationId="{5D24C678-76A5-422E-91A2-C6B5372A60D8}"/>
          </ac:picMkLst>
        </pc:picChg>
        <pc:picChg chg="add del mod">
          <ac:chgData name="Thu Huyen Pham" userId="3eb787573b41f7e6" providerId="LiveId" clId="{D21008C1-1F35-4EFD-920C-00227BB11F61}" dt="2019-03-17T14:18:44.203" v="2763" actId="478"/>
          <ac:picMkLst>
            <pc:docMk/>
            <pc:sldMk cId="2945457629" sldId="260"/>
            <ac:picMk id="171" creationId="{D3F64611-F5C8-498A-8D88-A9A325DA984F}"/>
          </ac:picMkLst>
        </pc:picChg>
        <pc:picChg chg="add del mod modCrop">
          <ac:chgData name="Thu Huyen Pham" userId="3eb787573b41f7e6" providerId="LiveId" clId="{D21008C1-1F35-4EFD-920C-00227BB11F61}" dt="2019-03-17T14:29:15.487" v="2927" actId="478"/>
          <ac:picMkLst>
            <pc:docMk/>
            <pc:sldMk cId="2945457629" sldId="260"/>
            <ac:picMk id="172" creationId="{A83F04EE-B165-43DC-BF24-4F148248FBF2}"/>
          </ac:picMkLst>
        </pc:picChg>
        <pc:picChg chg="add del mod">
          <ac:chgData name="Thu Huyen Pham" userId="3eb787573b41f7e6" providerId="LiveId" clId="{D21008C1-1F35-4EFD-920C-00227BB11F61}" dt="2019-03-17T14:32:41.082" v="2946"/>
          <ac:picMkLst>
            <pc:docMk/>
            <pc:sldMk cId="2945457629" sldId="260"/>
            <ac:picMk id="182" creationId="{662F23A7-B46E-4B25-A674-D58BB9AD089D}"/>
          </ac:picMkLst>
        </pc:picChg>
        <pc:picChg chg="add mod ord">
          <ac:chgData name="Thu Huyen Pham" userId="3eb787573b41f7e6" providerId="LiveId" clId="{D21008C1-1F35-4EFD-920C-00227BB11F61}" dt="2019-03-17T14:32:18.469" v="2945" actId="1076"/>
          <ac:picMkLst>
            <pc:docMk/>
            <pc:sldMk cId="2945457629" sldId="260"/>
            <ac:picMk id="184" creationId="{FE557C00-71C2-482A-B207-09AD4B02DD67}"/>
          </ac:picMkLst>
        </pc:picChg>
        <pc:cxnChg chg="del">
          <ac:chgData name="Thu Huyen Pham" userId="3eb787573b41f7e6" providerId="LiveId" clId="{D21008C1-1F35-4EFD-920C-00227BB11F61}" dt="2019-03-16T01:36:52.125" v="44" actId="478"/>
          <ac:cxnSpMkLst>
            <pc:docMk/>
            <pc:sldMk cId="2945457629" sldId="260"/>
            <ac:cxnSpMk id="6" creationId="{2E84E88E-5309-4AF2-93AD-A8B764AD45E6}"/>
          </ac:cxnSpMkLst>
        </pc:cxnChg>
        <pc:cxnChg chg="del">
          <ac:chgData name="Thu Huyen Pham" userId="3eb787573b41f7e6" providerId="LiveId" clId="{D21008C1-1F35-4EFD-920C-00227BB11F61}" dt="2019-03-16T01:36:52.125" v="44" actId="478"/>
          <ac:cxnSpMkLst>
            <pc:docMk/>
            <pc:sldMk cId="2945457629" sldId="260"/>
            <ac:cxnSpMk id="10" creationId="{DBAAB765-3207-4E22-9034-2ED8F6651BDD}"/>
          </ac:cxnSpMkLst>
        </pc:cxnChg>
        <pc:cxnChg chg="del">
          <ac:chgData name="Thu Huyen Pham" userId="3eb787573b41f7e6" providerId="LiveId" clId="{D21008C1-1F35-4EFD-920C-00227BB11F61}" dt="2019-03-16T01:36:52.125" v="44" actId="478"/>
          <ac:cxnSpMkLst>
            <pc:docMk/>
            <pc:sldMk cId="2945457629" sldId="260"/>
            <ac:cxnSpMk id="56" creationId="{359B6302-878F-480A-8A4F-0B6693696273}"/>
          </ac:cxnSpMkLst>
        </pc:cxnChg>
        <pc:cxnChg chg="del">
          <ac:chgData name="Thu Huyen Pham" userId="3eb787573b41f7e6" providerId="LiveId" clId="{D21008C1-1F35-4EFD-920C-00227BB11F61}" dt="2019-03-16T01:36:52.125" v="44" actId="478"/>
          <ac:cxnSpMkLst>
            <pc:docMk/>
            <pc:sldMk cId="2945457629" sldId="260"/>
            <ac:cxnSpMk id="58" creationId="{6EEF004E-C6CE-4E8B-B436-179976ED53E0}"/>
          </ac:cxnSpMkLst>
        </pc:cxnChg>
        <pc:cxnChg chg="del">
          <ac:chgData name="Thu Huyen Pham" userId="3eb787573b41f7e6" providerId="LiveId" clId="{D21008C1-1F35-4EFD-920C-00227BB11F61}" dt="2019-03-16T01:36:15.336" v="34"/>
          <ac:cxnSpMkLst>
            <pc:docMk/>
            <pc:sldMk cId="2945457629" sldId="260"/>
            <ac:cxnSpMk id="69" creationId="{91E018E3-36F7-46DD-A1DB-D049EB3F78A0}"/>
          </ac:cxnSpMkLst>
        </pc:cxnChg>
        <pc:cxnChg chg="del">
          <ac:chgData name="Thu Huyen Pham" userId="3eb787573b41f7e6" providerId="LiveId" clId="{D21008C1-1F35-4EFD-920C-00227BB11F61}" dt="2019-03-16T01:36:15.336" v="34"/>
          <ac:cxnSpMkLst>
            <pc:docMk/>
            <pc:sldMk cId="2945457629" sldId="260"/>
            <ac:cxnSpMk id="75" creationId="{4B8E6D55-FF9A-46E2-A6E8-26360442E2AA}"/>
          </ac:cxnSpMkLst>
        </pc:cxnChg>
        <pc:cxnChg chg="del">
          <ac:chgData name="Thu Huyen Pham" userId="3eb787573b41f7e6" providerId="LiveId" clId="{D21008C1-1F35-4EFD-920C-00227BB11F61}" dt="2019-03-16T01:36:15.336" v="34"/>
          <ac:cxnSpMkLst>
            <pc:docMk/>
            <pc:sldMk cId="2945457629" sldId="260"/>
            <ac:cxnSpMk id="78" creationId="{1E38E2EA-0F70-4F99-83CB-C627A7C3D9D8}"/>
          </ac:cxnSpMkLst>
        </pc:cxnChg>
        <pc:cxnChg chg="del">
          <ac:chgData name="Thu Huyen Pham" userId="3eb787573b41f7e6" providerId="LiveId" clId="{D21008C1-1F35-4EFD-920C-00227BB11F61}" dt="2019-03-16T01:36:15.336" v="34"/>
          <ac:cxnSpMkLst>
            <pc:docMk/>
            <pc:sldMk cId="2945457629" sldId="260"/>
            <ac:cxnSpMk id="81" creationId="{8CA28567-B877-49C1-AA4D-0E1E8E57F04E}"/>
          </ac:cxnSpMkLst>
        </pc:cxnChg>
        <pc:cxnChg chg="del">
          <ac:chgData name="Thu Huyen Pham" userId="3eb787573b41f7e6" providerId="LiveId" clId="{D21008C1-1F35-4EFD-920C-00227BB11F61}" dt="2019-03-16T01:36:15.336" v="34"/>
          <ac:cxnSpMkLst>
            <pc:docMk/>
            <pc:sldMk cId="2945457629" sldId="260"/>
            <ac:cxnSpMk id="82" creationId="{96B1D3D1-4C2E-4F28-87C7-19F3B304F045}"/>
          </ac:cxnSpMkLst>
        </pc:cxnChg>
        <pc:cxnChg chg="del">
          <ac:chgData name="Thu Huyen Pham" userId="3eb787573b41f7e6" providerId="LiveId" clId="{D21008C1-1F35-4EFD-920C-00227BB11F61}" dt="2019-03-16T01:36:15.336" v="34"/>
          <ac:cxnSpMkLst>
            <pc:docMk/>
            <pc:sldMk cId="2945457629" sldId="260"/>
            <ac:cxnSpMk id="83" creationId="{E46C31FC-086D-49C7-BDE9-B55B4CC97A4B}"/>
          </ac:cxnSpMkLst>
        </pc:cxnChg>
        <pc:cxnChg chg="add del mod">
          <ac:chgData name="Thu Huyen Pham" userId="3eb787573b41f7e6" providerId="LiveId" clId="{D21008C1-1F35-4EFD-920C-00227BB11F61}" dt="2019-03-16T06:54:26.117" v="1068" actId="478"/>
          <ac:cxnSpMkLst>
            <pc:docMk/>
            <pc:sldMk cId="2945457629" sldId="260"/>
            <ac:cxnSpMk id="117" creationId="{DA3517B4-3302-4086-9134-1F4C9B3328F3}"/>
          </ac:cxnSpMkLst>
        </pc:cxnChg>
        <pc:cxnChg chg="del mod topLvl">
          <ac:chgData name="Thu Huyen Pham" userId="3eb787573b41f7e6" providerId="LiveId" clId="{D21008C1-1F35-4EFD-920C-00227BB11F61}" dt="2019-03-16T06:47:23.859" v="901" actId="478"/>
          <ac:cxnSpMkLst>
            <pc:docMk/>
            <pc:sldMk cId="2945457629" sldId="260"/>
            <ac:cxnSpMk id="125" creationId="{DBE4F241-6143-4F37-A883-0CE401AD3A36}"/>
          </ac:cxnSpMkLst>
        </pc:cxnChg>
        <pc:cxnChg chg="del mod topLvl">
          <ac:chgData name="Thu Huyen Pham" userId="3eb787573b41f7e6" providerId="LiveId" clId="{D21008C1-1F35-4EFD-920C-00227BB11F61}" dt="2019-03-16T06:47:38.266" v="903" actId="478"/>
          <ac:cxnSpMkLst>
            <pc:docMk/>
            <pc:sldMk cId="2945457629" sldId="260"/>
            <ac:cxnSpMk id="126" creationId="{C9B67C97-A117-4BD5-AB1B-2A06BA277230}"/>
          </ac:cxnSpMkLst>
        </pc:cxnChg>
      </pc:sldChg>
      <pc:sldChg chg="addSp delSp modSp add">
        <pc:chgData name="Thu Huyen Pham" userId="3eb787573b41f7e6" providerId="LiveId" clId="{D21008C1-1F35-4EFD-920C-00227BB11F61}" dt="2019-03-18T00:47:53.332" v="3132"/>
        <pc:sldMkLst>
          <pc:docMk/>
          <pc:sldMk cId="1797404787" sldId="261"/>
        </pc:sldMkLst>
        <pc:spChg chg="del">
          <ac:chgData name="Thu Huyen Pham" userId="3eb787573b41f7e6" providerId="LiveId" clId="{D21008C1-1F35-4EFD-920C-00227BB11F61}" dt="2019-03-16T01:35:58.889" v="30" actId="478"/>
          <ac:spMkLst>
            <pc:docMk/>
            <pc:sldMk cId="1797404787" sldId="261"/>
            <ac:spMk id="2" creationId="{E9D0A257-4AE0-4E2E-A789-978429B1995B}"/>
          </ac:spMkLst>
        </pc:spChg>
        <pc:spChg chg="del">
          <ac:chgData name="Thu Huyen Pham" userId="3eb787573b41f7e6" providerId="LiveId" clId="{D21008C1-1F35-4EFD-920C-00227BB11F61}" dt="2019-03-16T01:36:00.443" v="31" actId="478"/>
          <ac:spMkLst>
            <pc:docMk/>
            <pc:sldMk cId="1797404787" sldId="261"/>
            <ac:spMk id="3" creationId="{A5CF685D-0239-4197-AEF9-9BA77B6F0CF1}"/>
          </ac:spMkLst>
        </pc:spChg>
        <pc:spChg chg="add del mod">
          <ac:chgData name="Thu Huyen Pham" userId="3eb787573b41f7e6" providerId="LiveId" clId="{D21008C1-1F35-4EFD-920C-00227BB11F61}" dt="2019-03-17T14:03:10.180" v="2695" actId="478"/>
          <ac:spMkLst>
            <pc:docMk/>
            <pc:sldMk cId="1797404787" sldId="261"/>
            <ac:spMk id="4" creationId="{AF7CA0F9-E20B-4E07-B8E2-B30F4EE0C8BC}"/>
          </ac:spMkLst>
        </pc:spChg>
        <pc:spChg chg="add mod">
          <ac:chgData name="Thu Huyen Pham" userId="3eb787573b41f7e6" providerId="LiveId" clId="{D21008C1-1F35-4EFD-920C-00227BB11F61}" dt="2019-03-17T14:00:02.456" v="2650" actId="1076"/>
          <ac:spMkLst>
            <pc:docMk/>
            <pc:sldMk cId="1797404787" sldId="261"/>
            <ac:spMk id="7" creationId="{77D416D2-019F-433B-82AF-56F4369EAD8E}"/>
          </ac:spMkLst>
        </pc:spChg>
        <pc:spChg chg="add mod">
          <ac:chgData name="Thu Huyen Pham" userId="3eb787573b41f7e6" providerId="LiveId" clId="{D21008C1-1F35-4EFD-920C-00227BB11F61}" dt="2019-03-17T14:00:02.456" v="2650" actId="1076"/>
          <ac:spMkLst>
            <pc:docMk/>
            <pc:sldMk cId="1797404787" sldId="261"/>
            <ac:spMk id="9" creationId="{058734BC-5FC7-4D78-AF1C-1780B7E9F23B}"/>
          </ac:spMkLst>
        </pc:spChg>
        <pc:spChg chg="add mod">
          <ac:chgData name="Thu Huyen Pham" userId="3eb787573b41f7e6" providerId="LiveId" clId="{D21008C1-1F35-4EFD-920C-00227BB11F61}" dt="2019-03-17T14:00:02.456" v="2650" actId="1076"/>
          <ac:spMkLst>
            <pc:docMk/>
            <pc:sldMk cId="1797404787" sldId="261"/>
            <ac:spMk id="10" creationId="{6F00FFAD-7DED-434C-9A4E-E65D6AD81E18}"/>
          </ac:spMkLst>
        </pc:spChg>
        <pc:spChg chg="add mod">
          <ac:chgData name="Thu Huyen Pham" userId="3eb787573b41f7e6" providerId="LiveId" clId="{D21008C1-1F35-4EFD-920C-00227BB11F61}" dt="2019-03-17T14:00:02.456" v="2650" actId="1076"/>
          <ac:spMkLst>
            <pc:docMk/>
            <pc:sldMk cId="1797404787" sldId="261"/>
            <ac:spMk id="11" creationId="{B31B5754-DE20-428D-812F-A794EC2A5840}"/>
          </ac:spMkLst>
        </pc:spChg>
        <pc:spChg chg="add mod">
          <ac:chgData name="Thu Huyen Pham" userId="3eb787573b41f7e6" providerId="LiveId" clId="{D21008C1-1F35-4EFD-920C-00227BB11F61}" dt="2019-03-17T14:00:02.456" v="2650" actId="1076"/>
          <ac:spMkLst>
            <pc:docMk/>
            <pc:sldMk cId="1797404787" sldId="261"/>
            <ac:spMk id="12" creationId="{C77132D8-A978-4B8C-B109-8D56076A4139}"/>
          </ac:spMkLst>
        </pc:spChg>
        <pc:spChg chg="add mod">
          <ac:chgData name="Thu Huyen Pham" userId="3eb787573b41f7e6" providerId="LiveId" clId="{D21008C1-1F35-4EFD-920C-00227BB11F61}" dt="2019-03-17T14:00:02.456" v="2650" actId="1076"/>
          <ac:spMkLst>
            <pc:docMk/>
            <pc:sldMk cId="1797404787" sldId="261"/>
            <ac:spMk id="13" creationId="{7BDC7138-CE21-4557-96F6-513DB3B12E95}"/>
          </ac:spMkLst>
        </pc:spChg>
        <pc:spChg chg="add mod">
          <ac:chgData name="Thu Huyen Pham" userId="3eb787573b41f7e6" providerId="LiveId" clId="{D21008C1-1F35-4EFD-920C-00227BB11F61}" dt="2019-03-17T14:00:02.456" v="2650" actId="1076"/>
          <ac:spMkLst>
            <pc:docMk/>
            <pc:sldMk cId="1797404787" sldId="261"/>
            <ac:spMk id="15" creationId="{0768D373-8259-4134-AD70-D9507246E12C}"/>
          </ac:spMkLst>
        </pc:spChg>
        <pc:spChg chg="add mod">
          <ac:chgData name="Thu Huyen Pham" userId="3eb787573b41f7e6" providerId="LiveId" clId="{D21008C1-1F35-4EFD-920C-00227BB11F61}" dt="2019-03-17T14:00:51.612" v="2662" actId="1076"/>
          <ac:spMkLst>
            <pc:docMk/>
            <pc:sldMk cId="1797404787" sldId="261"/>
            <ac:spMk id="17" creationId="{A3CE611F-FF95-4F24-A8F6-4E1B22329DF0}"/>
          </ac:spMkLst>
        </pc:spChg>
        <pc:spChg chg="add mod">
          <ac:chgData name="Thu Huyen Pham" userId="3eb787573b41f7e6" providerId="LiveId" clId="{D21008C1-1F35-4EFD-920C-00227BB11F61}" dt="2019-03-17T14:02:43.723" v="2694" actId="1036"/>
          <ac:spMkLst>
            <pc:docMk/>
            <pc:sldMk cId="1797404787" sldId="261"/>
            <ac:spMk id="18" creationId="{FDEBA28D-4590-44DC-977B-2CB55178A89B}"/>
          </ac:spMkLst>
        </pc:spChg>
        <pc:spChg chg="add mod">
          <ac:chgData name="Thu Huyen Pham" userId="3eb787573b41f7e6" providerId="LiveId" clId="{D21008C1-1F35-4EFD-920C-00227BB11F61}" dt="2019-03-17T14:02:43.723" v="2694" actId="1036"/>
          <ac:spMkLst>
            <pc:docMk/>
            <pc:sldMk cId="1797404787" sldId="261"/>
            <ac:spMk id="19" creationId="{5B4A0BE5-F642-42BB-80B4-44B688CAB02A}"/>
          </ac:spMkLst>
        </pc:spChg>
        <pc:spChg chg="add mod">
          <ac:chgData name="Thu Huyen Pham" userId="3eb787573b41f7e6" providerId="LiveId" clId="{D21008C1-1F35-4EFD-920C-00227BB11F61}" dt="2019-03-17T14:00:48.604" v="2661" actId="1076"/>
          <ac:spMkLst>
            <pc:docMk/>
            <pc:sldMk cId="1797404787" sldId="261"/>
            <ac:spMk id="20" creationId="{EB36E811-8EE2-4896-9084-E2F10930E2C8}"/>
          </ac:spMkLst>
        </pc:spChg>
        <pc:spChg chg="add mod">
          <ac:chgData name="Thu Huyen Pham" userId="3eb787573b41f7e6" providerId="LiveId" clId="{D21008C1-1F35-4EFD-920C-00227BB11F61}" dt="2019-03-17T14:02:43.723" v="2694" actId="1036"/>
          <ac:spMkLst>
            <pc:docMk/>
            <pc:sldMk cId="1797404787" sldId="261"/>
            <ac:spMk id="30" creationId="{ED83E433-E7B8-4FAE-B98F-1DDB1D0B9B90}"/>
          </ac:spMkLst>
        </pc:spChg>
        <pc:spChg chg="add del mod">
          <ac:chgData name="Thu Huyen Pham" userId="3eb787573b41f7e6" providerId="LiveId" clId="{D21008C1-1F35-4EFD-920C-00227BB11F61}" dt="2019-03-17T14:01:32.261" v="2669" actId="478"/>
          <ac:spMkLst>
            <pc:docMk/>
            <pc:sldMk cId="1797404787" sldId="261"/>
            <ac:spMk id="31" creationId="{8C6E1689-4FD5-404F-B42E-4F923F13905A}"/>
          </ac:spMkLst>
        </pc:spChg>
        <pc:spChg chg="add del mod">
          <ac:chgData name="Thu Huyen Pham" userId="3eb787573b41f7e6" providerId="LiveId" clId="{D21008C1-1F35-4EFD-920C-00227BB11F61}" dt="2019-03-17T14:01:35.050" v="2670" actId="478"/>
          <ac:spMkLst>
            <pc:docMk/>
            <pc:sldMk cId="1797404787" sldId="261"/>
            <ac:spMk id="33" creationId="{B7E35449-DBF5-40A6-9F5C-3EEC6D24B3C4}"/>
          </ac:spMkLst>
        </pc:spChg>
        <pc:spChg chg="add mod">
          <ac:chgData name="Thu Huyen Pham" userId="3eb787573b41f7e6" providerId="LiveId" clId="{D21008C1-1F35-4EFD-920C-00227BB11F61}" dt="2019-03-17T14:02:43.723" v="2694" actId="1036"/>
          <ac:spMkLst>
            <pc:docMk/>
            <pc:sldMk cId="1797404787" sldId="261"/>
            <ac:spMk id="38" creationId="{D59F0720-2F3E-44C3-948D-8A7F17069E9F}"/>
          </ac:spMkLst>
        </pc:spChg>
        <pc:spChg chg="add mod">
          <ac:chgData name="Thu Huyen Pham" userId="3eb787573b41f7e6" providerId="LiveId" clId="{D21008C1-1F35-4EFD-920C-00227BB11F61}" dt="2019-03-17T14:01:05.509" v="2664" actId="20577"/>
          <ac:spMkLst>
            <pc:docMk/>
            <pc:sldMk cId="1797404787" sldId="261"/>
            <ac:spMk id="51" creationId="{679C3607-F800-4CED-A26C-7B54814FFBB4}"/>
          </ac:spMkLst>
        </pc:spChg>
        <pc:spChg chg="add mod">
          <ac:chgData name="Thu Huyen Pham" userId="3eb787573b41f7e6" providerId="LiveId" clId="{D21008C1-1F35-4EFD-920C-00227BB11F61}" dt="2019-03-17T14:01:43.551" v="2672" actId="1076"/>
          <ac:spMkLst>
            <pc:docMk/>
            <pc:sldMk cId="1797404787" sldId="261"/>
            <ac:spMk id="53" creationId="{DD83EC17-83AB-470A-BE43-923C0126DA71}"/>
          </ac:spMkLst>
        </pc:spChg>
        <pc:spChg chg="add mod">
          <ac:chgData name="Thu Huyen Pham" userId="3eb787573b41f7e6" providerId="LiveId" clId="{D21008C1-1F35-4EFD-920C-00227BB11F61}" dt="2019-03-17T14:02:14.732" v="2681" actId="1076"/>
          <ac:spMkLst>
            <pc:docMk/>
            <pc:sldMk cId="1797404787" sldId="261"/>
            <ac:spMk id="54" creationId="{A02F7FF0-D273-4C78-98FF-012B74E36C9F}"/>
          </ac:spMkLst>
        </pc:spChg>
        <pc:picChg chg="add del mod modCrop">
          <ac:chgData name="Thu Huyen Pham" userId="3eb787573b41f7e6" providerId="LiveId" clId="{D21008C1-1F35-4EFD-920C-00227BB11F61}" dt="2019-03-17T13:57:08.166" v="2625" actId="478"/>
          <ac:picMkLst>
            <pc:docMk/>
            <pc:sldMk cId="1797404787" sldId="261"/>
            <ac:picMk id="6" creationId="{685438CA-8EE5-4702-AC36-366F8EFE6062}"/>
          </ac:picMkLst>
        </pc:picChg>
        <pc:picChg chg="add del mod">
          <ac:chgData name="Thu Huyen Pham" userId="3eb787573b41f7e6" providerId="LiveId" clId="{D21008C1-1F35-4EFD-920C-00227BB11F61}" dt="2019-03-17T14:00:39.155" v="2658" actId="478"/>
          <ac:picMkLst>
            <pc:docMk/>
            <pc:sldMk cId="1797404787" sldId="261"/>
            <ac:picMk id="21" creationId="{489FEDC2-27F7-4083-B225-D6450E537A8F}"/>
          </ac:picMkLst>
        </pc:picChg>
        <pc:picChg chg="add del mod">
          <ac:chgData name="Thu Huyen Pham" userId="3eb787573b41f7e6" providerId="LiveId" clId="{D21008C1-1F35-4EFD-920C-00227BB11F61}" dt="2019-03-17T14:00:39.155" v="2658" actId="478"/>
          <ac:picMkLst>
            <pc:docMk/>
            <pc:sldMk cId="1797404787" sldId="261"/>
            <ac:picMk id="22" creationId="{9A704455-F717-4DE3-BE86-564C4991CF1E}"/>
          </ac:picMkLst>
        </pc:picChg>
        <pc:picChg chg="add del mod">
          <ac:chgData name="Thu Huyen Pham" userId="3eb787573b41f7e6" providerId="LiveId" clId="{D21008C1-1F35-4EFD-920C-00227BB11F61}" dt="2019-03-17T14:00:39.155" v="2658" actId="478"/>
          <ac:picMkLst>
            <pc:docMk/>
            <pc:sldMk cId="1797404787" sldId="261"/>
            <ac:picMk id="23" creationId="{E217ECEC-82BE-48E5-9592-74056207C280}"/>
          </ac:picMkLst>
        </pc:picChg>
        <pc:picChg chg="add del mod modCrop">
          <ac:chgData name="Thu Huyen Pham" userId="3eb787573b41f7e6" providerId="LiveId" clId="{D21008C1-1F35-4EFD-920C-00227BB11F61}" dt="2019-03-17T11:21:15.794" v="2010" actId="478"/>
          <ac:picMkLst>
            <pc:docMk/>
            <pc:sldMk cId="1797404787" sldId="261"/>
            <ac:picMk id="24" creationId="{B6F971F9-BFF0-4196-9B62-1E85E2E4ACDA}"/>
          </ac:picMkLst>
        </pc:picChg>
        <pc:picChg chg="add del mod modCrop">
          <ac:chgData name="Thu Huyen Pham" userId="3eb787573b41f7e6" providerId="LiveId" clId="{D21008C1-1F35-4EFD-920C-00227BB11F61}" dt="2019-03-17T11:20:15.694" v="2006" actId="478"/>
          <ac:picMkLst>
            <pc:docMk/>
            <pc:sldMk cId="1797404787" sldId="261"/>
            <ac:picMk id="25" creationId="{52DE73A6-9982-4FA8-9584-0EACDDBFA07C}"/>
          </ac:picMkLst>
        </pc:picChg>
        <pc:picChg chg="add del mod modCrop">
          <ac:chgData name="Thu Huyen Pham" userId="3eb787573b41f7e6" providerId="LiveId" clId="{D21008C1-1F35-4EFD-920C-00227BB11F61}" dt="2019-03-17T11:21:47.988" v="2015" actId="478"/>
          <ac:picMkLst>
            <pc:docMk/>
            <pc:sldMk cId="1797404787" sldId="261"/>
            <ac:picMk id="26" creationId="{927B7E85-6AFF-4860-B4C4-E7EE658252D0}"/>
          </ac:picMkLst>
        </pc:picChg>
        <pc:picChg chg="add del mod modCrop">
          <ac:chgData name="Thu Huyen Pham" userId="3eb787573b41f7e6" providerId="LiveId" clId="{D21008C1-1F35-4EFD-920C-00227BB11F61}" dt="2019-03-17T13:57:17.750" v="2627"/>
          <ac:picMkLst>
            <pc:docMk/>
            <pc:sldMk cId="1797404787" sldId="261"/>
            <ac:picMk id="27" creationId="{9CF07E35-B37E-494E-A7B6-B2AC40E990CC}"/>
          </ac:picMkLst>
        </pc:picChg>
        <pc:picChg chg="add del mod modCrop">
          <ac:chgData name="Thu Huyen Pham" userId="3eb787573b41f7e6" providerId="LiveId" clId="{D21008C1-1F35-4EFD-920C-00227BB11F61}" dt="2019-03-17T13:57:17.750" v="2627"/>
          <ac:picMkLst>
            <pc:docMk/>
            <pc:sldMk cId="1797404787" sldId="261"/>
            <ac:picMk id="29" creationId="{EEC25A2D-7229-4C68-BF3D-928D54113D7A}"/>
          </ac:picMkLst>
        </pc:picChg>
        <pc:picChg chg="add del mod">
          <ac:chgData name="Thu Huyen Pham" userId="3eb787573b41f7e6" providerId="LiveId" clId="{D21008C1-1F35-4EFD-920C-00227BB11F61}" dt="2019-03-17T11:22:13.341" v="2021" actId="478"/>
          <ac:picMkLst>
            <pc:docMk/>
            <pc:sldMk cId="1797404787" sldId="261"/>
            <ac:picMk id="32" creationId="{1FDE0D9D-15DE-48FB-8DDF-71C469A1A606}"/>
          </ac:picMkLst>
        </pc:picChg>
        <pc:picChg chg="add del mod">
          <ac:chgData name="Thu Huyen Pham" userId="3eb787573b41f7e6" providerId="LiveId" clId="{D21008C1-1F35-4EFD-920C-00227BB11F61}" dt="2019-03-16T05:33:02.451" v="800"/>
          <ac:picMkLst>
            <pc:docMk/>
            <pc:sldMk cId="1797404787" sldId="261"/>
            <ac:picMk id="34" creationId="{5D011FFA-CE25-4206-AB5F-8C4B55D76222}"/>
          </ac:picMkLst>
        </pc:picChg>
        <pc:picChg chg="add del mod">
          <ac:chgData name="Thu Huyen Pham" userId="3eb787573b41f7e6" providerId="LiveId" clId="{D21008C1-1F35-4EFD-920C-00227BB11F61}" dt="2019-03-16T07:11:50.017" v="1246" actId="478"/>
          <ac:picMkLst>
            <pc:docMk/>
            <pc:sldMk cId="1797404787" sldId="261"/>
            <ac:picMk id="35" creationId="{1701D75C-24E0-4AEF-BB23-206F1085B39A}"/>
          </ac:picMkLst>
        </pc:picChg>
        <pc:picChg chg="add del mod">
          <ac:chgData name="Thu Huyen Pham" userId="3eb787573b41f7e6" providerId="LiveId" clId="{D21008C1-1F35-4EFD-920C-00227BB11F61}" dt="2019-03-17T13:57:17.750" v="2627"/>
          <ac:picMkLst>
            <pc:docMk/>
            <pc:sldMk cId="1797404787" sldId="261"/>
            <ac:picMk id="36" creationId="{C0E7B081-81ED-43EC-93AD-4BA75780B26D}"/>
          </ac:picMkLst>
        </pc:picChg>
        <pc:picChg chg="add del mod modCrop">
          <ac:chgData name="Thu Huyen Pham" userId="3eb787573b41f7e6" providerId="LiveId" clId="{D21008C1-1F35-4EFD-920C-00227BB11F61}" dt="2019-03-17T13:56:59.959" v="2621" actId="478"/>
          <ac:picMkLst>
            <pc:docMk/>
            <pc:sldMk cId="1797404787" sldId="261"/>
            <ac:picMk id="37" creationId="{15CD3769-A9A7-4E94-8284-2F146394D265}"/>
          </ac:picMkLst>
        </pc:picChg>
        <pc:picChg chg="add del mod ord">
          <ac:chgData name="Thu Huyen Pham" userId="3eb787573b41f7e6" providerId="LiveId" clId="{D21008C1-1F35-4EFD-920C-00227BB11F61}" dt="2019-03-17T11:10:29.533" v="1988"/>
          <ac:picMkLst>
            <pc:docMk/>
            <pc:sldMk cId="1797404787" sldId="261"/>
            <ac:picMk id="40" creationId="{FD759122-547D-47E8-A9AE-83DF16BE6417}"/>
          </ac:picMkLst>
        </pc:picChg>
        <pc:picChg chg="add del mod">
          <ac:chgData name="Thu Huyen Pham" userId="3eb787573b41f7e6" providerId="LiveId" clId="{D21008C1-1F35-4EFD-920C-00227BB11F61}" dt="2019-03-17T11:10:27.095" v="1983"/>
          <ac:picMkLst>
            <pc:docMk/>
            <pc:sldMk cId="1797404787" sldId="261"/>
            <ac:picMk id="42" creationId="{B2C0F483-9C4E-4042-A3AB-08DB2E9EE119}"/>
          </ac:picMkLst>
        </pc:picChg>
        <pc:picChg chg="add mod ord">
          <ac:chgData name="Thu Huyen Pham" userId="3eb787573b41f7e6" providerId="LiveId" clId="{D21008C1-1F35-4EFD-920C-00227BB11F61}" dt="2019-03-17T14:02:43.723" v="2694" actId="1036"/>
          <ac:picMkLst>
            <pc:docMk/>
            <pc:sldMk cId="1797404787" sldId="261"/>
            <ac:picMk id="44" creationId="{C4CD26DF-EA80-404E-AB74-AA4AFCA627FF}"/>
          </ac:picMkLst>
        </pc:picChg>
        <pc:picChg chg="add mod ord">
          <ac:chgData name="Thu Huyen Pham" userId="3eb787573b41f7e6" providerId="LiveId" clId="{D21008C1-1F35-4EFD-920C-00227BB11F61}" dt="2019-03-17T14:02:43.723" v="2694" actId="1036"/>
          <ac:picMkLst>
            <pc:docMk/>
            <pc:sldMk cId="1797404787" sldId="261"/>
            <ac:picMk id="46" creationId="{4024E091-EF14-4869-91B1-E75E2783D9D1}"/>
          </ac:picMkLst>
        </pc:picChg>
        <pc:picChg chg="add mod ord">
          <ac:chgData name="Thu Huyen Pham" userId="3eb787573b41f7e6" providerId="LiveId" clId="{D21008C1-1F35-4EFD-920C-00227BB11F61}" dt="2019-03-17T14:02:30.390" v="2684" actId="1076"/>
          <ac:picMkLst>
            <pc:docMk/>
            <pc:sldMk cId="1797404787" sldId="261"/>
            <ac:picMk id="48" creationId="{E23EA123-753F-468B-A83F-E6EF03140CC4}"/>
          </ac:picMkLst>
        </pc:picChg>
        <pc:picChg chg="add mod ord">
          <ac:chgData name="Thu Huyen Pham" userId="3eb787573b41f7e6" providerId="LiveId" clId="{D21008C1-1F35-4EFD-920C-00227BB11F61}" dt="2019-03-18T00:47:53.332" v="3132"/>
          <ac:picMkLst>
            <pc:docMk/>
            <pc:sldMk cId="1797404787" sldId="261"/>
            <ac:picMk id="50" creationId="{ED2D0420-30AE-4FC1-8668-D1805EDF8302}"/>
          </ac:picMkLst>
        </pc:picChg>
        <pc:picChg chg="add del mod modCrop">
          <ac:chgData name="Thu Huyen Pham" userId="3eb787573b41f7e6" providerId="LiveId" clId="{D21008C1-1F35-4EFD-920C-00227BB11F61}" dt="2019-03-17T14:00:39.155" v="2658" actId="478"/>
          <ac:picMkLst>
            <pc:docMk/>
            <pc:sldMk cId="1797404787" sldId="261"/>
            <ac:picMk id="52" creationId="{F70440CC-C18A-4FB4-B2A1-06B4779604BD}"/>
          </ac:picMkLst>
        </pc:picChg>
        <pc:cxnChg chg="add mod">
          <ac:chgData name="Thu Huyen Pham" userId="3eb787573b41f7e6" providerId="LiveId" clId="{D21008C1-1F35-4EFD-920C-00227BB11F61}" dt="2019-03-17T14:00:02.456" v="2650" actId="1076"/>
          <ac:cxnSpMkLst>
            <pc:docMk/>
            <pc:sldMk cId="1797404787" sldId="261"/>
            <ac:cxnSpMk id="5" creationId="{09F2B510-ECDA-43B8-A93C-2C00192B102E}"/>
          </ac:cxnSpMkLst>
        </pc:cxnChg>
        <pc:cxnChg chg="add mod">
          <ac:chgData name="Thu Huyen Pham" userId="3eb787573b41f7e6" providerId="LiveId" clId="{D21008C1-1F35-4EFD-920C-00227BB11F61}" dt="2019-03-17T14:00:02.456" v="2650" actId="1076"/>
          <ac:cxnSpMkLst>
            <pc:docMk/>
            <pc:sldMk cId="1797404787" sldId="261"/>
            <ac:cxnSpMk id="8" creationId="{064E84BD-FE4D-47AF-8F24-BBFF8BB28A36}"/>
          </ac:cxnSpMkLst>
        </pc:cxnChg>
        <pc:cxnChg chg="add mod">
          <ac:chgData name="Thu Huyen Pham" userId="3eb787573b41f7e6" providerId="LiveId" clId="{D21008C1-1F35-4EFD-920C-00227BB11F61}" dt="2019-03-17T14:00:02.456" v="2650" actId="1076"/>
          <ac:cxnSpMkLst>
            <pc:docMk/>
            <pc:sldMk cId="1797404787" sldId="261"/>
            <ac:cxnSpMk id="14" creationId="{397249F2-CC1A-4D1B-8EAA-7EB92340E130}"/>
          </ac:cxnSpMkLst>
        </pc:cxnChg>
        <pc:cxnChg chg="add mod">
          <ac:chgData name="Thu Huyen Pham" userId="3eb787573b41f7e6" providerId="LiveId" clId="{D21008C1-1F35-4EFD-920C-00227BB11F61}" dt="2019-03-17T14:00:02.456" v="2650" actId="1076"/>
          <ac:cxnSpMkLst>
            <pc:docMk/>
            <pc:sldMk cId="1797404787" sldId="261"/>
            <ac:cxnSpMk id="16" creationId="{FD25AD03-49B3-4257-8179-9FE9A65756D7}"/>
          </ac:cxnSpMkLst>
        </pc:cxnChg>
      </pc:sldChg>
      <pc:sldChg chg="addSp delSp modSp add">
        <pc:chgData name="Thu Huyen Pham" userId="3eb787573b41f7e6" providerId="LiveId" clId="{D21008C1-1F35-4EFD-920C-00227BB11F61}" dt="2019-03-17T14:49:13.929" v="3114" actId="1076"/>
        <pc:sldMkLst>
          <pc:docMk/>
          <pc:sldMk cId="4140991045" sldId="262"/>
        </pc:sldMkLst>
        <pc:spChg chg="del">
          <ac:chgData name="Thu Huyen Pham" userId="3eb787573b41f7e6" providerId="LiveId" clId="{D21008C1-1F35-4EFD-920C-00227BB11F61}" dt="2019-03-16T01:36:20.963" v="36" actId="478"/>
          <ac:spMkLst>
            <pc:docMk/>
            <pc:sldMk cId="4140991045" sldId="262"/>
            <ac:spMk id="2" creationId="{56C086E7-CEB8-4173-85F4-BDEE836BB34D}"/>
          </ac:spMkLst>
        </pc:spChg>
        <pc:spChg chg="del">
          <ac:chgData name="Thu Huyen Pham" userId="3eb787573b41f7e6" providerId="LiveId" clId="{D21008C1-1F35-4EFD-920C-00227BB11F61}" dt="2019-03-16T01:36:22.377" v="37" actId="478"/>
          <ac:spMkLst>
            <pc:docMk/>
            <pc:sldMk cId="4140991045" sldId="262"/>
            <ac:spMk id="3" creationId="{0FAA455C-FDD3-49EA-95A3-C714979F033D}"/>
          </ac:spMkLst>
        </pc:spChg>
        <pc:spChg chg="add mod">
          <ac:chgData name="Thu Huyen Pham" userId="3eb787573b41f7e6" providerId="LiveId" clId="{D21008C1-1F35-4EFD-920C-00227BB11F61}" dt="2019-03-17T14:48:41.811" v="3107" actId="1076"/>
          <ac:spMkLst>
            <pc:docMk/>
            <pc:sldMk cId="4140991045" sldId="262"/>
            <ac:spMk id="5" creationId="{EEB8E258-8873-4A09-AEF1-9A8C75B8C0B8}"/>
          </ac:spMkLst>
        </pc:spChg>
        <pc:spChg chg="add mod">
          <ac:chgData name="Thu Huyen Pham" userId="3eb787573b41f7e6" providerId="LiveId" clId="{D21008C1-1F35-4EFD-920C-00227BB11F61}" dt="2019-03-17T14:48:41.811" v="3107" actId="1076"/>
          <ac:spMkLst>
            <pc:docMk/>
            <pc:sldMk cId="4140991045" sldId="262"/>
            <ac:spMk id="6" creationId="{80C02B1B-6AE1-4A27-BEB6-3F116518CBCF}"/>
          </ac:spMkLst>
        </pc:spChg>
        <pc:spChg chg="add mod">
          <ac:chgData name="Thu Huyen Pham" userId="3eb787573b41f7e6" providerId="LiveId" clId="{D21008C1-1F35-4EFD-920C-00227BB11F61}" dt="2019-03-17T14:48:41.811" v="3107" actId="1076"/>
          <ac:spMkLst>
            <pc:docMk/>
            <pc:sldMk cId="4140991045" sldId="262"/>
            <ac:spMk id="7" creationId="{FB1E9E02-8C4A-42C2-957F-EEC87AFF1D10}"/>
          </ac:spMkLst>
        </pc:spChg>
        <pc:spChg chg="add mod">
          <ac:chgData name="Thu Huyen Pham" userId="3eb787573b41f7e6" providerId="LiveId" clId="{D21008C1-1F35-4EFD-920C-00227BB11F61}" dt="2019-03-17T14:48:41.811" v="3107" actId="1076"/>
          <ac:spMkLst>
            <pc:docMk/>
            <pc:sldMk cId="4140991045" sldId="262"/>
            <ac:spMk id="8" creationId="{331772E1-479A-451E-82FB-5E8A09A16C1C}"/>
          </ac:spMkLst>
        </pc:spChg>
        <pc:spChg chg="add mod">
          <ac:chgData name="Thu Huyen Pham" userId="3eb787573b41f7e6" providerId="LiveId" clId="{D21008C1-1F35-4EFD-920C-00227BB11F61}" dt="2019-03-17T14:49:13.929" v="3114" actId="1076"/>
          <ac:spMkLst>
            <pc:docMk/>
            <pc:sldMk cId="4140991045" sldId="262"/>
            <ac:spMk id="9" creationId="{31077112-1939-4B7E-ADD7-A81B5E496E95}"/>
          </ac:spMkLst>
        </pc:spChg>
        <pc:spChg chg="add mod">
          <ac:chgData name="Thu Huyen Pham" userId="3eb787573b41f7e6" providerId="LiveId" clId="{D21008C1-1F35-4EFD-920C-00227BB11F61}" dt="2019-03-17T14:48:41.811" v="3107" actId="1076"/>
          <ac:spMkLst>
            <pc:docMk/>
            <pc:sldMk cId="4140991045" sldId="262"/>
            <ac:spMk id="13" creationId="{A3D19856-CD9B-44C0-A4A5-66AB7EAAFE53}"/>
          </ac:spMkLst>
        </pc:spChg>
        <pc:spChg chg="add mod">
          <ac:chgData name="Thu Huyen Pham" userId="3eb787573b41f7e6" providerId="LiveId" clId="{D21008C1-1F35-4EFD-920C-00227BB11F61}" dt="2019-03-17T14:48:41.811" v="3107" actId="1076"/>
          <ac:spMkLst>
            <pc:docMk/>
            <pc:sldMk cId="4140991045" sldId="262"/>
            <ac:spMk id="14" creationId="{BE592B2E-A899-48AB-A43C-9CD7023EF816}"/>
          </ac:spMkLst>
        </pc:spChg>
        <pc:spChg chg="add mod">
          <ac:chgData name="Thu Huyen Pham" userId="3eb787573b41f7e6" providerId="LiveId" clId="{D21008C1-1F35-4EFD-920C-00227BB11F61}" dt="2019-03-17T14:49:13.929" v="3114" actId="1076"/>
          <ac:spMkLst>
            <pc:docMk/>
            <pc:sldMk cId="4140991045" sldId="262"/>
            <ac:spMk id="17" creationId="{82DE2D7E-AC7C-43B6-AA2A-925D14E785EA}"/>
          </ac:spMkLst>
        </pc:spChg>
        <pc:spChg chg="add mod">
          <ac:chgData name="Thu Huyen Pham" userId="3eb787573b41f7e6" providerId="LiveId" clId="{D21008C1-1F35-4EFD-920C-00227BB11F61}" dt="2019-03-17T14:49:13.929" v="3114" actId="1076"/>
          <ac:spMkLst>
            <pc:docMk/>
            <pc:sldMk cId="4140991045" sldId="262"/>
            <ac:spMk id="18" creationId="{F147E130-D6E6-4EBD-B632-94F7E395D358}"/>
          </ac:spMkLst>
        </pc:spChg>
        <pc:spChg chg="add mod">
          <ac:chgData name="Thu Huyen Pham" userId="3eb787573b41f7e6" providerId="LiveId" clId="{D21008C1-1F35-4EFD-920C-00227BB11F61}" dt="2019-03-17T14:49:13.929" v="3114" actId="1076"/>
          <ac:spMkLst>
            <pc:docMk/>
            <pc:sldMk cId="4140991045" sldId="262"/>
            <ac:spMk id="20" creationId="{46B87037-F12E-411A-92E1-454321275B66}"/>
          </ac:spMkLst>
        </pc:spChg>
        <pc:spChg chg="add mod">
          <ac:chgData name="Thu Huyen Pham" userId="3eb787573b41f7e6" providerId="LiveId" clId="{D21008C1-1F35-4EFD-920C-00227BB11F61}" dt="2019-03-17T14:49:13.929" v="3114" actId="1076"/>
          <ac:spMkLst>
            <pc:docMk/>
            <pc:sldMk cId="4140991045" sldId="262"/>
            <ac:spMk id="21" creationId="{B0159282-8BCC-4CF6-AD12-F797D6745DF3}"/>
          </ac:spMkLst>
        </pc:spChg>
        <pc:spChg chg="add mod">
          <ac:chgData name="Thu Huyen Pham" userId="3eb787573b41f7e6" providerId="LiveId" clId="{D21008C1-1F35-4EFD-920C-00227BB11F61}" dt="2019-03-17T14:48:41.811" v="3107" actId="1076"/>
          <ac:spMkLst>
            <pc:docMk/>
            <pc:sldMk cId="4140991045" sldId="262"/>
            <ac:spMk id="28" creationId="{DAB2D1BA-AC0C-47D7-BC72-E2F8D74C4BE5}"/>
          </ac:spMkLst>
        </pc:spChg>
        <pc:spChg chg="add mod">
          <ac:chgData name="Thu Huyen Pham" userId="3eb787573b41f7e6" providerId="LiveId" clId="{D21008C1-1F35-4EFD-920C-00227BB11F61}" dt="2019-03-17T14:48:41.811" v="3107" actId="1076"/>
          <ac:spMkLst>
            <pc:docMk/>
            <pc:sldMk cId="4140991045" sldId="262"/>
            <ac:spMk id="29" creationId="{D8371686-7F2E-4124-80B9-B0322AE3DB56}"/>
          </ac:spMkLst>
        </pc:spChg>
        <pc:spChg chg="add mod">
          <ac:chgData name="Thu Huyen Pham" userId="3eb787573b41f7e6" providerId="LiveId" clId="{D21008C1-1F35-4EFD-920C-00227BB11F61}" dt="2019-03-17T14:48:41.811" v="3107" actId="1076"/>
          <ac:spMkLst>
            <pc:docMk/>
            <pc:sldMk cId="4140991045" sldId="262"/>
            <ac:spMk id="30" creationId="{16E43859-4B7C-4564-864E-BE56EB8FFD64}"/>
          </ac:spMkLst>
        </pc:spChg>
        <pc:spChg chg="add mod">
          <ac:chgData name="Thu Huyen Pham" userId="3eb787573b41f7e6" providerId="LiveId" clId="{D21008C1-1F35-4EFD-920C-00227BB11F61}" dt="2019-03-17T14:49:13.929" v="3114" actId="1076"/>
          <ac:spMkLst>
            <pc:docMk/>
            <pc:sldMk cId="4140991045" sldId="262"/>
            <ac:spMk id="31" creationId="{B007EDFE-8716-4EDC-8414-6F56A79F26C3}"/>
          </ac:spMkLst>
        </pc:spChg>
        <pc:spChg chg="add mod">
          <ac:chgData name="Thu Huyen Pham" userId="3eb787573b41f7e6" providerId="LiveId" clId="{D21008C1-1F35-4EFD-920C-00227BB11F61}" dt="2019-03-17T14:49:13.929" v="3114" actId="1076"/>
          <ac:spMkLst>
            <pc:docMk/>
            <pc:sldMk cId="4140991045" sldId="262"/>
            <ac:spMk id="32" creationId="{5C41F25D-7BC0-48BD-AE74-7FF7EEF8D4C3}"/>
          </ac:spMkLst>
        </pc:spChg>
        <pc:spChg chg="add mod">
          <ac:chgData name="Thu Huyen Pham" userId="3eb787573b41f7e6" providerId="LiveId" clId="{D21008C1-1F35-4EFD-920C-00227BB11F61}" dt="2019-03-17T14:49:13.929" v="3114" actId="1076"/>
          <ac:spMkLst>
            <pc:docMk/>
            <pc:sldMk cId="4140991045" sldId="262"/>
            <ac:spMk id="33" creationId="{6122F34A-733F-42DC-B506-2531801375BA}"/>
          </ac:spMkLst>
        </pc:spChg>
        <pc:spChg chg="add mod">
          <ac:chgData name="Thu Huyen Pham" userId="3eb787573b41f7e6" providerId="LiveId" clId="{D21008C1-1F35-4EFD-920C-00227BB11F61}" dt="2019-03-17T14:49:13.929" v="3114" actId="1076"/>
          <ac:spMkLst>
            <pc:docMk/>
            <pc:sldMk cId="4140991045" sldId="262"/>
            <ac:spMk id="34" creationId="{974F2B18-0F92-4B88-AA02-A368D3FDA797}"/>
          </ac:spMkLst>
        </pc:spChg>
        <pc:spChg chg="add del mod">
          <ac:chgData name="Thu Huyen Pham" userId="3eb787573b41f7e6" providerId="LiveId" clId="{D21008C1-1F35-4EFD-920C-00227BB11F61}" dt="2019-03-17T14:48:04.994" v="3100" actId="478"/>
          <ac:spMkLst>
            <pc:docMk/>
            <pc:sldMk cId="4140991045" sldId="262"/>
            <ac:spMk id="36" creationId="{64911065-0B31-49A1-8DA6-6689AEBC2EF2}"/>
          </ac:spMkLst>
        </pc:spChg>
        <pc:spChg chg="add mod">
          <ac:chgData name="Thu Huyen Pham" userId="3eb787573b41f7e6" providerId="LiveId" clId="{D21008C1-1F35-4EFD-920C-00227BB11F61}" dt="2019-03-17T14:49:13.929" v="3114" actId="1076"/>
          <ac:spMkLst>
            <pc:docMk/>
            <pc:sldMk cId="4140991045" sldId="262"/>
            <ac:spMk id="56" creationId="{DBF3C0D6-7A77-436F-8097-42D6D687F659}"/>
          </ac:spMkLst>
        </pc:spChg>
        <pc:spChg chg="add mod">
          <ac:chgData name="Thu Huyen Pham" userId="3eb787573b41f7e6" providerId="LiveId" clId="{D21008C1-1F35-4EFD-920C-00227BB11F61}" dt="2019-03-17T14:49:13.929" v="3114" actId="1076"/>
          <ac:spMkLst>
            <pc:docMk/>
            <pc:sldMk cId="4140991045" sldId="262"/>
            <ac:spMk id="57" creationId="{3E728245-FD16-4596-B9DA-FE0208D39EF7}"/>
          </ac:spMkLst>
        </pc:spChg>
        <pc:spChg chg="add mod ord">
          <ac:chgData name="Thu Huyen Pham" userId="3eb787573b41f7e6" providerId="LiveId" clId="{D21008C1-1F35-4EFD-920C-00227BB11F61}" dt="2019-03-17T14:49:13.929" v="3114" actId="1076"/>
          <ac:spMkLst>
            <pc:docMk/>
            <pc:sldMk cId="4140991045" sldId="262"/>
            <ac:spMk id="58" creationId="{CF47DF40-BA04-4DDF-B181-ACB5F9AE9561}"/>
          </ac:spMkLst>
        </pc:spChg>
        <pc:spChg chg="add mod">
          <ac:chgData name="Thu Huyen Pham" userId="3eb787573b41f7e6" providerId="LiveId" clId="{D21008C1-1F35-4EFD-920C-00227BB11F61}" dt="2019-03-17T14:48:41.811" v="3107" actId="1076"/>
          <ac:spMkLst>
            <pc:docMk/>
            <pc:sldMk cId="4140991045" sldId="262"/>
            <ac:spMk id="59" creationId="{EA10E884-8310-46C2-9E45-10BED2101F24}"/>
          </ac:spMkLst>
        </pc:spChg>
        <pc:spChg chg="add mod">
          <ac:chgData name="Thu Huyen Pham" userId="3eb787573b41f7e6" providerId="LiveId" clId="{D21008C1-1F35-4EFD-920C-00227BB11F61}" dt="2019-03-17T14:48:41.811" v="3107" actId="1076"/>
          <ac:spMkLst>
            <pc:docMk/>
            <pc:sldMk cId="4140991045" sldId="262"/>
            <ac:spMk id="60" creationId="{695368FB-F9B8-4603-9620-E42D6002BF1D}"/>
          </ac:spMkLst>
        </pc:spChg>
        <pc:spChg chg="add mod">
          <ac:chgData name="Thu Huyen Pham" userId="3eb787573b41f7e6" providerId="LiveId" clId="{D21008C1-1F35-4EFD-920C-00227BB11F61}" dt="2019-03-17T14:48:41.811" v="3107" actId="1076"/>
          <ac:spMkLst>
            <pc:docMk/>
            <pc:sldMk cId="4140991045" sldId="262"/>
            <ac:spMk id="61" creationId="{A5061A81-1A1D-41A1-8697-920B97717DC5}"/>
          </ac:spMkLst>
        </pc:spChg>
        <pc:spChg chg="add mod">
          <ac:chgData name="Thu Huyen Pham" userId="3eb787573b41f7e6" providerId="LiveId" clId="{D21008C1-1F35-4EFD-920C-00227BB11F61}" dt="2019-03-17T14:48:41.811" v="3107" actId="1076"/>
          <ac:spMkLst>
            <pc:docMk/>
            <pc:sldMk cId="4140991045" sldId="262"/>
            <ac:spMk id="62" creationId="{77A07EE9-935E-432B-A1ED-CD47FF71A9C2}"/>
          </ac:spMkLst>
        </pc:spChg>
        <pc:spChg chg="add mod">
          <ac:chgData name="Thu Huyen Pham" userId="3eb787573b41f7e6" providerId="LiveId" clId="{D21008C1-1F35-4EFD-920C-00227BB11F61}" dt="2019-03-17T12:47:58.350" v="2323" actId="20577"/>
          <ac:spMkLst>
            <pc:docMk/>
            <pc:sldMk cId="4140991045" sldId="262"/>
            <ac:spMk id="64" creationId="{6D7A10B6-428F-4A1F-955B-8B0EA3419C45}"/>
          </ac:spMkLst>
        </pc:spChg>
        <pc:spChg chg="add mod">
          <ac:chgData name="Thu Huyen Pham" userId="3eb787573b41f7e6" providerId="LiveId" clId="{D21008C1-1F35-4EFD-920C-00227BB11F61}" dt="2019-03-17T14:49:13.929" v="3114" actId="1076"/>
          <ac:spMkLst>
            <pc:docMk/>
            <pc:sldMk cId="4140991045" sldId="262"/>
            <ac:spMk id="67" creationId="{16578F91-1FCC-4022-B598-372CAC720265}"/>
          </ac:spMkLst>
        </pc:spChg>
        <pc:picChg chg="add del mod">
          <ac:chgData name="Thu Huyen Pham" userId="3eb787573b41f7e6" providerId="LiveId" clId="{D21008C1-1F35-4EFD-920C-00227BB11F61}" dt="2019-03-17T14:13:51.772" v="2730" actId="478"/>
          <ac:picMkLst>
            <pc:docMk/>
            <pc:sldMk cId="4140991045" sldId="262"/>
            <ac:picMk id="4" creationId="{EC16232D-B0C1-4795-A101-4A328685D64F}"/>
          </ac:picMkLst>
        </pc:picChg>
        <pc:picChg chg="add del mod modCrop">
          <ac:chgData name="Thu Huyen Pham" userId="3eb787573b41f7e6" providerId="LiveId" clId="{D21008C1-1F35-4EFD-920C-00227BB11F61}" dt="2019-03-17T14:10:33.922" v="2723" actId="478"/>
          <ac:picMkLst>
            <pc:docMk/>
            <pc:sldMk cId="4140991045" sldId="262"/>
            <ac:picMk id="11" creationId="{E50B130B-857E-461E-B129-2B87DC3B7D48}"/>
          </ac:picMkLst>
        </pc:picChg>
        <pc:picChg chg="add del mod">
          <ac:chgData name="Thu Huyen Pham" userId="3eb787573b41f7e6" providerId="LiveId" clId="{D21008C1-1F35-4EFD-920C-00227BB11F61}" dt="2019-03-17T14:47:53.510" v="3097" actId="478"/>
          <ac:picMkLst>
            <pc:docMk/>
            <pc:sldMk cId="4140991045" sldId="262"/>
            <ac:picMk id="12" creationId="{1117383E-9F9C-45DF-9A7B-9D802A35D161}"/>
          </ac:picMkLst>
        </pc:picChg>
        <pc:picChg chg="add del mod">
          <ac:chgData name="Thu Huyen Pham" userId="3eb787573b41f7e6" providerId="LiveId" clId="{D21008C1-1F35-4EFD-920C-00227BB11F61}" dt="2019-03-17T14:47:53.510" v="3097" actId="478"/>
          <ac:picMkLst>
            <pc:docMk/>
            <pc:sldMk cId="4140991045" sldId="262"/>
            <ac:picMk id="15" creationId="{D72D7F5D-2A81-416C-81DB-F163A734E17B}"/>
          </ac:picMkLst>
        </pc:picChg>
        <pc:picChg chg="add del mod">
          <ac:chgData name="Thu Huyen Pham" userId="3eb787573b41f7e6" providerId="LiveId" clId="{D21008C1-1F35-4EFD-920C-00227BB11F61}" dt="2019-03-17T14:47:53.510" v="3097" actId="478"/>
          <ac:picMkLst>
            <pc:docMk/>
            <pc:sldMk cId="4140991045" sldId="262"/>
            <ac:picMk id="25" creationId="{F3F0BD77-6A9D-4C6B-8FFC-AF9676DC0D15}"/>
          </ac:picMkLst>
        </pc:picChg>
        <pc:picChg chg="add del mod">
          <ac:chgData name="Thu Huyen Pham" userId="3eb787573b41f7e6" providerId="LiveId" clId="{D21008C1-1F35-4EFD-920C-00227BB11F61}" dt="2019-03-17T14:47:53.510" v="3097" actId="478"/>
          <ac:picMkLst>
            <pc:docMk/>
            <pc:sldMk cId="4140991045" sldId="262"/>
            <ac:picMk id="26" creationId="{C93F286C-FDE5-4847-883C-7ACC290F75C6}"/>
          </ac:picMkLst>
        </pc:picChg>
        <pc:picChg chg="add del mod">
          <ac:chgData name="Thu Huyen Pham" userId="3eb787573b41f7e6" providerId="LiveId" clId="{D21008C1-1F35-4EFD-920C-00227BB11F61}" dt="2019-03-17T11:53:28.104" v="2113"/>
          <ac:picMkLst>
            <pc:docMk/>
            <pc:sldMk cId="4140991045" sldId="262"/>
            <ac:picMk id="27" creationId="{9FA8A9F2-A305-4961-B0DE-072347E14D73}"/>
          </ac:picMkLst>
        </pc:picChg>
        <pc:picChg chg="add del mod modCrop">
          <ac:chgData name="Thu Huyen Pham" userId="3eb787573b41f7e6" providerId="LiveId" clId="{D21008C1-1F35-4EFD-920C-00227BB11F61}" dt="2019-03-17T14:14:09.424" v="2737"/>
          <ac:picMkLst>
            <pc:docMk/>
            <pc:sldMk cId="4140991045" sldId="262"/>
            <ac:picMk id="35" creationId="{C14A40E9-8848-41B1-9725-E88F12F02649}"/>
          </ac:picMkLst>
        </pc:picChg>
        <pc:picChg chg="add del mod modCrop">
          <ac:chgData name="Thu Huyen Pham" userId="3eb787573b41f7e6" providerId="LiveId" clId="{D21008C1-1F35-4EFD-920C-00227BB11F61}" dt="2019-03-17T14:40:10.819" v="3005"/>
          <ac:picMkLst>
            <pc:docMk/>
            <pc:sldMk cId="4140991045" sldId="262"/>
            <ac:picMk id="37" creationId="{0E086481-58FA-4C91-A3CB-256DF35B961A}"/>
          </ac:picMkLst>
        </pc:picChg>
        <pc:picChg chg="add del mod modCrop">
          <ac:chgData name="Thu Huyen Pham" userId="3eb787573b41f7e6" providerId="LiveId" clId="{D21008C1-1F35-4EFD-920C-00227BB11F61}" dt="2019-03-17T14:14:09.424" v="2737"/>
          <ac:picMkLst>
            <pc:docMk/>
            <pc:sldMk cId="4140991045" sldId="262"/>
            <ac:picMk id="38" creationId="{DDD3D8F5-D5B4-4DA5-A4CC-91488173ABEC}"/>
          </ac:picMkLst>
        </pc:picChg>
        <pc:picChg chg="add del mod modCrop">
          <ac:chgData name="Thu Huyen Pham" userId="3eb787573b41f7e6" providerId="LiveId" clId="{D21008C1-1F35-4EFD-920C-00227BB11F61}" dt="2019-03-17T14:40:10.819" v="3005"/>
          <ac:picMkLst>
            <pc:docMk/>
            <pc:sldMk cId="4140991045" sldId="262"/>
            <ac:picMk id="39" creationId="{A2D5802C-9283-48CD-A9B5-550EAC88F209}"/>
          </ac:picMkLst>
        </pc:picChg>
        <pc:picChg chg="add del mod modCrop">
          <ac:chgData name="Thu Huyen Pham" userId="3eb787573b41f7e6" providerId="LiveId" clId="{D21008C1-1F35-4EFD-920C-00227BB11F61}" dt="2019-03-17T14:14:09.424" v="2737"/>
          <ac:picMkLst>
            <pc:docMk/>
            <pc:sldMk cId="4140991045" sldId="262"/>
            <ac:picMk id="40" creationId="{EEB743DC-D71E-4D0D-BBC0-6F059A1A9D4A}"/>
          </ac:picMkLst>
        </pc:picChg>
        <pc:picChg chg="add del mod modCrop">
          <ac:chgData name="Thu Huyen Pham" userId="3eb787573b41f7e6" providerId="LiveId" clId="{D21008C1-1F35-4EFD-920C-00227BB11F61}" dt="2019-03-17T14:40:10.819" v="3005"/>
          <ac:picMkLst>
            <pc:docMk/>
            <pc:sldMk cId="4140991045" sldId="262"/>
            <ac:picMk id="41" creationId="{8CEB8107-2E6D-42C8-8F39-687A98767DEA}"/>
          </ac:picMkLst>
        </pc:picChg>
        <pc:picChg chg="add del mod modCrop">
          <ac:chgData name="Thu Huyen Pham" userId="3eb787573b41f7e6" providerId="LiveId" clId="{D21008C1-1F35-4EFD-920C-00227BB11F61}" dt="2019-03-16T06:38:28.889" v="863" actId="478"/>
          <ac:picMkLst>
            <pc:docMk/>
            <pc:sldMk cId="4140991045" sldId="262"/>
            <ac:picMk id="42" creationId="{ED6C81D0-1567-4CE4-A141-2E399731695D}"/>
          </ac:picMkLst>
        </pc:picChg>
        <pc:picChg chg="add del mod modCrop">
          <ac:chgData name="Thu Huyen Pham" userId="3eb787573b41f7e6" providerId="LiveId" clId="{D21008C1-1F35-4EFD-920C-00227BB11F61}" dt="2019-03-17T14:14:00.468" v="2734" actId="478"/>
          <ac:picMkLst>
            <pc:docMk/>
            <pc:sldMk cId="4140991045" sldId="262"/>
            <ac:picMk id="43" creationId="{D50FD82B-8BD5-446C-BD38-A353B5AF288C}"/>
          </ac:picMkLst>
        </pc:picChg>
        <pc:picChg chg="add del mod">
          <ac:chgData name="Thu Huyen Pham" userId="3eb787573b41f7e6" providerId="LiveId" clId="{D21008C1-1F35-4EFD-920C-00227BB11F61}" dt="2019-03-16T04:57:29.724" v="577"/>
          <ac:picMkLst>
            <pc:docMk/>
            <pc:sldMk cId="4140991045" sldId="262"/>
            <ac:picMk id="45" creationId="{9E381D65-6744-4369-A2CF-17869694C7F8}"/>
          </ac:picMkLst>
        </pc:picChg>
        <pc:picChg chg="add del mod modCrop">
          <ac:chgData name="Thu Huyen Pham" userId="3eb787573b41f7e6" providerId="LiveId" clId="{D21008C1-1F35-4EFD-920C-00227BB11F61}" dt="2019-03-17T14:40:10.819" v="3005"/>
          <ac:picMkLst>
            <pc:docMk/>
            <pc:sldMk cId="4140991045" sldId="262"/>
            <ac:picMk id="47" creationId="{8E9D9FCB-011D-4CE4-83F3-348D9F748E5B}"/>
          </ac:picMkLst>
        </pc:picChg>
        <pc:picChg chg="add del mod">
          <ac:chgData name="Thu Huyen Pham" userId="3eb787573b41f7e6" providerId="LiveId" clId="{D21008C1-1F35-4EFD-920C-00227BB11F61}" dt="2019-03-16T04:32:08.308" v="509" actId="478"/>
          <ac:picMkLst>
            <pc:docMk/>
            <pc:sldMk cId="4140991045" sldId="262"/>
            <ac:picMk id="49" creationId="{29A2B213-3FBC-4BFD-9F6F-CCA2464158E3}"/>
          </ac:picMkLst>
        </pc:picChg>
        <pc:picChg chg="add del mod modCrop">
          <ac:chgData name="Thu Huyen Pham" userId="3eb787573b41f7e6" providerId="LiveId" clId="{D21008C1-1F35-4EFD-920C-00227BB11F61}" dt="2019-03-16T04:33:51.721" v="551"/>
          <ac:picMkLst>
            <pc:docMk/>
            <pc:sldMk cId="4140991045" sldId="262"/>
            <ac:picMk id="51" creationId="{2A92E6DD-AE6E-43C8-99A8-A820D2FA4DF5}"/>
          </ac:picMkLst>
        </pc:picChg>
        <pc:picChg chg="add del mod modCrop">
          <ac:chgData name="Thu Huyen Pham" userId="3eb787573b41f7e6" providerId="LiveId" clId="{D21008C1-1F35-4EFD-920C-00227BB11F61}" dt="2019-03-17T14:40:10.819" v="3005"/>
          <ac:picMkLst>
            <pc:docMk/>
            <pc:sldMk cId="4140991045" sldId="262"/>
            <ac:picMk id="52" creationId="{A9B60D8F-C8BD-4D61-A7F4-3F113E76A5E4}"/>
          </ac:picMkLst>
        </pc:picChg>
        <pc:picChg chg="add del mod modCrop">
          <ac:chgData name="Thu Huyen Pham" userId="3eb787573b41f7e6" providerId="LiveId" clId="{D21008C1-1F35-4EFD-920C-00227BB11F61}" dt="2019-03-17T14:40:10.819" v="3005"/>
          <ac:picMkLst>
            <pc:docMk/>
            <pc:sldMk cId="4140991045" sldId="262"/>
            <ac:picMk id="53" creationId="{B960F300-5EDE-4A8C-A2B4-C80567E3DE3B}"/>
          </ac:picMkLst>
        </pc:picChg>
        <pc:picChg chg="add del mod modCrop">
          <ac:chgData name="Thu Huyen Pham" userId="3eb787573b41f7e6" providerId="LiveId" clId="{D21008C1-1F35-4EFD-920C-00227BB11F61}" dt="2019-03-17T14:47:53.510" v="3097" actId="478"/>
          <ac:picMkLst>
            <pc:docMk/>
            <pc:sldMk cId="4140991045" sldId="262"/>
            <ac:picMk id="54" creationId="{9322B3C0-A50D-4939-8D13-3A369B82FADE}"/>
          </ac:picMkLst>
        </pc:picChg>
        <pc:picChg chg="add del mod modCrop">
          <ac:chgData name="Thu Huyen Pham" userId="3eb787573b41f7e6" providerId="LiveId" clId="{D21008C1-1F35-4EFD-920C-00227BB11F61}" dt="2019-03-17T14:47:53.510" v="3097" actId="478"/>
          <ac:picMkLst>
            <pc:docMk/>
            <pc:sldMk cId="4140991045" sldId="262"/>
            <ac:picMk id="55" creationId="{26FE8831-31FE-44C0-BE6D-A7CB53C24832}"/>
          </ac:picMkLst>
        </pc:picChg>
        <pc:picChg chg="add del mod modCrop">
          <ac:chgData name="Thu Huyen Pham" userId="3eb787573b41f7e6" providerId="LiveId" clId="{D21008C1-1F35-4EFD-920C-00227BB11F61}" dt="2019-03-17T14:06:10.090" v="2696" actId="478"/>
          <ac:picMkLst>
            <pc:docMk/>
            <pc:sldMk cId="4140991045" sldId="262"/>
            <ac:picMk id="63" creationId="{F2E892F5-4387-4333-A4E9-690EE3794D55}"/>
          </ac:picMkLst>
        </pc:picChg>
        <pc:picChg chg="add del mod modCrop">
          <ac:chgData name="Thu Huyen Pham" userId="3eb787573b41f7e6" providerId="LiveId" clId="{D21008C1-1F35-4EFD-920C-00227BB11F61}" dt="2019-03-17T14:47:53.510" v="3097" actId="478"/>
          <ac:picMkLst>
            <pc:docMk/>
            <pc:sldMk cId="4140991045" sldId="262"/>
            <ac:picMk id="65" creationId="{36DE2517-25EE-43B9-8DC6-EF8907C2D2AF}"/>
          </ac:picMkLst>
        </pc:picChg>
        <pc:picChg chg="add del mod ord modCrop">
          <ac:chgData name="Thu Huyen Pham" userId="3eb787573b41f7e6" providerId="LiveId" clId="{D21008C1-1F35-4EFD-920C-00227BB11F61}" dt="2019-03-17T14:40:10.819" v="3005"/>
          <ac:picMkLst>
            <pc:docMk/>
            <pc:sldMk cId="4140991045" sldId="262"/>
            <ac:picMk id="66" creationId="{75971E6B-EC6D-4ED3-AD7C-4F5C1285754A}"/>
          </ac:picMkLst>
        </pc:picChg>
        <pc:picChg chg="add del mod modCrop">
          <ac:chgData name="Thu Huyen Pham" userId="3eb787573b41f7e6" providerId="LiveId" clId="{D21008C1-1F35-4EFD-920C-00227BB11F61}" dt="2019-03-17T14:47:53.510" v="3097" actId="478"/>
          <ac:picMkLst>
            <pc:docMk/>
            <pc:sldMk cId="4140991045" sldId="262"/>
            <ac:picMk id="68" creationId="{2918530B-DF46-4852-9B3A-33DDBF713360}"/>
          </ac:picMkLst>
        </pc:picChg>
        <pc:picChg chg="add mod ord">
          <ac:chgData name="Thu Huyen Pham" userId="3eb787573b41f7e6" providerId="LiveId" clId="{D21008C1-1F35-4EFD-920C-00227BB11F61}" dt="2019-03-17T14:48:41.811" v="3107" actId="1076"/>
          <ac:picMkLst>
            <pc:docMk/>
            <pc:sldMk cId="4140991045" sldId="262"/>
            <ac:picMk id="70" creationId="{554AF940-596D-429D-ABF3-010FE1737E63}"/>
          </ac:picMkLst>
        </pc:picChg>
        <pc:picChg chg="add del mod">
          <ac:chgData name="Thu Huyen Pham" userId="3eb787573b41f7e6" providerId="LiveId" clId="{D21008C1-1F35-4EFD-920C-00227BB11F61}" dt="2019-03-17T14:43:46.699" v="3062" actId="478"/>
          <ac:picMkLst>
            <pc:docMk/>
            <pc:sldMk cId="4140991045" sldId="262"/>
            <ac:picMk id="72" creationId="{1E252E47-651D-4CE1-B82F-C9A6ADF9C2C8}"/>
          </ac:picMkLst>
        </pc:picChg>
        <pc:picChg chg="add mod ord">
          <ac:chgData name="Thu Huyen Pham" userId="3eb787573b41f7e6" providerId="LiveId" clId="{D21008C1-1F35-4EFD-920C-00227BB11F61}" dt="2019-03-17T14:48:41.811" v="3107" actId="1076"/>
          <ac:picMkLst>
            <pc:docMk/>
            <pc:sldMk cId="4140991045" sldId="262"/>
            <ac:picMk id="74" creationId="{17B0E1EF-0E8D-43CA-874B-912D9558746C}"/>
          </ac:picMkLst>
        </pc:picChg>
        <pc:picChg chg="add mod ord">
          <ac:chgData name="Thu Huyen Pham" userId="3eb787573b41f7e6" providerId="LiveId" clId="{D21008C1-1F35-4EFD-920C-00227BB11F61}" dt="2019-03-17T14:48:41.811" v="3107" actId="1076"/>
          <ac:picMkLst>
            <pc:docMk/>
            <pc:sldMk cId="4140991045" sldId="262"/>
            <ac:picMk id="76" creationId="{183C8EDA-0DC7-4CB6-A3E8-7FACE667E8AB}"/>
          </ac:picMkLst>
        </pc:picChg>
        <pc:picChg chg="add mod ord">
          <ac:chgData name="Thu Huyen Pham" userId="3eb787573b41f7e6" providerId="LiveId" clId="{D21008C1-1F35-4EFD-920C-00227BB11F61}" dt="2019-03-17T14:48:41.811" v="3107" actId="1076"/>
          <ac:picMkLst>
            <pc:docMk/>
            <pc:sldMk cId="4140991045" sldId="262"/>
            <ac:picMk id="78" creationId="{7D37078E-EF69-4529-B6E5-6079971AE6B9}"/>
          </ac:picMkLst>
        </pc:picChg>
        <pc:picChg chg="add mod ord">
          <ac:chgData name="Thu Huyen Pham" userId="3eb787573b41f7e6" providerId="LiveId" clId="{D21008C1-1F35-4EFD-920C-00227BB11F61}" dt="2019-03-17T14:49:13.929" v="3114" actId="1076"/>
          <ac:picMkLst>
            <pc:docMk/>
            <pc:sldMk cId="4140991045" sldId="262"/>
            <ac:picMk id="80" creationId="{90223F3E-FB29-48CA-88C7-B702AA8D9958}"/>
          </ac:picMkLst>
        </pc:picChg>
        <pc:picChg chg="add mod ord">
          <ac:chgData name="Thu Huyen Pham" userId="3eb787573b41f7e6" providerId="LiveId" clId="{D21008C1-1F35-4EFD-920C-00227BB11F61}" dt="2019-03-17T14:49:13.929" v="3114" actId="1076"/>
          <ac:picMkLst>
            <pc:docMk/>
            <pc:sldMk cId="4140991045" sldId="262"/>
            <ac:picMk id="82" creationId="{013558DF-F1AA-4591-B3D4-F084160B4F4A}"/>
          </ac:picMkLst>
        </pc:picChg>
        <pc:picChg chg="add del mod">
          <ac:chgData name="Thu Huyen Pham" userId="3eb787573b41f7e6" providerId="LiveId" clId="{D21008C1-1F35-4EFD-920C-00227BB11F61}" dt="2019-03-17T14:43:17.810" v="3056" actId="478"/>
          <ac:picMkLst>
            <pc:docMk/>
            <pc:sldMk cId="4140991045" sldId="262"/>
            <ac:picMk id="84" creationId="{C3416F40-F2F9-471A-AF0D-EE0E7F36B438}"/>
          </ac:picMkLst>
        </pc:picChg>
        <pc:picChg chg="add mod">
          <ac:chgData name="Thu Huyen Pham" userId="3eb787573b41f7e6" providerId="LiveId" clId="{D21008C1-1F35-4EFD-920C-00227BB11F61}" dt="2019-03-17T14:49:13.929" v="3114" actId="1076"/>
          <ac:picMkLst>
            <pc:docMk/>
            <pc:sldMk cId="4140991045" sldId="262"/>
            <ac:picMk id="86" creationId="{5DDF1B50-30D4-43BE-AC02-21F8C6010235}"/>
          </ac:picMkLst>
        </pc:picChg>
        <pc:cxnChg chg="add mod">
          <ac:chgData name="Thu Huyen Pham" userId="3eb787573b41f7e6" providerId="LiveId" clId="{D21008C1-1F35-4EFD-920C-00227BB11F61}" dt="2019-03-17T14:48:41.811" v="3107" actId="1076"/>
          <ac:cxnSpMkLst>
            <pc:docMk/>
            <pc:sldMk cId="4140991045" sldId="262"/>
            <ac:cxnSpMk id="10" creationId="{01D7929F-8F8B-4E7B-8E9D-4D06D67814A4}"/>
          </ac:cxnSpMkLst>
        </pc:cxnChg>
        <pc:cxnChg chg="add mod">
          <ac:chgData name="Thu Huyen Pham" userId="3eb787573b41f7e6" providerId="LiveId" clId="{D21008C1-1F35-4EFD-920C-00227BB11F61}" dt="2019-03-17T14:48:41.811" v="3107" actId="1076"/>
          <ac:cxnSpMkLst>
            <pc:docMk/>
            <pc:sldMk cId="4140991045" sldId="262"/>
            <ac:cxnSpMk id="16" creationId="{5C31BB04-635C-4181-A446-8B6F94D3DF1B}"/>
          </ac:cxnSpMkLst>
        </pc:cxnChg>
        <pc:cxnChg chg="add mod">
          <ac:chgData name="Thu Huyen Pham" userId="3eb787573b41f7e6" providerId="LiveId" clId="{D21008C1-1F35-4EFD-920C-00227BB11F61}" dt="2019-03-17T14:49:13.929" v="3114" actId="1076"/>
          <ac:cxnSpMkLst>
            <pc:docMk/>
            <pc:sldMk cId="4140991045" sldId="262"/>
            <ac:cxnSpMk id="19" creationId="{72146EE8-99B6-4B85-B8E4-227F93751B1C}"/>
          </ac:cxnSpMkLst>
        </pc:cxnChg>
        <pc:cxnChg chg="add mod">
          <ac:chgData name="Thu Huyen Pham" userId="3eb787573b41f7e6" providerId="LiveId" clId="{D21008C1-1F35-4EFD-920C-00227BB11F61}" dt="2019-03-17T14:49:13.929" v="3114" actId="1076"/>
          <ac:cxnSpMkLst>
            <pc:docMk/>
            <pc:sldMk cId="4140991045" sldId="262"/>
            <ac:cxnSpMk id="22" creationId="{ACED2BF4-78A0-45F3-807D-AC739B5120D4}"/>
          </ac:cxnSpMkLst>
        </pc:cxnChg>
        <pc:cxnChg chg="add mod">
          <ac:chgData name="Thu Huyen Pham" userId="3eb787573b41f7e6" providerId="LiveId" clId="{D21008C1-1F35-4EFD-920C-00227BB11F61}" dt="2019-03-17T14:49:13.929" v="3114" actId="1076"/>
          <ac:cxnSpMkLst>
            <pc:docMk/>
            <pc:sldMk cId="4140991045" sldId="262"/>
            <ac:cxnSpMk id="23" creationId="{32E5CDF1-C5EE-44EA-A700-1270EED3863B}"/>
          </ac:cxnSpMkLst>
        </pc:cxnChg>
        <pc:cxnChg chg="add mod">
          <ac:chgData name="Thu Huyen Pham" userId="3eb787573b41f7e6" providerId="LiveId" clId="{D21008C1-1F35-4EFD-920C-00227BB11F61}" dt="2019-03-17T14:48:41.811" v="3107" actId="1076"/>
          <ac:cxnSpMkLst>
            <pc:docMk/>
            <pc:sldMk cId="4140991045" sldId="262"/>
            <ac:cxnSpMk id="24" creationId="{1D4664C9-81B0-4BE8-B2AC-CCD9B115A414}"/>
          </ac:cxnSpMkLst>
        </pc:cxnChg>
      </pc:sldChg>
    </pc:docChg>
  </pc:docChgLst>
  <pc:docChgLst>
    <pc:chgData name="Thu Huyen Pham" userId="3eb787573b41f7e6" providerId="LiveId" clId="{D2B87A3D-0BCF-43FE-BE70-508B5C39EF1C}"/>
    <pc:docChg chg="undo custSel modSld">
      <pc:chgData name="Thu Huyen Pham" userId="3eb787573b41f7e6" providerId="LiveId" clId="{D2B87A3D-0BCF-43FE-BE70-508B5C39EF1C}" dt="2019-05-06T06:16:23.829" v="399" actId="1037"/>
      <pc:docMkLst>
        <pc:docMk/>
      </pc:docMkLst>
      <pc:sldChg chg="addSp delSp modSp">
        <pc:chgData name="Thu Huyen Pham" userId="3eb787573b41f7e6" providerId="LiveId" clId="{D2B87A3D-0BCF-43FE-BE70-508B5C39EF1C}" dt="2019-05-06T06:16:23.829" v="399" actId="1037"/>
        <pc:sldMkLst>
          <pc:docMk/>
          <pc:sldMk cId="2705666942" sldId="259"/>
        </pc:sldMkLst>
        <pc:spChg chg="mod">
          <ac:chgData name="Thu Huyen Pham" userId="3eb787573b41f7e6" providerId="LiveId" clId="{D2B87A3D-0BCF-43FE-BE70-508B5C39EF1C}" dt="2019-05-06T06:16:23.829" v="399" actId="1037"/>
          <ac:spMkLst>
            <pc:docMk/>
            <pc:sldMk cId="2705666942" sldId="259"/>
            <ac:spMk id="8" creationId="{DA5AB784-0D47-4268-A045-F33E7A57DE7C}"/>
          </ac:spMkLst>
        </pc:spChg>
        <pc:spChg chg="mod">
          <ac:chgData name="Thu Huyen Pham" userId="3eb787573b41f7e6" providerId="LiveId" clId="{D2B87A3D-0BCF-43FE-BE70-508B5C39EF1C}" dt="2019-05-06T06:16:23.829" v="399" actId="1037"/>
          <ac:spMkLst>
            <pc:docMk/>
            <pc:sldMk cId="2705666942" sldId="259"/>
            <ac:spMk id="9" creationId="{645A28B2-27AA-4EA9-99A4-B0D145003D43}"/>
          </ac:spMkLst>
        </pc:spChg>
        <pc:spChg chg="mod">
          <ac:chgData name="Thu Huyen Pham" userId="3eb787573b41f7e6" providerId="LiveId" clId="{D2B87A3D-0BCF-43FE-BE70-508B5C39EF1C}" dt="2019-05-06T06:16:23.829" v="399" actId="1037"/>
          <ac:spMkLst>
            <pc:docMk/>
            <pc:sldMk cId="2705666942" sldId="259"/>
            <ac:spMk id="10" creationId="{EC2A1826-94BD-4B16-95DF-8C7F54C4509C}"/>
          </ac:spMkLst>
        </pc:spChg>
        <pc:spChg chg="mod">
          <ac:chgData name="Thu Huyen Pham" userId="3eb787573b41f7e6" providerId="LiveId" clId="{D2B87A3D-0BCF-43FE-BE70-508B5C39EF1C}" dt="2019-05-06T06:16:23.829" v="399" actId="1037"/>
          <ac:spMkLst>
            <pc:docMk/>
            <pc:sldMk cId="2705666942" sldId="259"/>
            <ac:spMk id="16" creationId="{FDE204A6-61E4-4ABB-B646-8498BF529592}"/>
          </ac:spMkLst>
        </pc:spChg>
        <pc:spChg chg="add del mod">
          <ac:chgData name="Thu Huyen Pham" userId="3eb787573b41f7e6" providerId="LiveId" clId="{D2B87A3D-0BCF-43FE-BE70-508B5C39EF1C}" dt="2019-05-06T06:13:06.688" v="258" actId="478"/>
          <ac:spMkLst>
            <pc:docMk/>
            <pc:sldMk cId="2705666942" sldId="259"/>
            <ac:spMk id="24" creationId="{193867EB-ED1E-4F36-9FA8-32E56A73CC93}"/>
          </ac:spMkLst>
        </pc:spChg>
        <pc:spChg chg="mod">
          <ac:chgData name="Thu Huyen Pham" userId="3eb787573b41f7e6" providerId="LiveId" clId="{D2B87A3D-0BCF-43FE-BE70-508B5C39EF1C}" dt="2019-05-06T06:16:23.829" v="399" actId="1037"/>
          <ac:spMkLst>
            <pc:docMk/>
            <pc:sldMk cId="2705666942" sldId="259"/>
            <ac:spMk id="25" creationId="{A906576B-B11D-4645-A98C-C76BE63E2D6C}"/>
          </ac:spMkLst>
        </pc:spChg>
        <pc:spChg chg="mod">
          <ac:chgData name="Thu Huyen Pham" userId="3eb787573b41f7e6" providerId="LiveId" clId="{D2B87A3D-0BCF-43FE-BE70-508B5C39EF1C}" dt="2019-05-06T06:16:23.829" v="399" actId="1037"/>
          <ac:spMkLst>
            <pc:docMk/>
            <pc:sldMk cId="2705666942" sldId="259"/>
            <ac:spMk id="26" creationId="{1EAFBC4D-B4C4-4046-8A90-1411160414CA}"/>
          </ac:spMkLst>
        </pc:spChg>
        <pc:spChg chg="mod">
          <ac:chgData name="Thu Huyen Pham" userId="3eb787573b41f7e6" providerId="LiveId" clId="{D2B87A3D-0BCF-43FE-BE70-508B5C39EF1C}" dt="2019-05-06T06:16:23.829" v="399" actId="1037"/>
          <ac:spMkLst>
            <pc:docMk/>
            <pc:sldMk cId="2705666942" sldId="259"/>
            <ac:spMk id="27" creationId="{E6F88364-3AA8-42CE-937B-773B889259F0}"/>
          </ac:spMkLst>
        </pc:spChg>
        <pc:spChg chg="mod">
          <ac:chgData name="Thu Huyen Pham" userId="3eb787573b41f7e6" providerId="LiveId" clId="{D2B87A3D-0BCF-43FE-BE70-508B5C39EF1C}" dt="2019-05-06T06:16:23.829" v="399" actId="1037"/>
          <ac:spMkLst>
            <pc:docMk/>
            <pc:sldMk cId="2705666942" sldId="259"/>
            <ac:spMk id="28" creationId="{3FFE8A84-3F29-4908-87B4-B6C556C06331}"/>
          </ac:spMkLst>
        </pc:spChg>
        <pc:spChg chg="mod">
          <ac:chgData name="Thu Huyen Pham" userId="3eb787573b41f7e6" providerId="LiveId" clId="{D2B87A3D-0BCF-43FE-BE70-508B5C39EF1C}" dt="2019-05-06T06:16:23.829" v="399" actId="1037"/>
          <ac:spMkLst>
            <pc:docMk/>
            <pc:sldMk cId="2705666942" sldId="259"/>
            <ac:spMk id="29" creationId="{28B1D11F-C188-45D2-A4A6-D5F356A74D11}"/>
          </ac:spMkLst>
        </pc:spChg>
        <pc:spChg chg="add del mod">
          <ac:chgData name="Thu Huyen Pham" userId="3eb787573b41f7e6" providerId="LiveId" clId="{D2B87A3D-0BCF-43FE-BE70-508B5C39EF1C}" dt="2019-05-06T06:13:05.335" v="257" actId="478"/>
          <ac:spMkLst>
            <pc:docMk/>
            <pc:sldMk cId="2705666942" sldId="259"/>
            <ac:spMk id="30" creationId="{15838AC3-26F4-4AC7-B057-A2A02A8EA03A}"/>
          </ac:spMkLst>
        </pc:spChg>
        <pc:spChg chg="add del mod">
          <ac:chgData name="Thu Huyen Pham" userId="3eb787573b41f7e6" providerId="LiveId" clId="{D2B87A3D-0BCF-43FE-BE70-508B5C39EF1C}" dt="2019-05-06T06:13:05.335" v="257" actId="478"/>
          <ac:spMkLst>
            <pc:docMk/>
            <pc:sldMk cId="2705666942" sldId="259"/>
            <ac:spMk id="32" creationId="{A96F34E5-0259-4F93-82EB-29F0EF066214}"/>
          </ac:spMkLst>
        </pc:spChg>
        <pc:spChg chg="add del mod">
          <ac:chgData name="Thu Huyen Pham" userId="3eb787573b41f7e6" providerId="LiveId" clId="{D2B87A3D-0BCF-43FE-BE70-508B5C39EF1C}" dt="2019-05-06T06:13:05.335" v="257" actId="478"/>
          <ac:spMkLst>
            <pc:docMk/>
            <pc:sldMk cId="2705666942" sldId="259"/>
            <ac:spMk id="34" creationId="{800F0568-20E7-4A0A-AC4C-839A92087E10}"/>
          </ac:spMkLst>
        </pc:spChg>
        <pc:spChg chg="add mod">
          <ac:chgData name="Thu Huyen Pham" userId="3eb787573b41f7e6" providerId="LiveId" clId="{D2B87A3D-0BCF-43FE-BE70-508B5C39EF1C}" dt="2019-05-06T06:16:23.829" v="399" actId="1037"/>
          <ac:spMkLst>
            <pc:docMk/>
            <pc:sldMk cId="2705666942" sldId="259"/>
            <ac:spMk id="38" creationId="{57213790-94D5-47E5-9431-83A03F73CFC1}"/>
          </ac:spMkLst>
        </pc:spChg>
        <pc:spChg chg="add mod">
          <ac:chgData name="Thu Huyen Pham" userId="3eb787573b41f7e6" providerId="LiveId" clId="{D2B87A3D-0BCF-43FE-BE70-508B5C39EF1C}" dt="2019-05-06T06:16:23.829" v="399" actId="1037"/>
          <ac:spMkLst>
            <pc:docMk/>
            <pc:sldMk cId="2705666942" sldId="259"/>
            <ac:spMk id="40" creationId="{611DE519-36F0-47CD-96A8-6F2E380367E4}"/>
          </ac:spMkLst>
        </pc:spChg>
        <pc:spChg chg="mod">
          <ac:chgData name="Thu Huyen Pham" userId="3eb787573b41f7e6" providerId="LiveId" clId="{D2B87A3D-0BCF-43FE-BE70-508B5C39EF1C}" dt="2019-05-06T06:16:23.829" v="399" actId="1037"/>
          <ac:spMkLst>
            <pc:docMk/>
            <pc:sldMk cId="2705666942" sldId="259"/>
            <ac:spMk id="41" creationId="{291919B5-B38D-4599-A70B-98B613CB3CDE}"/>
          </ac:spMkLst>
        </pc:spChg>
        <pc:spChg chg="add mod">
          <ac:chgData name="Thu Huyen Pham" userId="3eb787573b41f7e6" providerId="LiveId" clId="{D2B87A3D-0BCF-43FE-BE70-508B5C39EF1C}" dt="2019-05-06T06:16:23.829" v="399" actId="1037"/>
          <ac:spMkLst>
            <pc:docMk/>
            <pc:sldMk cId="2705666942" sldId="259"/>
            <ac:spMk id="43" creationId="{B9E79E71-8C36-4CFC-AB27-1752541D389F}"/>
          </ac:spMkLst>
        </pc:spChg>
        <pc:spChg chg="add mod">
          <ac:chgData name="Thu Huyen Pham" userId="3eb787573b41f7e6" providerId="LiveId" clId="{D2B87A3D-0BCF-43FE-BE70-508B5C39EF1C}" dt="2019-05-06T06:16:23.829" v="399" actId="1037"/>
          <ac:spMkLst>
            <pc:docMk/>
            <pc:sldMk cId="2705666942" sldId="259"/>
            <ac:spMk id="44" creationId="{44C2130C-DC22-49E3-B1B5-4DC067E559E7}"/>
          </ac:spMkLst>
        </pc:spChg>
        <pc:spChg chg="add mod">
          <ac:chgData name="Thu Huyen Pham" userId="3eb787573b41f7e6" providerId="LiveId" clId="{D2B87A3D-0BCF-43FE-BE70-508B5C39EF1C}" dt="2019-05-06T06:16:23.829" v="399" actId="1037"/>
          <ac:spMkLst>
            <pc:docMk/>
            <pc:sldMk cId="2705666942" sldId="259"/>
            <ac:spMk id="45" creationId="{92B99D4C-5F03-45E6-9D3A-DE8719B8B38D}"/>
          </ac:spMkLst>
        </pc:spChg>
        <pc:picChg chg="add del mod">
          <ac:chgData name="Thu Huyen Pham" userId="3eb787573b41f7e6" providerId="LiveId" clId="{D2B87A3D-0BCF-43FE-BE70-508B5C39EF1C}" dt="2019-05-06T06:12:06.286" v="243"/>
          <ac:picMkLst>
            <pc:docMk/>
            <pc:sldMk cId="2705666942" sldId="259"/>
            <ac:picMk id="2" creationId="{2E01D7D2-2544-4565-A21C-2E1CF46EC8C2}"/>
          </ac:picMkLst>
        </pc:picChg>
        <pc:picChg chg="add del mod">
          <ac:chgData name="Thu Huyen Pham" userId="3eb787573b41f7e6" providerId="LiveId" clId="{D2B87A3D-0BCF-43FE-BE70-508B5C39EF1C}" dt="2019-05-03T01:51:48.427" v="78" actId="478"/>
          <ac:picMkLst>
            <pc:docMk/>
            <pc:sldMk cId="2705666942" sldId="259"/>
            <ac:picMk id="3" creationId="{21591A1B-33ED-469C-85F2-CEE6D417B7A4}"/>
          </ac:picMkLst>
        </pc:picChg>
        <pc:picChg chg="add mod ord">
          <ac:chgData name="Thu Huyen Pham" userId="3eb787573b41f7e6" providerId="LiveId" clId="{D2B87A3D-0BCF-43FE-BE70-508B5C39EF1C}" dt="2019-05-06T06:16:23.829" v="399" actId="1037"/>
          <ac:picMkLst>
            <pc:docMk/>
            <pc:sldMk cId="2705666942" sldId="259"/>
            <ac:picMk id="3" creationId="{F5322F6B-C5F0-4A0A-9EF7-AD5137FD5145}"/>
          </ac:picMkLst>
        </pc:picChg>
        <pc:picChg chg="add mod">
          <ac:chgData name="Thu Huyen Pham" userId="3eb787573b41f7e6" providerId="LiveId" clId="{D2B87A3D-0BCF-43FE-BE70-508B5C39EF1C}" dt="2019-05-06T06:16:23.829" v="399" actId="1037"/>
          <ac:picMkLst>
            <pc:docMk/>
            <pc:sldMk cId="2705666942" sldId="259"/>
            <ac:picMk id="4" creationId="{C8B684CA-E8C5-41B8-8ED0-97A707EC38F6}"/>
          </ac:picMkLst>
        </pc:picChg>
        <pc:picChg chg="add del mod ord modCrop">
          <ac:chgData name="Thu Huyen Pham" userId="3eb787573b41f7e6" providerId="LiveId" clId="{D2B87A3D-0BCF-43FE-BE70-508B5C39EF1C}" dt="2019-05-06T06:12:45.068" v="254" actId="478"/>
          <ac:picMkLst>
            <pc:docMk/>
            <pc:sldMk cId="2705666942" sldId="259"/>
            <ac:picMk id="5" creationId="{0A3253DF-BE4B-4F78-AEFA-440463686565}"/>
          </ac:picMkLst>
        </pc:picChg>
        <pc:picChg chg="add mod ord">
          <ac:chgData name="Thu Huyen Pham" userId="3eb787573b41f7e6" providerId="LiveId" clId="{D2B87A3D-0BCF-43FE-BE70-508B5C39EF1C}" dt="2019-05-06T06:16:23.829" v="399" actId="1037"/>
          <ac:picMkLst>
            <pc:docMk/>
            <pc:sldMk cId="2705666942" sldId="259"/>
            <ac:picMk id="6" creationId="{FB8ED5CC-D006-487D-8A5F-D9D4118C60A8}"/>
          </ac:picMkLst>
        </pc:picChg>
        <pc:picChg chg="add del mod modCrop">
          <ac:chgData name="Thu Huyen Pham" userId="3eb787573b41f7e6" providerId="LiveId" clId="{D2B87A3D-0BCF-43FE-BE70-508B5C39EF1C}" dt="2019-05-03T02:32:53.045" v="189" actId="478"/>
          <ac:picMkLst>
            <pc:docMk/>
            <pc:sldMk cId="2705666942" sldId="259"/>
            <ac:picMk id="7" creationId="{086B5FA8-3F73-4C61-B28D-9C14FBC914C3}"/>
          </ac:picMkLst>
        </pc:picChg>
        <pc:picChg chg="add mod">
          <ac:chgData name="Thu Huyen Pham" userId="3eb787573b41f7e6" providerId="LiveId" clId="{D2B87A3D-0BCF-43FE-BE70-508B5C39EF1C}" dt="2019-05-06T06:16:23.829" v="399" actId="1037"/>
          <ac:picMkLst>
            <pc:docMk/>
            <pc:sldMk cId="2705666942" sldId="259"/>
            <ac:picMk id="7" creationId="{486C7B8A-71CB-451D-A1FC-912A98A2BBD6}"/>
          </ac:picMkLst>
        </pc:picChg>
        <pc:picChg chg="add mod">
          <ac:chgData name="Thu Huyen Pham" userId="3eb787573b41f7e6" providerId="LiveId" clId="{D2B87A3D-0BCF-43FE-BE70-508B5C39EF1C}" dt="2019-05-06T06:16:23.829" v="399" actId="1037"/>
          <ac:picMkLst>
            <pc:docMk/>
            <pc:sldMk cId="2705666942" sldId="259"/>
            <ac:picMk id="11" creationId="{F28DA640-9497-4D62-9224-9B8A6BF68328}"/>
          </ac:picMkLst>
        </pc:picChg>
        <pc:picChg chg="add del mod modCrop">
          <ac:chgData name="Thu Huyen Pham" userId="3eb787573b41f7e6" providerId="LiveId" clId="{D2B87A3D-0BCF-43FE-BE70-508B5C39EF1C}" dt="2019-05-03T02:32:53.045" v="189" actId="478"/>
          <ac:picMkLst>
            <pc:docMk/>
            <pc:sldMk cId="2705666942" sldId="259"/>
            <ac:picMk id="12" creationId="{CC490DDC-C7B6-4446-A763-855BD6BFD9F1}"/>
          </ac:picMkLst>
        </pc:picChg>
        <pc:picChg chg="add del mod">
          <ac:chgData name="Thu Huyen Pham" userId="3eb787573b41f7e6" providerId="LiveId" clId="{D2B87A3D-0BCF-43FE-BE70-508B5C39EF1C}" dt="2019-05-03T02:30:28.816" v="157" actId="478"/>
          <ac:picMkLst>
            <pc:docMk/>
            <pc:sldMk cId="2705666942" sldId="259"/>
            <ac:picMk id="14" creationId="{B88DA55B-8C97-44E4-AF22-A30923B4EFC7}"/>
          </ac:picMkLst>
        </pc:picChg>
        <pc:picChg chg="add del mod ord modCrop">
          <ac:chgData name="Thu Huyen Pham" userId="3eb787573b41f7e6" providerId="LiveId" clId="{D2B87A3D-0BCF-43FE-BE70-508B5C39EF1C}" dt="2019-05-06T06:12:45.068" v="254" actId="478"/>
          <ac:picMkLst>
            <pc:docMk/>
            <pc:sldMk cId="2705666942" sldId="259"/>
            <ac:picMk id="17" creationId="{11BE0E1F-D547-4992-892C-98FCB38EC431}"/>
          </ac:picMkLst>
        </pc:picChg>
        <pc:picChg chg="add del mod">
          <ac:chgData name="Thu Huyen Pham" userId="3eb787573b41f7e6" providerId="LiveId" clId="{D2B87A3D-0BCF-43FE-BE70-508B5C39EF1C}" dt="2019-05-01T14:41:15.306" v="13" actId="478"/>
          <ac:picMkLst>
            <pc:docMk/>
            <pc:sldMk cId="2705666942" sldId="259"/>
            <ac:picMk id="18" creationId="{A1517AD6-73BD-4B90-9DF1-F8248A818BEB}"/>
          </ac:picMkLst>
        </pc:picChg>
        <pc:picChg chg="add del mod modCrop">
          <ac:chgData name="Thu Huyen Pham" userId="3eb787573b41f7e6" providerId="LiveId" clId="{D2B87A3D-0BCF-43FE-BE70-508B5C39EF1C}" dt="2019-05-06T06:12:45.068" v="254" actId="478"/>
          <ac:picMkLst>
            <pc:docMk/>
            <pc:sldMk cId="2705666942" sldId="259"/>
            <ac:picMk id="19" creationId="{5CA697AC-A21F-4E3E-B09F-45E7159F1379}"/>
          </ac:picMkLst>
        </pc:picChg>
        <pc:picChg chg="add del mod modCrop">
          <ac:chgData name="Thu Huyen Pham" userId="3eb787573b41f7e6" providerId="LiveId" clId="{D2B87A3D-0BCF-43FE-BE70-508B5C39EF1C}" dt="2019-05-02T07:51:37.218" v="43" actId="478"/>
          <ac:picMkLst>
            <pc:docMk/>
            <pc:sldMk cId="2705666942" sldId="259"/>
            <ac:picMk id="20" creationId="{EFAFFA61-C16F-477B-BBFE-B653E553AC85}"/>
          </ac:picMkLst>
        </pc:picChg>
        <pc:picChg chg="add del mod">
          <ac:chgData name="Thu Huyen Pham" userId="3eb787573b41f7e6" providerId="LiveId" clId="{D2B87A3D-0BCF-43FE-BE70-508B5C39EF1C}" dt="2019-05-03T02:01:09.817" v="112" actId="478"/>
          <ac:picMkLst>
            <pc:docMk/>
            <pc:sldMk cId="2705666942" sldId="259"/>
            <ac:picMk id="21" creationId="{82524B49-C51B-4D4B-9296-ABE88282C379}"/>
          </ac:picMkLst>
        </pc:picChg>
        <pc:picChg chg="add del mod modCrop">
          <ac:chgData name="Thu Huyen Pham" userId="3eb787573b41f7e6" providerId="LiveId" clId="{D2B87A3D-0BCF-43FE-BE70-508B5C39EF1C}" dt="2019-05-06T06:12:45.068" v="254" actId="478"/>
          <ac:picMkLst>
            <pc:docMk/>
            <pc:sldMk cId="2705666942" sldId="259"/>
            <ac:picMk id="22" creationId="{19601272-3B74-4FCA-9364-A95F26255F1B}"/>
          </ac:picMkLst>
        </pc:picChg>
        <pc:picChg chg="add del mod modCrop">
          <ac:chgData name="Thu Huyen Pham" userId="3eb787573b41f7e6" providerId="LiveId" clId="{D2B87A3D-0BCF-43FE-BE70-508B5C39EF1C}" dt="2019-05-06T06:12:45.068" v="254" actId="478"/>
          <ac:picMkLst>
            <pc:docMk/>
            <pc:sldMk cId="2705666942" sldId="259"/>
            <ac:picMk id="23" creationId="{47D15E91-261A-4435-8541-858F34EE4BC7}"/>
          </ac:picMkLst>
        </pc:picChg>
        <pc:picChg chg="mod">
          <ac:chgData name="Thu Huyen Pham" userId="3eb787573b41f7e6" providerId="LiveId" clId="{D2B87A3D-0BCF-43FE-BE70-508B5C39EF1C}" dt="2019-05-06T06:16:23.829" v="399" actId="1037"/>
          <ac:picMkLst>
            <pc:docMk/>
            <pc:sldMk cId="2705666942" sldId="259"/>
            <ac:picMk id="31" creationId="{AFA104BC-7AE7-490A-900B-C33204B87D68}"/>
          </ac:picMkLst>
        </pc:picChg>
        <pc:picChg chg="mod">
          <ac:chgData name="Thu Huyen Pham" userId="3eb787573b41f7e6" providerId="LiveId" clId="{D2B87A3D-0BCF-43FE-BE70-508B5C39EF1C}" dt="2019-05-06T06:16:23.829" v="399" actId="1037"/>
          <ac:picMkLst>
            <pc:docMk/>
            <pc:sldMk cId="2705666942" sldId="259"/>
            <ac:picMk id="33" creationId="{8BF95E3F-C574-48BA-B13E-07A22E28D257}"/>
          </ac:picMkLst>
        </pc:picChg>
        <pc:picChg chg="mod">
          <ac:chgData name="Thu Huyen Pham" userId="3eb787573b41f7e6" providerId="LiveId" clId="{D2B87A3D-0BCF-43FE-BE70-508B5C39EF1C}" dt="2019-05-06T06:16:23.829" v="399" actId="1037"/>
          <ac:picMkLst>
            <pc:docMk/>
            <pc:sldMk cId="2705666942" sldId="259"/>
            <ac:picMk id="35" creationId="{06359D65-946B-4F03-BBAB-9C49C3514CAE}"/>
          </ac:picMkLst>
        </pc:picChg>
        <pc:picChg chg="add del mod">
          <ac:chgData name="Thu Huyen Pham" userId="3eb787573b41f7e6" providerId="LiveId" clId="{D2B87A3D-0BCF-43FE-BE70-508B5C39EF1C}" dt="2019-05-03T02:32:53.045" v="189" actId="478"/>
          <ac:picMkLst>
            <pc:docMk/>
            <pc:sldMk cId="2705666942" sldId="259"/>
            <ac:picMk id="36" creationId="{5DE6ECA6-A108-4BD6-AFB1-CCCBED078630}"/>
          </ac:picMkLst>
        </pc:picChg>
        <pc:picChg chg="add del mod">
          <ac:chgData name="Thu Huyen Pham" userId="3eb787573b41f7e6" providerId="LiveId" clId="{D2B87A3D-0BCF-43FE-BE70-508B5C39EF1C}" dt="2019-05-06T06:10:52.518" v="239" actId="478"/>
          <ac:picMkLst>
            <pc:docMk/>
            <pc:sldMk cId="2705666942" sldId="259"/>
            <ac:picMk id="36" creationId="{8074C22B-F637-49F4-932B-1AFCAB3A7E52}"/>
          </ac:picMkLst>
        </pc:picChg>
        <pc:picChg chg="mod">
          <ac:chgData name="Thu Huyen Pham" userId="3eb787573b41f7e6" providerId="LiveId" clId="{D2B87A3D-0BCF-43FE-BE70-508B5C39EF1C}" dt="2019-05-06T06:16:23.829" v="399" actId="1037"/>
          <ac:picMkLst>
            <pc:docMk/>
            <pc:sldMk cId="2705666942" sldId="259"/>
            <ac:picMk id="37" creationId="{60F74843-6DA0-48CA-9BAA-ED9001B4C5E1}"/>
          </ac:picMkLst>
        </pc:picChg>
        <pc:picChg chg="mod">
          <ac:chgData name="Thu Huyen Pham" userId="3eb787573b41f7e6" providerId="LiveId" clId="{D2B87A3D-0BCF-43FE-BE70-508B5C39EF1C}" dt="2019-05-06T06:16:23.829" v="399" actId="1037"/>
          <ac:picMkLst>
            <pc:docMk/>
            <pc:sldMk cId="2705666942" sldId="259"/>
            <ac:picMk id="39" creationId="{A1CC91CD-E0EA-4B4F-BD7F-6CCA28B1DF85}"/>
          </ac:picMkLst>
        </pc:picChg>
        <pc:picChg chg="add del mod ord modCrop">
          <ac:chgData name="Thu Huyen Pham" userId="3eb787573b41f7e6" providerId="LiveId" clId="{D2B87A3D-0BCF-43FE-BE70-508B5C39EF1C}" dt="2019-05-03T02:31:06.715" v="165" actId="478"/>
          <ac:picMkLst>
            <pc:docMk/>
            <pc:sldMk cId="2705666942" sldId="259"/>
            <ac:picMk id="40" creationId="{7F981B65-6EBB-44F0-BE14-5F1DC3DFFC09}"/>
          </ac:picMkLst>
        </pc:picChg>
        <pc:picChg chg="add del mod modCrop">
          <ac:chgData name="Thu Huyen Pham" userId="3eb787573b41f7e6" providerId="LiveId" clId="{D2B87A3D-0BCF-43FE-BE70-508B5C39EF1C}" dt="2019-05-03T02:32:53.045" v="189" actId="478"/>
          <ac:picMkLst>
            <pc:docMk/>
            <pc:sldMk cId="2705666942" sldId="259"/>
            <ac:picMk id="43" creationId="{5EEB3146-40D8-4706-B186-B9E2E9483AEA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68F10E-3EBE-4313-93FC-3DBE0923BF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8EBCD00-FF92-44BF-85D9-50CFC8500B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0CE884-696C-4FDF-903E-5BA616D757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6784F-DFA4-4149-8315-8795703C004D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C6901D-6CF1-4D3A-B65F-EB9455A7D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2142D9-D749-42B7-BB1A-B9C61902B7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191A9-48EA-4759-A6B4-619EE367E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860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E2B286-4F62-4C98-BE66-0346F5EDA2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BE5533-D4CE-4BC4-A6E6-43D392CF2B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24A485-F241-448B-AE84-B47B087153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6784F-DFA4-4149-8315-8795703C004D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3CEA40-ECFD-41DD-9548-D94FAC8CC9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F978DF-4521-48E7-A9D6-FD1C9C2C3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191A9-48EA-4759-A6B4-619EE367E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4799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5B020A-AE5B-4F63-85CB-E0A7733188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425910-7ABD-45FB-9FEF-F0B3A922E9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C17B84-E347-4959-94B8-4BCB615D91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6784F-DFA4-4149-8315-8795703C004D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81039A-AFB5-4888-8233-E48887DDE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6F20AA-EF4C-45E9-B4AF-EB54124CC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191A9-48EA-4759-A6B4-619EE367E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648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19282F-772F-49C0-B2D9-D914CA583D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F96B80-AE1E-44CD-996A-7BEA602852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738483-1A03-4448-B760-FADC3E66D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6784F-DFA4-4149-8315-8795703C004D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0154C9-D858-4299-BC50-D824F0574A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0E61DB-31CE-4A79-B690-8A7E565C85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191A9-48EA-4759-A6B4-619EE367E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8603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7E5B0A-3A37-462D-BB08-ED356A07A6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6541BE-C87A-4915-AF95-56CFC60D85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187D23-16C1-475A-B233-DB4164234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6784F-DFA4-4149-8315-8795703C004D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01B62B-AE5F-4B73-8702-1049454A40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4F162D-B6EF-40DE-9112-C7E59ED27F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191A9-48EA-4759-A6B4-619EE367E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603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28CA45-086F-4ED5-88D7-F38908203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B275A1-9ECF-4E20-A4B6-2D624DB78A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B446190-9336-4A7B-A5EA-ECB5256AF9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0AFEEA-7B04-4865-9550-FD559BE6F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6784F-DFA4-4149-8315-8795703C004D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D5A5AC-08BA-4D9F-9EBE-AF6D028C6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FB73CA-D76E-4EE6-B8E4-5FD20985D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191A9-48EA-4759-A6B4-619EE367E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000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A2566B-C6FF-465E-8E9F-7FD18E2069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371511-F091-4806-91E4-BDD4438B64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F6DDAB-744F-49B9-96DE-DE1BB9E984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C7E785B-47A3-488A-83A7-E9EC0F39DD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477689-11F5-4BE3-8660-62D13E6665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AD03539-FC65-45BB-AFC5-B3D1D464F1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6784F-DFA4-4149-8315-8795703C004D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3C20C4A-FAA5-4A49-8941-1EC3EE8D6E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74BA1FA-0B36-4583-A9AC-A0E212AD3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191A9-48EA-4759-A6B4-619EE367E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649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004D97-C991-4177-80CE-C9DA80376C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243F11-D752-4151-B589-0AAD65F9E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6784F-DFA4-4149-8315-8795703C004D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30DBF53-03E7-4EAA-BA74-BF05645BD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4C12E67-972F-445D-B6D3-123C89E878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191A9-48EA-4759-A6B4-619EE367E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502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95AE8F-0E2D-44FA-B06E-B462B49370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6784F-DFA4-4149-8315-8795703C004D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993F639-4F83-4174-A065-847AF018F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D0A4F7D-9EC1-41C5-A2BB-84D7D98AF5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191A9-48EA-4759-A6B4-619EE367E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91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12BA01-1150-42FA-A93E-BE84B4428D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F57EE0-887E-4791-B3DB-9F428AB73F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877C8E-165D-4ACC-A415-DAC4DF7753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222F1E-D7B8-4C3F-9D9C-34EEDE7845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6784F-DFA4-4149-8315-8795703C004D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24BC01-822F-426D-B4B5-E1588E7715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45912D-4AA2-449F-B259-FCE0F5D5E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191A9-48EA-4759-A6B4-619EE367E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02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B86380-E0A2-42D6-A45D-F28BE4AB11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236B2CC-054E-4E85-864F-8E32DFFFFD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CDC2E8-1262-4D76-9D2A-D1321ED734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2A7A40-6544-4288-BAE1-031ABB8CD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6784F-DFA4-4149-8315-8795703C004D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0192EC-6A7B-4E6F-AFEC-A96752540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322455-A9F0-472B-8590-9E212473F0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191A9-48EA-4759-A6B4-619EE367E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112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6899A91-FBD0-4A7A-9936-19C9F6DFE6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2F8EE4-149D-4042-8D89-8799B9E926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1A1FFE-FC3F-4162-A62D-232D6BC3C2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86784F-DFA4-4149-8315-8795703C004D}" type="datetimeFigureOut">
              <a:rPr lang="en-US" smtClean="0"/>
              <a:t>5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85EA5E-D263-4797-BA81-9C0A768ED9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929CA2-A9FF-4F65-9170-57D24D4911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1191A9-48EA-4759-A6B4-619EE367E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9228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g"/><Relationship Id="rId3" Type="http://schemas.openxmlformats.org/officeDocument/2006/relationships/image" Target="../media/image8.jpg"/><Relationship Id="rId7" Type="http://schemas.openxmlformats.org/officeDocument/2006/relationships/image" Target="../media/image12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jpg"/><Relationship Id="rId5" Type="http://schemas.openxmlformats.org/officeDocument/2006/relationships/image" Target="../media/image16.jpg"/><Relationship Id="rId4" Type="http://schemas.openxmlformats.org/officeDocument/2006/relationships/image" Target="../media/image15.jp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jpg"/><Relationship Id="rId3" Type="http://schemas.openxmlformats.org/officeDocument/2006/relationships/image" Target="../media/image19.jpg"/><Relationship Id="rId7" Type="http://schemas.openxmlformats.org/officeDocument/2006/relationships/image" Target="../media/image23.jpg"/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jpg"/><Relationship Id="rId5" Type="http://schemas.openxmlformats.org/officeDocument/2006/relationships/image" Target="../media/image21.jpg"/><Relationship Id="rId4" Type="http://schemas.openxmlformats.org/officeDocument/2006/relationships/image" Target="../media/image20.jp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jp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jpg"/><Relationship Id="rId11" Type="http://schemas.openxmlformats.org/officeDocument/2006/relationships/image" Target="../media/image34.png"/><Relationship Id="rId5" Type="http://schemas.openxmlformats.org/officeDocument/2006/relationships/image" Target="../media/image28.jpg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DA1856D-60BE-40D8-AB9A-1724575E53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90096" y="1470481"/>
            <a:ext cx="3481118" cy="282269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1FA6AF8-392F-4641-AAD7-537A31C2C83B}"/>
              </a:ext>
            </a:extLst>
          </p:cNvPr>
          <p:cNvSpPr txBox="1"/>
          <p:nvPr/>
        </p:nvSpPr>
        <p:spPr>
          <a:xfrm>
            <a:off x="1065947" y="5347047"/>
            <a:ext cx="7409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GAPDH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2751969-E042-44DE-9CA6-6A062342F814}"/>
              </a:ext>
            </a:extLst>
          </p:cNvPr>
          <p:cNvSpPr txBox="1"/>
          <p:nvPr/>
        </p:nvSpPr>
        <p:spPr>
          <a:xfrm>
            <a:off x="4175571" y="183583"/>
            <a:ext cx="26521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Raw data of figure 2A </a:t>
            </a:r>
            <a:endParaRPr lang="ko-KR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82A9885C-613E-4B15-8C92-40941DA9ABB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3713" y="735667"/>
            <a:ext cx="3454633" cy="355234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DAD76C37-6A73-4B02-ACAC-6CA6835627F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5824" y="4624663"/>
            <a:ext cx="3292522" cy="1795921"/>
          </a:xfrm>
          <a:prstGeom prst="rect">
            <a:avLst/>
          </a:prstGeom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AFF6ABB5-7952-4CC4-8EA8-D64E785DCFC0}"/>
              </a:ext>
            </a:extLst>
          </p:cNvPr>
          <p:cNvSpPr/>
          <p:nvPr/>
        </p:nvSpPr>
        <p:spPr>
          <a:xfrm>
            <a:off x="3568482" y="1906150"/>
            <a:ext cx="777656" cy="244599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8E948285-4864-4D48-99A8-CB9E6FECF7BE}"/>
              </a:ext>
            </a:extLst>
          </p:cNvPr>
          <p:cNvSpPr/>
          <p:nvPr/>
        </p:nvSpPr>
        <p:spPr>
          <a:xfrm>
            <a:off x="3757233" y="4527818"/>
            <a:ext cx="876743" cy="206002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A7394B3-88F3-40F2-B57D-A6D10D1B7AE0}"/>
              </a:ext>
            </a:extLst>
          </p:cNvPr>
          <p:cNvSpPr txBox="1"/>
          <p:nvPr/>
        </p:nvSpPr>
        <p:spPr>
          <a:xfrm>
            <a:off x="1008901" y="2881828"/>
            <a:ext cx="73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Times New Roman" pitchFamily="18" charset="0"/>
                <a:cs typeface="Times New Roman" pitchFamily="18" charset="0"/>
              </a:rPr>
              <a:t>Myc</a:t>
            </a:r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-tag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FFD46ED-186B-4714-8E35-DEDD8C12EA65}"/>
              </a:ext>
            </a:extLst>
          </p:cNvPr>
          <p:cNvSpPr txBox="1"/>
          <p:nvPr/>
        </p:nvSpPr>
        <p:spPr>
          <a:xfrm>
            <a:off x="3923946" y="1660751"/>
            <a:ext cx="631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IL-32</a:t>
            </a:r>
            <a:r>
              <a:rPr lang="el-GR" altLang="ko-KR" sz="1200" b="1" dirty="0">
                <a:latin typeface="Times New Roman"/>
                <a:cs typeface="Times New Roman"/>
              </a:rPr>
              <a:t>θ</a:t>
            </a:r>
            <a:endParaRPr lang="ko-KR" altLang="en-US" sz="12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A2898AE-61A5-4E6F-9333-89FBC1E722E4}"/>
              </a:ext>
            </a:extLst>
          </p:cNvPr>
          <p:cNvSpPr txBox="1"/>
          <p:nvPr/>
        </p:nvSpPr>
        <p:spPr>
          <a:xfrm>
            <a:off x="3595449" y="165400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EV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75AC14D-CCC7-45A2-A913-ADB5BF7677AE}"/>
              </a:ext>
            </a:extLst>
          </p:cNvPr>
          <p:cNvSpPr txBox="1"/>
          <p:nvPr/>
        </p:nvSpPr>
        <p:spPr>
          <a:xfrm>
            <a:off x="4053510" y="5015967"/>
            <a:ext cx="631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IL-32</a:t>
            </a:r>
            <a:r>
              <a:rPr lang="el-GR" altLang="ko-KR" sz="1200" b="1" dirty="0">
                <a:latin typeface="Times New Roman"/>
                <a:cs typeface="Times New Roman"/>
              </a:rPr>
              <a:t>θ</a:t>
            </a:r>
            <a:endParaRPr lang="ko-KR" altLang="en-US" sz="1200" b="1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A47D944-5C88-49FB-BED7-CE2B0BA44898}"/>
              </a:ext>
            </a:extLst>
          </p:cNvPr>
          <p:cNvSpPr txBox="1"/>
          <p:nvPr/>
        </p:nvSpPr>
        <p:spPr>
          <a:xfrm>
            <a:off x="3725013" y="500922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EV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CF0093B-505E-4E57-8476-3C7B72F0C045}"/>
              </a:ext>
            </a:extLst>
          </p:cNvPr>
          <p:cNvSpPr/>
          <p:nvPr/>
        </p:nvSpPr>
        <p:spPr>
          <a:xfrm>
            <a:off x="8572599" y="2903706"/>
            <a:ext cx="750689" cy="45087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1D9C915-8D97-427F-898C-C0B1B5610F60}"/>
              </a:ext>
            </a:extLst>
          </p:cNvPr>
          <p:cNvSpPr txBox="1"/>
          <p:nvPr/>
        </p:nvSpPr>
        <p:spPr>
          <a:xfrm>
            <a:off x="8920128" y="2604829"/>
            <a:ext cx="631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IL-32</a:t>
            </a:r>
            <a:r>
              <a:rPr lang="el-GR" altLang="ko-KR" sz="1200" b="1" dirty="0">
                <a:latin typeface="Times New Roman"/>
                <a:cs typeface="Times New Roman"/>
              </a:rPr>
              <a:t>θ</a:t>
            </a:r>
            <a:endParaRPr lang="ko-KR" altLang="en-US" sz="12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7917173-75AE-4646-A0B0-0ECD6FA491AF}"/>
              </a:ext>
            </a:extLst>
          </p:cNvPr>
          <p:cNvSpPr txBox="1"/>
          <p:nvPr/>
        </p:nvSpPr>
        <p:spPr>
          <a:xfrm>
            <a:off x="8591631" y="259808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EV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56EC955-F388-4C0A-94B6-9D630EB635F1}"/>
              </a:ext>
            </a:extLst>
          </p:cNvPr>
          <p:cNvSpPr txBox="1"/>
          <p:nvPr/>
        </p:nvSpPr>
        <p:spPr>
          <a:xfrm>
            <a:off x="5830684" y="2881828"/>
            <a:ext cx="7745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KU32-52</a:t>
            </a:r>
          </a:p>
        </p:txBody>
      </p:sp>
    </p:spTree>
    <p:extLst>
      <p:ext uri="{BB962C8B-B14F-4D97-AF65-F5344CB8AC3E}">
        <p14:creationId xmlns:p14="http://schemas.microsoft.com/office/powerpoint/2010/main" val="31676039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7">
            <a:extLst>
              <a:ext uri="{FF2B5EF4-FFF2-40B4-BE49-F238E27FC236}">
                <a16:creationId xmlns:a16="http://schemas.microsoft.com/office/drawing/2014/main" id="{7B2A5339-D828-405D-8B11-B0DEC55B55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0231" y="5347490"/>
            <a:ext cx="3105513" cy="1123271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B8BFD923-2E0A-4AFE-B7BB-22AF26844B3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6525" y="2890917"/>
            <a:ext cx="5954986" cy="1902835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4724F865-D63C-4E38-9531-048D89D2BC8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4800" y="1213229"/>
            <a:ext cx="3962400" cy="112395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E8D953B-3C5B-4070-BAFC-6051D24D03EB}"/>
              </a:ext>
            </a:extLst>
          </p:cNvPr>
          <p:cNvSpPr txBox="1"/>
          <p:nvPr/>
        </p:nvSpPr>
        <p:spPr>
          <a:xfrm>
            <a:off x="3149736" y="1706912"/>
            <a:ext cx="9625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spcBef>
                <a:spcPts val="600"/>
              </a:spcBef>
              <a:spcAft>
                <a:spcPts val="600"/>
              </a:spcAft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X-2</a:t>
            </a:r>
          </a:p>
        </p:txBody>
      </p:sp>
      <p:cxnSp>
        <p:nvCxnSpPr>
          <p:cNvPr id="6" name="직선 연결선 26">
            <a:extLst>
              <a:ext uri="{FF2B5EF4-FFF2-40B4-BE49-F238E27FC236}">
                <a16:creationId xmlns:a16="http://schemas.microsoft.com/office/drawing/2014/main" id="{3D3B9303-0095-4330-8BB8-C1B2DC1000F9}"/>
              </a:ext>
            </a:extLst>
          </p:cNvPr>
          <p:cNvCxnSpPr/>
          <p:nvPr/>
        </p:nvCxnSpPr>
        <p:spPr>
          <a:xfrm>
            <a:off x="5529864" y="972667"/>
            <a:ext cx="68243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88EADD01-DDAA-4248-9614-075747192723}"/>
              </a:ext>
            </a:extLst>
          </p:cNvPr>
          <p:cNvSpPr txBox="1"/>
          <p:nvPr/>
        </p:nvSpPr>
        <p:spPr>
          <a:xfrm>
            <a:off x="5676386" y="972667"/>
            <a:ext cx="592272" cy="29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IL-32</a:t>
            </a:r>
            <a:r>
              <a:rPr lang="el-GR" altLang="ko-KR" sz="1200" b="1" dirty="0">
                <a:latin typeface="Times New Roman"/>
                <a:cs typeface="Times New Roman"/>
              </a:rPr>
              <a:t>θ</a:t>
            </a:r>
            <a:endParaRPr lang="ko-KR" altLang="en-US" sz="12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CEA4625-7986-4FBD-8289-5F959E24DD19}"/>
              </a:ext>
            </a:extLst>
          </p:cNvPr>
          <p:cNvSpPr txBox="1"/>
          <p:nvPr/>
        </p:nvSpPr>
        <p:spPr>
          <a:xfrm>
            <a:off x="5445045" y="972667"/>
            <a:ext cx="372913" cy="29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EV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F923D79-1E85-45CE-B258-6576DEAA8684}"/>
              </a:ext>
            </a:extLst>
          </p:cNvPr>
          <p:cNvSpPr txBox="1"/>
          <p:nvPr/>
        </p:nvSpPr>
        <p:spPr>
          <a:xfrm>
            <a:off x="6369333" y="711433"/>
            <a:ext cx="413478" cy="29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CM</a:t>
            </a:r>
          </a:p>
        </p:txBody>
      </p:sp>
      <p:cxnSp>
        <p:nvCxnSpPr>
          <p:cNvPr id="10" name="직선 연결선 30">
            <a:extLst>
              <a:ext uri="{FF2B5EF4-FFF2-40B4-BE49-F238E27FC236}">
                <a16:creationId xmlns:a16="http://schemas.microsoft.com/office/drawing/2014/main" id="{62EC7DB2-4F40-4848-A39E-DEDEB68D4E20}"/>
              </a:ext>
            </a:extLst>
          </p:cNvPr>
          <p:cNvCxnSpPr/>
          <p:nvPr/>
        </p:nvCxnSpPr>
        <p:spPr>
          <a:xfrm>
            <a:off x="6288206" y="972667"/>
            <a:ext cx="68243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BBC47B88-6922-4905-B11E-26DCE22F8966}"/>
              </a:ext>
            </a:extLst>
          </p:cNvPr>
          <p:cNvSpPr txBox="1"/>
          <p:nvPr/>
        </p:nvSpPr>
        <p:spPr>
          <a:xfrm>
            <a:off x="6461746" y="981787"/>
            <a:ext cx="592272" cy="29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IL-32</a:t>
            </a:r>
            <a:r>
              <a:rPr lang="el-GR" altLang="ko-KR" sz="1200" b="1" dirty="0">
                <a:latin typeface="Times New Roman"/>
                <a:cs typeface="Times New Roman"/>
              </a:rPr>
              <a:t>θ</a:t>
            </a:r>
            <a:endParaRPr lang="ko-KR" altLang="en-US" sz="12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543379A-AE40-4F24-9D21-FAB329581410}"/>
              </a:ext>
            </a:extLst>
          </p:cNvPr>
          <p:cNvSpPr txBox="1"/>
          <p:nvPr/>
        </p:nvSpPr>
        <p:spPr>
          <a:xfrm>
            <a:off x="6202561" y="981787"/>
            <a:ext cx="372913" cy="29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EV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88CAF68-4D38-41EC-9929-37F7E34066FD}"/>
              </a:ext>
            </a:extLst>
          </p:cNvPr>
          <p:cNvSpPr txBox="1"/>
          <p:nvPr/>
        </p:nvSpPr>
        <p:spPr>
          <a:xfrm>
            <a:off x="5748169" y="711433"/>
            <a:ext cx="228676" cy="3223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250EE0E-24BF-4792-ADA6-C5407CA5C806}"/>
              </a:ext>
            </a:extLst>
          </p:cNvPr>
          <p:cNvSpPr txBox="1"/>
          <p:nvPr/>
        </p:nvSpPr>
        <p:spPr>
          <a:xfrm>
            <a:off x="4348753" y="95247"/>
            <a:ext cx="31462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b="1" dirty="0">
                <a:latin typeface="Times New Roman" pitchFamily="18" charset="0"/>
                <a:cs typeface="Times New Roman" pitchFamily="18" charset="0"/>
              </a:rPr>
              <a:t>Raw data of figure 2E </a:t>
            </a:r>
            <a:endParaRPr lang="ko-KR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928ECD2-3CD5-4FD3-B2BD-C887C4E1CD9F}"/>
              </a:ext>
            </a:extLst>
          </p:cNvPr>
          <p:cNvSpPr/>
          <p:nvPr/>
        </p:nvSpPr>
        <p:spPr>
          <a:xfrm>
            <a:off x="5411754" y="1269338"/>
            <a:ext cx="1691205" cy="103056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27707DD0-B93F-4E6D-837A-690074972790}"/>
              </a:ext>
            </a:extLst>
          </p:cNvPr>
          <p:cNvSpPr/>
          <p:nvPr/>
        </p:nvSpPr>
        <p:spPr>
          <a:xfrm>
            <a:off x="5357810" y="3224454"/>
            <a:ext cx="1766329" cy="899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6BCC8588-761B-402A-83E0-7376E9B69396}"/>
              </a:ext>
            </a:extLst>
          </p:cNvPr>
          <p:cNvSpPr/>
          <p:nvPr/>
        </p:nvSpPr>
        <p:spPr>
          <a:xfrm>
            <a:off x="5562087" y="5376400"/>
            <a:ext cx="1659808" cy="8220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5" name="직선 연결선 26">
            <a:extLst>
              <a:ext uri="{FF2B5EF4-FFF2-40B4-BE49-F238E27FC236}">
                <a16:creationId xmlns:a16="http://schemas.microsoft.com/office/drawing/2014/main" id="{4116A037-27E7-4E9B-A142-53F74E599127}"/>
              </a:ext>
            </a:extLst>
          </p:cNvPr>
          <p:cNvCxnSpPr/>
          <p:nvPr/>
        </p:nvCxnSpPr>
        <p:spPr>
          <a:xfrm>
            <a:off x="5599985" y="2711569"/>
            <a:ext cx="68243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12114986-ED1A-44F2-B2E8-59BF87BB40EE}"/>
              </a:ext>
            </a:extLst>
          </p:cNvPr>
          <p:cNvSpPr txBox="1"/>
          <p:nvPr/>
        </p:nvSpPr>
        <p:spPr>
          <a:xfrm>
            <a:off x="5746507" y="2711569"/>
            <a:ext cx="592272" cy="29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IL-32</a:t>
            </a:r>
            <a:r>
              <a:rPr lang="el-GR" altLang="ko-KR" sz="1200" b="1" dirty="0">
                <a:latin typeface="Times New Roman"/>
                <a:cs typeface="Times New Roman"/>
              </a:rPr>
              <a:t>θ</a:t>
            </a:r>
            <a:endParaRPr lang="ko-KR" altLang="en-US" sz="1200" b="1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08F5F3D-09D4-46C8-8FDC-BB978DE0AD25}"/>
              </a:ext>
            </a:extLst>
          </p:cNvPr>
          <p:cNvSpPr txBox="1"/>
          <p:nvPr/>
        </p:nvSpPr>
        <p:spPr>
          <a:xfrm>
            <a:off x="5515166" y="2711569"/>
            <a:ext cx="372913" cy="29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EV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EFFFB30-9062-48B0-A557-CF68B69DB833}"/>
              </a:ext>
            </a:extLst>
          </p:cNvPr>
          <p:cNvSpPr txBox="1"/>
          <p:nvPr/>
        </p:nvSpPr>
        <p:spPr>
          <a:xfrm>
            <a:off x="6439454" y="2450335"/>
            <a:ext cx="413478" cy="29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CM</a:t>
            </a:r>
          </a:p>
        </p:txBody>
      </p:sp>
      <p:cxnSp>
        <p:nvCxnSpPr>
          <p:cNvPr id="49" name="직선 연결선 30">
            <a:extLst>
              <a:ext uri="{FF2B5EF4-FFF2-40B4-BE49-F238E27FC236}">
                <a16:creationId xmlns:a16="http://schemas.microsoft.com/office/drawing/2014/main" id="{9AD96578-181B-4AE8-9815-F3A8670A5C08}"/>
              </a:ext>
            </a:extLst>
          </p:cNvPr>
          <p:cNvCxnSpPr/>
          <p:nvPr/>
        </p:nvCxnSpPr>
        <p:spPr>
          <a:xfrm>
            <a:off x="6358327" y="2711569"/>
            <a:ext cx="68243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6E82EC7A-361E-48EE-85F1-A1EBDE970B5C}"/>
              </a:ext>
            </a:extLst>
          </p:cNvPr>
          <p:cNvSpPr txBox="1"/>
          <p:nvPr/>
        </p:nvSpPr>
        <p:spPr>
          <a:xfrm>
            <a:off x="6531867" y="2720689"/>
            <a:ext cx="592272" cy="29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IL-32</a:t>
            </a:r>
            <a:r>
              <a:rPr lang="el-GR" altLang="ko-KR" sz="1200" b="1" dirty="0">
                <a:latin typeface="Times New Roman"/>
                <a:cs typeface="Times New Roman"/>
              </a:rPr>
              <a:t>θ</a:t>
            </a:r>
            <a:endParaRPr lang="ko-KR" altLang="en-US" sz="1200" b="1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84D056D-C48C-4346-87AF-9C283BEC32B7}"/>
              </a:ext>
            </a:extLst>
          </p:cNvPr>
          <p:cNvSpPr txBox="1"/>
          <p:nvPr/>
        </p:nvSpPr>
        <p:spPr>
          <a:xfrm>
            <a:off x="6272682" y="2720689"/>
            <a:ext cx="372913" cy="29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EV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6131C59-7E33-44F4-82B5-8E74E7C3C3E8}"/>
              </a:ext>
            </a:extLst>
          </p:cNvPr>
          <p:cNvSpPr txBox="1"/>
          <p:nvPr/>
        </p:nvSpPr>
        <p:spPr>
          <a:xfrm>
            <a:off x="5818290" y="2450335"/>
            <a:ext cx="228676" cy="3223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-</a:t>
            </a:r>
          </a:p>
        </p:txBody>
      </p:sp>
      <p:cxnSp>
        <p:nvCxnSpPr>
          <p:cNvPr id="53" name="직선 연결선 26">
            <a:extLst>
              <a:ext uri="{FF2B5EF4-FFF2-40B4-BE49-F238E27FC236}">
                <a16:creationId xmlns:a16="http://schemas.microsoft.com/office/drawing/2014/main" id="{164C3896-4E16-47D5-AAD9-FC6D05F4DA7A}"/>
              </a:ext>
            </a:extLst>
          </p:cNvPr>
          <p:cNvCxnSpPr/>
          <p:nvPr/>
        </p:nvCxnSpPr>
        <p:spPr>
          <a:xfrm>
            <a:off x="5614683" y="5108949"/>
            <a:ext cx="68243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EB6F3E53-C4AE-40C9-8C88-05D01F6EB585}"/>
              </a:ext>
            </a:extLst>
          </p:cNvPr>
          <p:cNvSpPr txBox="1"/>
          <p:nvPr/>
        </p:nvSpPr>
        <p:spPr>
          <a:xfrm>
            <a:off x="5761205" y="5108949"/>
            <a:ext cx="592272" cy="29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IL-32</a:t>
            </a:r>
            <a:r>
              <a:rPr lang="el-GR" altLang="ko-KR" sz="1200" b="1" dirty="0">
                <a:latin typeface="Times New Roman"/>
                <a:cs typeface="Times New Roman"/>
              </a:rPr>
              <a:t>θ</a:t>
            </a:r>
            <a:endParaRPr lang="ko-KR" altLang="en-US" sz="1200" b="1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73A8BAE-39F4-46F0-8EA8-C3CD8BF10E7B}"/>
              </a:ext>
            </a:extLst>
          </p:cNvPr>
          <p:cNvSpPr txBox="1"/>
          <p:nvPr/>
        </p:nvSpPr>
        <p:spPr>
          <a:xfrm>
            <a:off x="5529864" y="5108949"/>
            <a:ext cx="372913" cy="29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EV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29AD8BE-1177-4200-A069-F806D2BAB821}"/>
              </a:ext>
            </a:extLst>
          </p:cNvPr>
          <p:cNvSpPr txBox="1"/>
          <p:nvPr/>
        </p:nvSpPr>
        <p:spPr>
          <a:xfrm>
            <a:off x="6454152" y="4847715"/>
            <a:ext cx="413478" cy="29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CM</a:t>
            </a:r>
          </a:p>
        </p:txBody>
      </p:sp>
      <p:cxnSp>
        <p:nvCxnSpPr>
          <p:cNvPr id="57" name="직선 연결선 30">
            <a:extLst>
              <a:ext uri="{FF2B5EF4-FFF2-40B4-BE49-F238E27FC236}">
                <a16:creationId xmlns:a16="http://schemas.microsoft.com/office/drawing/2014/main" id="{8F3D8BD8-9BC4-4061-876F-AF0D1DF51989}"/>
              </a:ext>
            </a:extLst>
          </p:cNvPr>
          <p:cNvCxnSpPr/>
          <p:nvPr/>
        </p:nvCxnSpPr>
        <p:spPr>
          <a:xfrm>
            <a:off x="6373025" y="5108949"/>
            <a:ext cx="68243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0F6EA5E4-26D5-4CD5-87D3-8A4C47EE29FD}"/>
              </a:ext>
            </a:extLst>
          </p:cNvPr>
          <p:cNvSpPr txBox="1"/>
          <p:nvPr/>
        </p:nvSpPr>
        <p:spPr>
          <a:xfrm>
            <a:off x="6546565" y="5118069"/>
            <a:ext cx="592272" cy="29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IL-32</a:t>
            </a:r>
            <a:r>
              <a:rPr lang="el-GR" altLang="ko-KR" sz="1200" b="1" dirty="0">
                <a:latin typeface="Times New Roman"/>
                <a:cs typeface="Times New Roman"/>
              </a:rPr>
              <a:t>θ</a:t>
            </a:r>
            <a:endParaRPr lang="ko-KR" altLang="en-US" sz="1200" b="1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309513E-DD15-4E93-BC9C-1645584B3F47}"/>
              </a:ext>
            </a:extLst>
          </p:cNvPr>
          <p:cNvSpPr txBox="1"/>
          <p:nvPr/>
        </p:nvSpPr>
        <p:spPr>
          <a:xfrm>
            <a:off x="6287380" y="5118069"/>
            <a:ext cx="372913" cy="2901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EV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7C6387E8-64BC-47D9-8845-C7F4D99276B4}"/>
              </a:ext>
            </a:extLst>
          </p:cNvPr>
          <p:cNvSpPr txBox="1"/>
          <p:nvPr/>
        </p:nvSpPr>
        <p:spPr>
          <a:xfrm>
            <a:off x="5832988" y="4847715"/>
            <a:ext cx="228676" cy="3223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-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220AC30-68DF-4274-AE46-2F8982F965DC}"/>
              </a:ext>
            </a:extLst>
          </p:cNvPr>
          <p:cNvSpPr txBox="1"/>
          <p:nvPr/>
        </p:nvSpPr>
        <p:spPr>
          <a:xfrm>
            <a:off x="3113933" y="3609747"/>
            <a:ext cx="9625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spcBef>
                <a:spcPts val="600"/>
              </a:spcBef>
              <a:spcAft>
                <a:spcPts val="600"/>
              </a:spcAft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59C2DF2-0F24-428D-BF88-1049907B36E1}"/>
              </a:ext>
            </a:extLst>
          </p:cNvPr>
          <p:cNvSpPr txBox="1"/>
          <p:nvPr/>
        </p:nvSpPr>
        <p:spPr>
          <a:xfrm>
            <a:off x="3113934" y="5632126"/>
            <a:ext cx="9625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spcBef>
                <a:spcPts val="600"/>
              </a:spcBef>
              <a:spcAft>
                <a:spcPts val="600"/>
              </a:spcAft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12984408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" name="Picture 183">
            <a:extLst>
              <a:ext uri="{FF2B5EF4-FFF2-40B4-BE49-F238E27FC236}">
                <a16:creationId xmlns:a16="http://schemas.microsoft.com/office/drawing/2014/main" id="{FE557C00-71C2-482A-B207-09AD4B02DD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95030" y="1153487"/>
            <a:ext cx="2097024" cy="1578864"/>
          </a:xfrm>
          <a:prstGeom prst="rect">
            <a:avLst/>
          </a:prstGeom>
        </p:spPr>
      </p:pic>
      <p:sp>
        <p:nvSpPr>
          <p:cNvPr id="18" name="Text Box 87">
            <a:extLst>
              <a:ext uri="{FF2B5EF4-FFF2-40B4-BE49-F238E27FC236}">
                <a16:creationId xmlns:a16="http://schemas.microsoft.com/office/drawing/2014/main" id="{760FCC67-E355-4F17-AD04-DDF4B2F813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237710" y="2675366"/>
            <a:ext cx="858850" cy="215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lnSpc>
                <a:spcPct val="50000"/>
              </a:lnSpc>
              <a:spcBef>
                <a:spcPct val="50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Symbol" pitchFamily="18" charset="2"/>
            </a:endParaRPr>
          </a:p>
        </p:txBody>
      </p:sp>
      <p:sp>
        <p:nvSpPr>
          <p:cNvPr id="23" name="Text Box 87">
            <a:extLst>
              <a:ext uri="{FF2B5EF4-FFF2-40B4-BE49-F238E27FC236}">
                <a16:creationId xmlns:a16="http://schemas.microsoft.com/office/drawing/2014/main" id="{8215567B-5BEA-46AF-8F10-64FB3E0A9E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41349" y="1743340"/>
            <a:ext cx="858850" cy="215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lnSpc>
                <a:spcPct val="50000"/>
              </a:lnSpc>
              <a:spcBef>
                <a:spcPct val="50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Symbol" pitchFamily="18" charset="2"/>
            </a:endParaRPr>
          </a:p>
        </p:txBody>
      </p:sp>
      <p:sp>
        <p:nvSpPr>
          <p:cNvPr id="25" name="Text Box 87">
            <a:extLst>
              <a:ext uri="{FF2B5EF4-FFF2-40B4-BE49-F238E27FC236}">
                <a16:creationId xmlns:a16="http://schemas.microsoft.com/office/drawing/2014/main" id="{E30206BA-58BE-4E7A-8BE7-0B90D5DD9B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278713" y="3892473"/>
            <a:ext cx="858850" cy="215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lnSpc>
                <a:spcPct val="50000"/>
              </a:lnSpc>
              <a:spcBef>
                <a:spcPct val="50000"/>
              </a:spcBef>
            </a:pPr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Symbol" pitchFamily="18" charset="2"/>
            </a:endParaRPr>
          </a:p>
        </p:txBody>
      </p:sp>
      <p:sp>
        <p:nvSpPr>
          <p:cNvPr id="28" name="Line 139">
            <a:extLst>
              <a:ext uri="{FF2B5EF4-FFF2-40B4-BE49-F238E27FC236}">
                <a16:creationId xmlns:a16="http://schemas.microsoft.com/office/drawing/2014/main" id="{67FB579B-C431-4843-8CDB-8AFE17B88962}"/>
              </a:ext>
            </a:extLst>
          </p:cNvPr>
          <p:cNvSpPr>
            <a:spLocks noChangeShapeType="1"/>
          </p:cNvSpPr>
          <p:nvPr/>
        </p:nvSpPr>
        <p:spPr bwMode="auto">
          <a:xfrm>
            <a:off x="4767681" y="2345686"/>
            <a:ext cx="0" cy="2177551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 Box 87">
            <a:extLst>
              <a:ext uri="{FF2B5EF4-FFF2-40B4-BE49-F238E27FC236}">
                <a16:creationId xmlns:a16="http://schemas.microsoft.com/office/drawing/2014/main" id="{C5F22A15-D243-42AA-9A84-E417D5C468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567827" y="1888386"/>
            <a:ext cx="720725" cy="215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50000"/>
              </a:lnSpc>
              <a:spcBef>
                <a:spcPct val="50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Symbol" pitchFamily="18" charset="2"/>
            </a:endParaRPr>
          </a:p>
        </p:txBody>
      </p:sp>
      <p:sp>
        <p:nvSpPr>
          <p:cNvPr id="53" name="Text Box 87">
            <a:extLst>
              <a:ext uri="{FF2B5EF4-FFF2-40B4-BE49-F238E27FC236}">
                <a16:creationId xmlns:a16="http://schemas.microsoft.com/office/drawing/2014/main" id="{AC122B73-7F06-467E-AB92-030BD25F11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39945" y="3263957"/>
            <a:ext cx="901407" cy="215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lnSpc>
                <a:spcPct val="50000"/>
              </a:lnSpc>
              <a:spcBef>
                <a:spcPct val="50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: </a:t>
            </a:r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Symbol" pitchFamily="18" charset="2"/>
            </a:endParaRP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B8AE3FD5-CF94-4C25-BBA3-A736D4915767}"/>
              </a:ext>
            </a:extLst>
          </p:cNvPr>
          <p:cNvSpPr txBox="1"/>
          <p:nvPr/>
        </p:nvSpPr>
        <p:spPr>
          <a:xfrm>
            <a:off x="4440411" y="114510"/>
            <a:ext cx="30869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b="1" dirty="0">
                <a:latin typeface="Times New Roman" pitchFamily="18" charset="0"/>
                <a:cs typeface="Times New Roman" pitchFamily="18" charset="0"/>
              </a:rPr>
              <a:t>Raw data of figure 3A</a:t>
            </a:r>
            <a:endParaRPr lang="ko-KR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51" name="Picture 150">
            <a:extLst>
              <a:ext uri="{FF2B5EF4-FFF2-40B4-BE49-F238E27FC236}">
                <a16:creationId xmlns:a16="http://schemas.microsoft.com/office/drawing/2014/main" id="{608FDCE2-E7A4-4D88-B88A-01D872E6F37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8225" y="4392994"/>
            <a:ext cx="3401087" cy="1381472"/>
          </a:xfrm>
          <a:prstGeom prst="rect">
            <a:avLst/>
          </a:prstGeom>
        </p:spPr>
      </p:pic>
      <p:pic>
        <p:nvPicPr>
          <p:cNvPr id="153" name="Picture 152">
            <a:extLst>
              <a:ext uri="{FF2B5EF4-FFF2-40B4-BE49-F238E27FC236}">
                <a16:creationId xmlns:a16="http://schemas.microsoft.com/office/drawing/2014/main" id="{B8C0FCDD-A46F-4C85-8B76-CF2750457F2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395" y="2249919"/>
            <a:ext cx="2036064" cy="1048512"/>
          </a:xfrm>
          <a:prstGeom prst="rect">
            <a:avLst/>
          </a:prstGeom>
        </p:spPr>
      </p:pic>
      <p:pic>
        <p:nvPicPr>
          <p:cNvPr id="155" name="Picture 154">
            <a:extLst>
              <a:ext uri="{FF2B5EF4-FFF2-40B4-BE49-F238E27FC236}">
                <a16:creationId xmlns:a16="http://schemas.microsoft.com/office/drawing/2014/main" id="{6565E33E-0D66-452C-84CB-79D1C0BB342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4642" y="2176767"/>
            <a:ext cx="1524000" cy="1194816"/>
          </a:xfrm>
          <a:prstGeom prst="rect">
            <a:avLst/>
          </a:prstGeom>
        </p:spPr>
      </p:pic>
      <p:pic>
        <p:nvPicPr>
          <p:cNvPr id="157" name="Picture 156">
            <a:extLst>
              <a:ext uri="{FF2B5EF4-FFF2-40B4-BE49-F238E27FC236}">
                <a16:creationId xmlns:a16="http://schemas.microsoft.com/office/drawing/2014/main" id="{C7E26B83-44E2-4210-A25B-79075B5E9CD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395" y="3568339"/>
            <a:ext cx="3932247" cy="954898"/>
          </a:xfrm>
          <a:prstGeom prst="rect">
            <a:avLst/>
          </a:prstGeom>
        </p:spPr>
      </p:pic>
      <p:pic>
        <p:nvPicPr>
          <p:cNvPr id="159" name="Picture 158">
            <a:extLst>
              <a:ext uri="{FF2B5EF4-FFF2-40B4-BE49-F238E27FC236}">
                <a16:creationId xmlns:a16="http://schemas.microsoft.com/office/drawing/2014/main" id="{14B73C28-3F4C-417E-BCEC-7543F8C4664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11155" y="1494087"/>
            <a:ext cx="2785872" cy="1042416"/>
          </a:xfrm>
          <a:prstGeom prst="rect">
            <a:avLst/>
          </a:prstGeom>
        </p:spPr>
      </p:pic>
      <p:pic>
        <p:nvPicPr>
          <p:cNvPr id="161" name="Picture 160">
            <a:extLst>
              <a:ext uri="{FF2B5EF4-FFF2-40B4-BE49-F238E27FC236}">
                <a16:creationId xmlns:a16="http://schemas.microsoft.com/office/drawing/2014/main" id="{06B41AA4-E217-4A7C-A89C-1DF7AB40CC5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52182" y="3464005"/>
            <a:ext cx="3477130" cy="543475"/>
          </a:xfrm>
          <a:prstGeom prst="rect">
            <a:avLst/>
          </a:prstGeom>
        </p:spPr>
      </p:pic>
      <p:sp>
        <p:nvSpPr>
          <p:cNvPr id="148" name="Rectangle 147">
            <a:extLst>
              <a:ext uri="{FF2B5EF4-FFF2-40B4-BE49-F238E27FC236}">
                <a16:creationId xmlns:a16="http://schemas.microsoft.com/office/drawing/2014/main" id="{E9B81C9E-FCDC-49F5-8891-4B7EEB539771}"/>
              </a:ext>
            </a:extLst>
          </p:cNvPr>
          <p:cNvSpPr/>
          <p:nvPr/>
        </p:nvSpPr>
        <p:spPr>
          <a:xfrm>
            <a:off x="1027526" y="2175587"/>
            <a:ext cx="1374733" cy="11959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2" name="Rectangle 161">
            <a:extLst>
              <a:ext uri="{FF2B5EF4-FFF2-40B4-BE49-F238E27FC236}">
                <a16:creationId xmlns:a16="http://schemas.microsoft.com/office/drawing/2014/main" id="{FB9B66D8-BCC4-435C-AEEB-62B5ED057309}"/>
              </a:ext>
            </a:extLst>
          </p:cNvPr>
          <p:cNvSpPr/>
          <p:nvPr/>
        </p:nvSpPr>
        <p:spPr>
          <a:xfrm>
            <a:off x="3235437" y="2184995"/>
            <a:ext cx="1374733" cy="11959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3" name="Rectangle 162">
            <a:extLst>
              <a:ext uri="{FF2B5EF4-FFF2-40B4-BE49-F238E27FC236}">
                <a16:creationId xmlns:a16="http://schemas.microsoft.com/office/drawing/2014/main" id="{CE365A73-1C2F-4DE4-B415-2A091F38B487}"/>
              </a:ext>
            </a:extLst>
          </p:cNvPr>
          <p:cNvSpPr/>
          <p:nvPr/>
        </p:nvSpPr>
        <p:spPr>
          <a:xfrm>
            <a:off x="1053871" y="3519902"/>
            <a:ext cx="1417952" cy="111050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4" name="Rectangle 163">
            <a:extLst>
              <a:ext uri="{FF2B5EF4-FFF2-40B4-BE49-F238E27FC236}">
                <a16:creationId xmlns:a16="http://schemas.microsoft.com/office/drawing/2014/main" id="{04B234A5-69B7-4C07-A1F7-EA83BC20DB11}"/>
              </a:ext>
            </a:extLst>
          </p:cNvPr>
          <p:cNvSpPr/>
          <p:nvPr/>
        </p:nvSpPr>
        <p:spPr>
          <a:xfrm>
            <a:off x="2815918" y="3509728"/>
            <a:ext cx="1489328" cy="11959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5" name="Rectangle 164">
            <a:extLst>
              <a:ext uri="{FF2B5EF4-FFF2-40B4-BE49-F238E27FC236}">
                <a16:creationId xmlns:a16="http://schemas.microsoft.com/office/drawing/2014/main" id="{B74FEDC5-A7E3-4590-AAFF-2DD127A810C3}"/>
              </a:ext>
            </a:extLst>
          </p:cNvPr>
          <p:cNvSpPr/>
          <p:nvPr/>
        </p:nvSpPr>
        <p:spPr>
          <a:xfrm>
            <a:off x="10185404" y="1374135"/>
            <a:ext cx="1139784" cy="12254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3" name="Line 139">
            <a:extLst>
              <a:ext uri="{FF2B5EF4-FFF2-40B4-BE49-F238E27FC236}">
                <a16:creationId xmlns:a16="http://schemas.microsoft.com/office/drawing/2014/main" id="{51C6ED41-D10E-4D47-801E-C7D35DF30A09}"/>
              </a:ext>
            </a:extLst>
          </p:cNvPr>
          <p:cNvSpPr>
            <a:spLocks noChangeShapeType="1"/>
          </p:cNvSpPr>
          <p:nvPr/>
        </p:nvSpPr>
        <p:spPr bwMode="auto">
          <a:xfrm>
            <a:off x="11563390" y="1021277"/>
            <a:ext cx="0" cy="1752898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Text Box 87">
            <a:extLst>
              <a:ext uri="{FF2B5EF4-FFF2-40B4-BE49-F238E27FC236}">
                <a16:creationId xmlns:a16="http://schemas.microsoft.com/office/drawing/2014/main" id="{8DCCB108-9657-4CDD-8DAA-B81923DEB3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43990" y="4353852"/>
            <a:ext cx="720725" cy="215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50000"/>
              </a:lnSpc>
              <a:spcBef>
                <a:spcPct val="50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Symbol" pitchFamily="18" charset="2"/>
            </a:endParaRPr>
          </a:p>
        </p:txBody>
      </p:sp>
      <p:sp>
        <p:nvSpPr>
          <p:cNvPr id="175" name="Line 139">
            <a:extLst>
              <a:ext uri="{FF2B5EF4-FFF2-40B4-BE49-F238E27FC236}">
                <a16:creationId xmlns:a16="http://schemas.microsoft.com/office/drawing/2014/main" id="{E6896EDF-F3B4-4168-ADFF-2F67BA3C2B49}"/>
              </a:ext>
            </a:extLst>
          </p:cNvPr>
          <p:cNvSpPr>
            <a:spLocks noChangeShapeType="1"/>
          </p:cNvSpPr>
          <p:nvPr/>
        </p:nvSpPr>
        <p:spPr bwMode="auto">
          <a:xfrm>
            <a:off x="11239553" y="3486742"/>
            <a:ext cx="0" cy="2287723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Text Box 87">
            <a:extLst>
              <a:ext uri="{FF2B5EF4-FFF2-40B4-BE49-F238E27FC236}">
                <a16:creationId xmlns:a16="http://schemas.microsoft.com/office/drawing/2014/main" id="{336EC113-159B-43EF-AA80-94AD2A737B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60515" y="3656476"/>
            <a:ext cx="858850" cy="215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lnSpc>
                <a:spcPct val="50000"/>
              </a:lnSpc>
              <a:spcBef>
                <a:spcPct val="50000"/>
              </a:spcBef>
            </a:pPr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Symbol" pitchFamily="18" charset="2"/>
            </a:endParaRPr>
          </a:p>
        </p:txBody>
      </p:sp>
      <p:sp>
        <p:nvSpPr>
          <p:cNvPr id="177" name="Text Box 87">
            <a:extLst>
              <a:ext uri="{FF2B5EF4-FFF2-40B4-BE49-F238E27FC236}">
                <a16:creationId xmlns:a16="http://schemas.microsoft.com/office/drawing/2014/main" id="{4694C529-93F1-4899-B839-0B5B3923B7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54555" y="4948638"/>
            <a:ext cx="858850" cy="215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lnSpc>
                <a:spcPct val="50000"/>
              </a:lnSpc>
              <a:spcBef>
                <a:spcPct val="50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Symbol" pitchFamily="18" charset="2"/>
            </a:endParaRPr>
          </a:p>
        </p:txBody>
      </p:sp>
      <p:sp>
        <p:nvSpPr>
          <p:cNvPr id="178" name="Rectangle 177">
            <a:extLst>
              <a:ext uri="{FF2B5EF4-FFF2-40B4-BE49-F238E27FC236}">
                <a16:creationId xmlns:a16="http://schemas.microsoft.com/office/drawing/2014/main" id="{CC51ED9C-F803-494E-A096-4474EB7C25E2}"/>
              </a:ext>
            </a:extLst>
          </p:cNvPr>
          <p:cNvSpPr/>
          <p:nvPr/>
        </p:nvSpPr>
        <p:spPr>
          <a:xfrm>
            <a:off x="6429158" y="1069502"/>
            <a:ext cx="858840" cy="17528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9" name="Rectangle 178">
            <a:extLst>
              <a:ext uri="{FF2B5EF4-FFF2-40B4-BE49-F238E27FC236}">
                <a16:creationId xmlns:a16="http://schemas.microsoft.com/office/drawing/2014/main" id="{8ECFC35E-3AC1-42D7-81FA-CD80EC1F32D2}"/>
              </a:ext>
            </a:extLst>
          </p:cNvPr>
          <p:cNvSpPr/>
          <p:nvPr/>
        </p:nvSpPr>
        <p:spPr>
          <a:xfrm>
            <a:off x="8172475" y="3270806"/>
            <a:ext cx="1311994" cy="8648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0" name="Rectangle 179">
            <a:extLst>
              <a:ext uri="{FF2B5EF4-FFF2-40B4-BE49-F238E27FC236}">
                <a16:creationId xmlns:a16="http://schemas.microsoft.com/office/drawing/2014/main" id="{1A9BE1DF-18BC-4DFB-A06E-F7E71E617BD6}"/>
              </a:ext>
            </a:extLst>
          </p:cNvPr>
          <p:cNvSpPr/>
          <p:nvPr/>
        </p:nvSpPr>
        <p:spPr>
          <a:xfrm>
            <a:off x="8172474" y="4499048"/>
            <a:ext cx="1389815" cy="8648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 Box 87">
            <a:extLst>
              <a:ext uri="{FF2B5EF4-FFF2-40B4-BE49-F238E27FC236}">
                <a16:creationId xmlns:a16="http://schemas.microsoft.com/office/drawing/2014/main" id="{6AE2ABFA-7A30-451C-A98E-9638D4F89C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68217" y="1954116"/>
            <a:ext cx="858850" cy="215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lnSpc>
                <a:spcPct val="50000"/>
              </a:lnSpc>
              <a:spcBef>
                <a:spcPct val="50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PMA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Symbol" pitchFamily="18" charset="2"/>
            </a:endParaRPr>
          </a:p>
        </p:txBody>
      </p:sp>
      <p:sp>
        <p:nvSpPr>
          <p:cNvPr id="31" name="Text Box 87">
            <a:extLst>
              <a:ext uri="{FF2B5EF4-FFF2-40B4-BE49-F238E27FC236}">
                <a16:creationId xmlns:a16="http://schemas.microsoft.com/office/drawing/2014/main" id="{2A1102C7-BB8A-4CAC-AC32-BA86B53FE4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00199" y="850280"/>
            <a:ext cx="858850" cy="215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lnSpc>
                <a:spcPct val="50000"/>
              </a:lnSpc>
              <a:spcBef>
                <a:spcPct val="50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PMA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Symbol" pitchFamily="18" charset="2"/>
            </a:endParaRPr>
          </a:p>
        </p:txBody>
      </p:sp>
      <p:sp>
        <p:nvSpPr>
          <p:cNvPr id="32" name="Text Box 87">
            <a:extLst>
              <a:ext uri="{FF2B5EF4-FFF2-40B4-BE49-F238E27FC236}">
                <a16:creationId xmlns:a16="http://schemas.microsoft.com/office/drawing/2014/main" id="{7F72CC20-FC2F-43A5-B0F1-AD2856FF92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92411" y="3038344"/>
            <a:ext cx="858850" cy="215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lnSpc>
                <a:spcPct val="50000"/>
              </a:lnSpc>
              <a:spcBef>
                <a:spcPct val="50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PMA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Symbol" pitchFamily="18" charset="2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1313BDD0-BE43-46F9-9F7E-6E168A5E2718}"/>
              </a:ext>
            </a:extLst>
          </p:cNvPr>
          <p:cNvSpPr/>
          <p:nvPr/>
        </p:nvSpPr>
        <p:spPr>
          <a:xfrm>
            <a:off x="9465123" y="3263957"/>
            <a:ext cx="1311994" cy="8648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B37076F6-FF15-43F5-839B-9070B6F694AE}"/>
              </a:ext>
            </a:extLst>
          </p:cNvPr>
          <p:cNvSpPr/>
          <p:nvPr/>
        </p:nvSpPr>
        <p:spPr>
          <a:xfrm>
            <a:off x="9540921" y="4499047"/>
            <a:ext cx="1389815" cy="8648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 Box 87">
            <a:extLst>
              <a:ext uri="{FF2B5EF4-FFF2-40B4-BE49-F238E27FC236}">
                <a16:creationId xmlns:a16="http://schemas.microsoft.com/office/drawing/2014/main" id="{BC0E6B67-36E3-49FA-957B-861A4692FD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92411" y="4221244"/>
            <a:ext cx="858850" cy="215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lnSpc>
                <a:spcPct val="50000"/>
              </a:lnSpc>
              <a:spcBef>
                <a:spcPct val="50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PMA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Symbol" pitchFamily="18" charset="2"/>
            </a:endParaRPr>
          </a:p>
        </p:txBody>
      </p:sp>
      <p:sp>
        <p:nvSpPr>
          <p:cNvPr id="36" name="Text Box 87">
            <a:extLst>
              <a:ext uri="{FF2B5EF4-FFF2-40B4-BE49-F238E27FC236}">
                <a16:creationId xmlns:a16="http://schemas.microsoft.com/office/drawing/2014/main" id="{119D6081-FCB0-48F1-8360-9ED1287B07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202470" y="1138318"/>
            <a:ext cx="858850" cy="215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lnSpc>
                <a:spcPct val="50000"/>
              </a:lnSpc>
              <a:spcBef>
                <a:spcPct val="50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CM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Symbol" pitchFamily="18" charset="2"/>
            </a:endParaRPr>
          </a:p>
        </p:txBody>
      </p:sp>
      <p:sp>
        <p:nvSpPr>
          <p:cNvPr id="37" name="Text Box 87">
            <a:extLst>
              <a:ext uri="{FF2B5EF4-FFF2-40B4-BE49-F238E27FC236}">
                <a16:creationId xmlns:a16="http://schemas.microsoft.com/office/drawing/2014/main" id="{63F520F5-95A7-4AB8-BBAD-247FC1571E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91156" y="3050531"/>
            <a:ext cx="858850" cy="215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lnSpc>
                <a:spcPct val="50000"/>
              </a:lnSpc>
              <a:spcBef>
                <a:spcPct val="50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CM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Symbol" pitchFamily="18" charset="2"/>
            </a:endParaRPr>
          </a:p>
        </p:txBody>
      </p:sp>
      <p:sp>
        <p:nvSpPr>
          <p:cNvPr id="38" name="Text Box 87">
            <a:extLst>
              <a:ext uri="{FF2B5EF4-FFF2-40B4-BE49-F238E27FC236}">
                <a16:creationId xmlns:a16="http://schemas.microsoft.com/office/drawing/2014/main" id="{FB9ADB4D-4EEE-4E6C-812F-5BE053F307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648304" y="4230769"/>
            <a:ext cx="858850" cy="215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lnSpc>
                <a:spcPct val="50000"/>
              </a:lnSpc>
              <a:spcBef>
                <a:spcPct val="50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CM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Symbol" pitchFamily="18" charset="2"/>
            </a:endParaRPr>
          </a:p>
        </p:txBody>
      </p:sp>
      <p:sp>
        <p:nvSpPr>
          <p:cNvPr id="39" name="Text Box 87">
            <a:extLst>
              <a:ext uri="{FF2B5EF4-FFF2-40B4-BE49-F238E27FC236}">
                <a16:creationId xmlns:a16="http://schemas.microsoft.com/office/drawing/2014/main" id="{0B687803-0A6B-4509-A2D6-5F9A10BF2E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1123" y="1971829"/>
            <a:ext cx="858850" cy="215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lnSpc>
                <a:spcPct val="50000"/>
              </a:lnSpc>
              <a:spcBef>
                <a:spcPct val="50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CM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  <a:sym typeface="Symbol" pitchFamily="18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29454576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49">
            <a:extLst>
              <a:ext uri="{FF2B5EF4-FFF2-40B4-BE49-F238E27FC236}">
                <a16:creationId xmlns:a16="http://schemas.microsoft.com/office/drawing/2014/main" id="{ED2D0420-30AE-4FC1-8668-D1805EDF83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7845" y="5264348"/>
            <a:ext cx="5392745" cy="1408812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E23EA123-753F-468B-A83F-E6EF03140CC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9925" y="4299530"/>
            <a:ext cx="5712075" cy="857754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4024E091-EF14-4869-91B1-E75E2783D9D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9397" y="1518625"/>
            <a:ext cx="5595618" cy="758051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C4CD26DF-EA80-404E-AB74-AA4AFCA627F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9437" y="2331246"/>
            <a:ext cx="3373145" cy="2069884"/>
          </a:xfrm>
          <a:prstGeom prst="rect">
            <a:avLst/>
          </a:prstGeom>
        </p:spPr>
      </p:pic>
      <p:cxnSp>
        <p:nvCxnSpPr>
          <p:cNvPr id="5" name="직선 연결선 38">
            <a:extLst>
              <a:ext uri="{FF2B5EF4-FFF2-40B4-BE49-F238E27FC236}">
                <a16:creationId xmlns:a16="http://schemas.microsoft.com/office/drawing/2014/main" id="{09F2B510-ECDA-43B8-A93C-2C00192B102E}"/>
              </a:ext>
            </a:extLst>
          </p:cNvPr>
          <p:cNvCxnSpPr/>
          <p:nvPr/>
        </p:nvCxnSpPr>
        <p:spPr>
          <a:xfrm>
            <a:off x="5899915" y="1139029"/>
            <a:ext cx="7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77D416D2-019F-433B-82AF-56F4369EAD8E}"/>
              </a:ext>
            </a:extLst>
          </p:cNvPr>
          <p:cNvSpPr txBox="1"/>
          <p:nvPr/>
        </p:nvSpPr>
        <p:spPr>
          <a:xfrm>
            <a:off x="7126864" y="633741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CM</a:t>
            </a:r>
          </a:p>
        </p:txBody>
      </p:sp>
      <p:cxnSp>
        <p:nvCxnSpPr>
          <p:cNvPr id="8" name="직선 연결선 58">
            <a:extLst>
              <a:ext uri="{FF2B5EF4-FFF2-40B4-BE49-F238E27FC236}">
                <a16:creationId xmlns:a16="http://schemas.microsoft.com/office/drawing/2014/main" id="{064E84BD-FE4D-47AF-8F24-BBFF8BB28A36}"/>
              </a:ext>
            </a:extLst>
          </p:cNvPr>
          <p:cNvCxnSpPr/>
          <p:nvPr/>
        </p:nvCxnSpPr>
        <p:spPr>
          <a:xfrm>
            <a:off x="6625805" y="1139029"/>
            <a:ext cx="7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058734BC-5FC7-4D78-AF1C-1780B7E9F23B}"/>
              </a:ext>
            </a:extLst>
          </p:cNvPr>
          <p:cNvSpPr txBox="1"/>
          <p:nvPr/>
        </p:nvSpPr>
        <p:spPr>
          <a:xfrm>
            <a:off x="6637206" y="1144590"/>
            <a:ext cx="8776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EV IL-32</a:t>
            </a:r>
            <a:r>
              <a:rPr lang="el-GR" altLang="ko-KR" sz="1200" b="1" dirty="0">
                <a:latin typeface="Times New Roman"/>
                <a:cs typeface="Times New Roman"/>
              </a:rPr>
              <a:t>θ</a:t>
            </a:r>
            <a:endParaRPr lang="ko-KR" altLang="en-US" sz="12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F00FFAD-7DED-434C-9A4E-E65D6AD81E18}"/>
              </a:ext>
            </a:extLst>
          </p:cNvPr>
          <p:cNvSpPr txBox="1"/>
          <p:nvPr/>
        </p:nvSpPr>
        <p:spPr>
          <a:xfrm>
            <a:off x="6096000" y="841851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-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31B5754-DE20-428D-812F-A794EC2A5840}"/>
              </a:ext>
            </a:extLst>
          </p:cNvPr>
          <p:cNvSpPr txBox="1"/>
          <p:nvPr/>
        </p:nvSpPr>
        <p:spPr>
          <a:xfrm>
            <a:off x="5833435" y="1144590"/>
            <a:ext cx="8776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EV IL-32</a:t>
            </a:r>
            <a:r>
              <a:rPr lang="el-GR" altLang="ko-KR" sz="1200" b="1" dirty="0">
                <a:latin typeface="Times New Roman"/>
                <a:cs typeface="Times New Roman"/>
              </a:rPr>
              <a:t>θ</a:t>
            </a:r>
            <a:endParaRPr lang="ko-KR" altLang="en-US" sz="12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77132D8-A978-4B8C-B109-8D56076A4139}"/>
              </a:ext>
            </a:extLst>
          </p:cNvPr>
          <p:cNvSpPr txBox="1"/>
          <p:nvPr/>
        </p:nvSpPr>
        <p:spPr>
          <a:xfrm>
            <a:off x="7362996" y="1143790"/>
            <a:ext cx="8776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EV IL-32</a:t>
            </a:r>
            <a:r>
              <a:rPr lang="el-GR" altLang="ko-KR" sz="1200" b="1" dirty="0">
                <a:latin typeface="Times New Roman"/>
                <a:cs typeface="Times New Roman"/>
              </a:rPr>
              <a:t>θ</a:t>
            </a:r>
            <a:endParaRPr lang="ko-KR" altLang="en-US" sz="12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BDC7138-CE21-4557-96F6-513DB3B12E95}"/>
              </a:ext>
            </a:extLst>
          </p:cNvPr>
          <p:cNvSpPr txBox="1"/>
          <p:nvPr/>
        </p:nvSpPr>
        <p:spPr>
          <a:xfrm>
            <a:off x="7331321" y="904173"/>
            <a:ext cx="9358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Times New Roman" pitchFamily="18" charset="0"/>
                <a:cs typeface="Times New Roman" pitchFamily="18" charset="0"/>
              </a:rPr>
              <a:t>Rottlerin 1 µM</a:t>
            </a:r>
          </a:p>
        </p:txBody>
      </p:sp>
      <p:cxnSp>
        <p:nvCxnSpPr>
          <p:cNvPr id="14" name="직선 연결선 58">
            <a:extLst>
              <a:ext uri="{FF2B5EF4-FFF2-40B4-BE49-F238E27FC236}">
                <a16:creationId xmlns:a16="http://schemas.microsoft.com/office/drawing/2014/main" id="{397249F2-CC1A-4D1B-8EAA-7EB92340E130}"/>
              </a:ext>
            </a:extLst>
          </p:cNvPr>
          <p:cNvCxnSpPr/>
          <p:nvPr/>
        </p:nvCxnSpPr>
        <p:spPr>
          <a:xfrm>
            <a:off x="7403173" y="1133125"/>
            <a:ext cx="7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0768D373-8259-4134-AD70-D9507246E12C}"/>
              </a:ext>
            </a:extLst>
          </p:cNvPr>
          <p:cNvSpPr txBox="1"/>
          <p:nvPr/>
        </p:nvSpPr>
        <p:spPr>
          <a:xfrm>
            <a:off x="6892884" y="851521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-</a:t>
            </a:r>
          </a:p>
        </p:txBody>
      </p:sp>
      <p:cxnSp>
        <p:nvCxnSpPr>
          <p:cNvPr id="16" name="직선 연결선 190">
            <a:extLst>
              <a:ext uri="{FF2B5EF4-FFF2-40B4-BE49-F238E27FC236}">
                <a16:creationId xmlns:a16="http://schemas.microsoft.com/office/drawing/2014/main" id="{FD25AD03-49B3-4257-8179-9FE9A65756D7}"/>
              </a:ext>
            </a:extLst>
          </p:cNvPr>
          <p:cNvCxnSpPr>
            <a:cxnSpLocks/>
          </p:cNvCxnSpPr>
          <p:nvPr/>
        </p:nvCxnSpPr>
        <p:spPr>
          <a:xfrm>
            <a:off x="6625805" y="906360"/>
            <a:ext cx="159178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A3CE611F-FF95-4F24-A8F6-4E1B22329DF0}"/>
              </a:ext>
            </a:extLst>
          </p:cNvPr>
          <p:cNvSpPr txBox="1"/>
          <p:nvPr/>
        </p:nvSpPr>
        <p:spPr>
          <a:xfrm>
            <a:off x="2570319" y="6003622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GAPDH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DEBA28D-4590-44DC-977B-2CB55178A89B}"/>
              </a:ext>
            </a:extLst>
          </p:cNvPr>
          <p:cNvSpPr txBox="1"/>
          <p:nvPr/>
        </p:nvSpPr>
        <p:spPr>
          <a:xfrm>
            <a:off x="2845212" y="1743761"/>
            <a:ext cx="5757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l-GR" altLang="ko-KR" sz="1400" b="1" dirty="0">
                <a:latin typeface="Times New Roman" pitchFamily="18" charset="0"/>
                <a:cs typeface="Times New Roman" pitchFamily="18" charset="0"/>
              </a:rPr>
              <a:t>κ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l-GR" altLang="ko-KR" sz="1400" b="1" dirty="0">
                <a:latin typeface="Times New Roman" pitchFamily="18" charset="0"/>
                <a:cs typeface="Times New Roman" pitchFamily="18" charset="0"/>
              </a:rPr>
              <a:t>α</a:t>
            </a:r>
            <a:endParaRPr lang="en-US" altLang="ko-KR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B4A0BE5-F642-42BB-80B4-44B688CAB02A}"/>
              </a:ext>
            </a:extLst>
          </p:cNvPr>
          <p:cNvSpPr txBox="1"/>
          <p:nvPr/>
        </p:nvSpPr>
        <p:spPr>
          <a:xfrm>
            <a:off x="2641630" y="3113584"/>
            <a:ext cx="7793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p- I</a:t>
            </a:r>
            <a:r>
              <a:rPr lang="el-GR" altLang="ko-KR" sz="1400" b="1" dirty="0">
                <a:latin typeface="Times New Roman" pitchFamily="18" charset="0"/>
                <a:cs typeface="Times New Roman" pitchFamily="18" charset="0"/>
              </a:rPr>
              <a:t>κ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l-GR" altLang="ko-KR" sz="1400" b="1" dirty="0">
                <a:latin typeface="Times New Roman" pitchFamily="18" charset="0"/>
                <a:cs typeface="Times New Roman" pitchFamily="18" charset="0"/>
              </a:rPr>
              <a:t>α</a:t>
            </a:r>
            <a:endParaRPr lang="en-US" altLang="ko-KR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B36E811-8EE2-4896-9084-E2F10930E2C8}"/>
              </a:ext>
            </a:extLst>
          </p:cNvPr>
          <p:cNvSpPr txBox="1"/>
          <p:nvPr/>
        </p:nvSpPr>
        <p:spPr>
          <a:xfrm>
            <a:off x="2129790" y="4435371"/>
            <a:ext cx="14308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p- STAT3 (Y705)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ED83E433-E7B8-4FAE-B98F-1DDB1D0B9B90}"/>
              </a:ext>
            </a:extLst>
          </p:cNvPr>
          <p:cNvSpPr/>
          <p:nvPr/>
        </p:nvSpPr>
        <p:spPr>
          <a:xfrm>
            <a:off x="5899916" y="1563425"/>
            <a:ext cx="2240464" cy="6883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D59F0720-2F3E-44C3-948D-8A7F17069E9F}"/>
              </a:ext>
            </a:extLst>
          </p:cNvPr>
          <p:cNvSpPr/>
          <p:nvPr/>
        </p:nvSpPr>
        <p:spPr>
          <a:xfrm>
            <a:off x="6096000" y="3382010"/>
            <a:ext cx="2255520" cy="3445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79C3607-F800-4CED-A26C-7B54814FFBB4}"/>
              </a:ext>
            </a:extLst>
          </p:cNvPr>
          <p:cNvSpPr txBox="1"/>
          <p:nvPr/>
        </p:nvSpPr>
        <p:spPr>
          <a:xfrm>
            <a:off x="4449228" y="114510"/>
            <a:ext cx="30693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b="1" dirty="0">
                <a:latin typeface="Times New Roman" pitchFamily="18" charset="0"/>
                <a:cs typeface="Times New Roman" pitchFamily="18" charset="0"/>
              </a:rPr>
              <a:t>Raw data of figure 3B</a:t>
            </a:r>
            <a:endParaRPr lang="ko-KR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DD83EC17-83AB-470A-BE43-923C0126DA71}"/>
              </a:ext>
            </a:extLst>
          </p:cNvPr>
          <p:cNvSpPr/>
          <p:nvPr/>
        </p:nvSpPr>
        <p:spPr>
          <a:xfrm>
            <a:off x="5899916" y="4398966"/>
            <a:ext cx="2240464" cy="6883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A02F7FF0-D273-4C78-98FF-012B74E36C9F}"/>
              </a:ext>
            </a:extLst>
          </p:cNvPr>
          <p:cNvSpPr/>
          <p:nvPr/>
        </p:nvSpPr>
        <p:spPr>
          <a:xfrm>
            <a:off x="5953182" y="5535895"/>
            <a:ext cx="2240464" cy="6883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4047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Picture 77">
            <a:extLst>
              <a:ext uri="{FF2B5EF4-FFF2-40B4-BE49-F238E27FC236}">
                <a16:creationId xmlns:a16="http://schemas.microsoft.com/office/drawing/2014/main" id="{7D37078E-EF69-4529-B6E5-6079971AE6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4078" y="5087207"/>
            <a:ext cx="4314825" cy="1276350"/>
          </a:xfrm>
          <a:prstGeom prst="rect">
            <a:avLst/>
          </a:prstGeom>
        </p:spPr>
      </p:pic>
      <p:pic>
        <p:nvPicPr>
          <p:cNvPr id="76" name="Picture 75">
            <a:extLst>
              <a:ext uri="{FF2B5EF4-FFF2-40B4-BE49-F238E27FC236}">
                <a16:creationId xmlns:a16="http://schemas.microsoft.com/office/drawing/2014/main" id="{183C8EDA-0DC7-4CB6-A3E8-7FACE667E8A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8304" y="3870495"/>
            <a:ext cx="3456432" cy="701040"/>
          </a:xfrm>
          <a:prstGeom prst="rect">
            <a:avLst/>
          </a:prstGeom>
        </p:spPr>
      </p:pic>
      <p:pic>
        <p:nvPicPr>
          <p:cNvPr id="70" name="Picture 69">
            <a:extLst>
              <a:ext uri="{FF2B5EF4-FFF2-40B4-BE49-F238E27FC236}">
                <a16:creationId xmlns:a16="http://schemas.microsoft.com/office/drawing/2014/main" id="{554AF940-596D-429D-ABF3-010FE1737E6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8030" y="2501896"/>
            <a:ext cx="3826059" cy="1182209"/>
          </a:xfrm>
          <a:prstGeom prst="rect">
            <a:avLst/>
          </a:prstGeom>
        </p:spPr>
      </p:pic>
      <p:pic>
        <p:nvPicPr>
          <p:cNvPr id="74" name="Picture 73">
            <a:extLst>
              <a:ext uri="{FF2B5EF4-FFF2-40B4-BE49-F238E27FC236}">
                <a16:creationId xmlns:a16="http://schemas.microsoft.com/office/drawing/2014/main" id="{17B0E1EF-0E8D-43CA-874B-912D9558746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9652" y="1667427"/>
            <a:ext cx="4179494" cy="593345"/>
          </a:xfrm>
          <a:prstGeom prst="rect">
            <a:avLst/>
          </a:prstGeom>
        </p:spPr>
      </p:pic>
      <p:pic>
        <p:nvPicPr>
          <p:cNvPr id="82" name="Picture 81">
            <a:extLst>
              <a:ext uri="{FF2B5EF4-FFF2-40B4-BE49-F238E27FC236}">
                <a16:creationId xmlns:a16="http://schemas.microsoft.com/office/drawing/2014/main" id="{013558DF-F1AA-4591-B3D4-F084160B4F4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5854" y="3150322"/>
            <a:ext cx="1935995" cy="1995381"/>
          </a:xfrm>
          <a:prstGeom prst="rect">
            <a:avLst/>
          </a:prstGeom>
        </p:spPr>
      </p:pic>
      <p:pic>
        <p:nvPicPr>
          <p:cNvPr id="80" name="Picture 79">
            <a:extLst>
              <a:ext uri="{FF2B5EF4-FFF2-40B4-BE49-F238E27FC236}">
                <a16:creationId xmlns:a16="http://schemas.microsoft.com/office/drawing/2014/main" id="{90223F3E-FB29-48CA-88C7-B702AA8D995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0399" y="1116989"/>
            <a:ext cx="3631949" cy="194742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EB8E258-8873-4A09-AEF1-9A8C75B8C0B8}"/>
              </a:ext>
            </a:extLst>
          </p:cNvPr>
          <p:cNvSpPr txBox="1"/>
          <p:nvPr/>
        </p:nvSpPr>
        <p:spPr>
          <a:xfrm>
            <a:off x="446155" y="5554638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/>
                <a:cs typeface="Times New Roman"/>
              </a:rPr>
              <a:t>GAPDH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0C02B1B-6AE1-4A27-BEB6-3F116518CBCF}"/>
              </a:ext>
            </a:extLst>
          </p:cNvPr>
          <p:cNvSpPr txBox="1"/>
          <p:nvPr/>
        </p:nvSpPr>
        <p:spPr>
          <a:xfrm>
            <a:off x="1930041" y="930511"/>
            <a:ext cx="351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Times New Roman" pitchFamily="18" charset="0"/>
                <a:cs typeface="Times New Roman" pitchFamily="18" charset="0"/>
              </a:rPr>
              <a:t>-</a:t>
            </a:r>
          </a:p>
        </p:txBody>
      </p:sp>
      <p:sp>
        <p:nvSpPr>
          <p:cNvPr id="7" name="직사각형 172">
            <a:extLst>
              <a:ext uri="{FF2B5EF4-FFF2-40B4-BE49-F238E27FC236}">
                <a16:creationId xmlns:a16="http://schemas.microsoft.com/office/drawing/2014/main" id="{FB1E9E02-8C4A-42C2-957F-EEC87AFF1D10}"/>
              </a:ext>
            </a:extLst>
          </p:cNvPr>
          <p:cNvSpPr/>
          <p:nvPr/>
        </p:nvSpPr>
        <p:spPr>
          <a:xfrm>
            <a:off x="2108045" y="688301"/>
            <a:ext cx="63831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Cytosol</a:t>
            </a:r>
            <a:endParaRPr lang="ko-KR" altLang="en-US" sz="11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31772E1-479A-451E-82FB-5E8A09A16C1C}"/>
              </a:ext>
            </a:extLst>
          </p:cNvPr>
          <p:cNvSpPr txBox="1"/>
          <p:nvPr/>
        </p:nvSpPr>
        <p:spPr>
          <a:xfrm>
            <a:off x="2589372" y="973945"/>
            <a:ext cx="562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CM</a:t>
            </a:r>
          </a:p>
        </p:txBody>
      </p:sp>
      <p:sp>
        <p:nvSpPr>
          <p:cNvPr id="9" name="직사각형 189">
            <a:extLst>
              <a:ext uri="{FF2B5EF4-FFF2-40B4-BE49-F238E27FC236}">
                <a16:creationId xmlns:a16="http://schemas.microsoft.com/office/drawing/2014/main" id="{31077112-1939-4B7E-ADD7-A81B5E496E95}"/>
              </a:ext>
            </a:extLst>
          </p:cNvPr>
          <p:cNvSpPr/>
          <p:nvPr/>
        </p:nvSpPr>
        <p:spPr>
          <a:xfrm>
            <a:off x="9615634" y="461274"/>
            <a:ext cx="66236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Nuclear</a:t>
            </a:r>
            <a:endParaRPr lang="ko-KR" altLang="en-US" sz="1100" b="1" dirty="0"/>
          </a:p>
        </p:txBody>
      </p:sp>
      <p:cxnSp>
        <p:nvCxnSpPr>
          <p:cNvPr id="10" name="직선 연결선 192">
            <a:extLst>
              <a:ext uri="{FF2B5EF4-FFF2-40B4-BE49-F238E27FC236}">
                <a16:creationId xmlns:a16="http://schemas.microsoft.com/office/drawing/2014/main" id="{01D7929F-8F8B-4E7B-8E9D-4D06D67814A4}"/>
              </a:ext>
            </a:extLst>
          </p:cNvPr>
          <p:cNvCxnSpPr/>
          <p:nvPr/>
        </p:nvCxnSpPr>
        <p:spPr>
          <a:xfrm>
            <a:off x="1784045" y="1259588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A3D19856-CD9B-44C0-A4A5-66AB7EAAFE53}"/>
              </a:ext>
            </a:extLst>
          </p:cNvPr>
          <p:cNvSpPr txBox="1"/>
          <p:nvPr/>
        </p:nvSpPr>
        <p:spPr>
          <a:xfrm>
            <a:off x="1648304" y="1259588"/>
            <a:ext cx="877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EV IL-32</a:t>
            </a:r>
            <a:r>
              <a:rPr lang="el-GR" altLang="ko-KR" sz="1100" b="1" dirty="0">
                <a:latin typeface="Times New Roman"/>
                <a:cs typeface="Times New Roman"/>
              </a:rPr>
              <a:t>θ</a:t>
            </a:r>
            <a:endParaRPr lang="ko-KR" altLang="en-US" sz="11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E592B2E-A899-48AB-A43C-9CD7023EF816}"/>
              </a:ext>
            </a:extLst>
          </p:cNvPr>
          <p:cNvSpPr txBox="1"/>
          <p:nvPr/>
        </p:nvSpPr>
        <p:spPr>
          <a:xfrm>
            <a:off x="2353651" y="1259588"/>
            <a:ext cx="877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EV IL-32</a:t>
            </a:r>
            <a:r>
              <a:rPr lang="el-GR" altLang="ko-KR" sz="1100" b="1" dirty="0">
                <a:latin typeface="Times New Roman"/>
                <a:cs typeface="Times New Roman"/>
              </a:rPr>
              <a:t>θ</a:t>
            </a:r>
            <a:endParaRPr lang="ko-KR" altLang="en-US" sz="1100" b="1" dirty="0"/>
          </a:p>
        </p:txBody>
      </p:sp>
      <p:cxnSp>
        <p:nvCxnSpPr>
          <p:cNvPr id="16" name="직선 연결선 192">
            <a:extLst>
              <a:ext uri="{FF2B5EF4-FFF2-40B4-BE49-F238E27FC236}">
                <a16:creationId xmlns:a16="http://schemas.microsoft.com/office/drawing/2014/main" id="{5C31BB04-635C-4181-A446-8B6F94D3DF1B}"/>
              </a:ext>
            </a:extLst>
          </p:cNvPr>
          <p:cNvCxnSpPr/>
          <p:nvPr/>
        </p:nvCxnSpPr>
        <p:spPr>
          <a:xfrm>
            <a:off x="2504053" y="1259588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82DE2D7E-AC7C-43B6-AA2A-925D14E785EA}"/>
              </a:ext>
            </a:extLst>
          </p:cNvPr>
          <p:cNvSpPr txBox="1"/>
          <p:nvPr/>
        </p:nvSpPr>
        <p:spPr>
          <a:xfrm>
            <a:off x="9401848" y="683772"/>
            <a:ext cx="351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Times New Roman" pitchFamily="18" charset="0"/>
                <a:cs typeface="Times New Roman" pitchFamily="18" charset="0"/>
              </a:rPr>
              <a:t>-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147E130-D6E6-4EBD-B632-94F7E395D358}"/>
              </a:ext>
            </a:extLst>
          </p:cNvPr>
          <p:cNvSpPr txBox="1"/>
          <p:nvPr/>
        </p:nvSpPr>
        <p:spPr>
          <a:xfrm>
            <a:off x="10061179" y="727206"/>
            <a:ext cx="562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CM</a:t>
            </a:r>
          </a:p>
        </p:txBody>
      </p:sp>
      <p:cxnSp>
        <p:nvCxnSpPr>
          <p:cNvPr id="19" name="직선 연결선 192">
            <a:extLst>
              <a:ext uri="{FF2B5EF4-FFF2-40B4-BE49-F238E27FC236}">
                <a16:creationId xmlns:a16="http://schemas.microsoft.com/office/drawing/2014/main" id="{72146EE8-99B6-4B85-B8E4-227F93751B1C}"/>
              </a:ext>
            </a:extLst>
          </p:cNvPr>
          <p:cNvCxnSpPr/>
          <p:nvPr/>
        </p:nvCxnSpPr>
        <p:spPr>
          <a:xfrm>
            <a:off x="9255852" y="1012849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46B87037-F12E-411A-92E1-454321275B66}"/>
              </a:ext>
            </a:extLst>
          </p:cNvPr>
          <p:cNvSpPr txBox="1"/>
          <p:nvPr/>
        </p:nvSpPr>
        <p:spPr>
          <a:xfrm>
            <a:off x="9120111" y="1012849"/>
            <a:ext cx="877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EV IL-32</a:t>
            </a:r>
            <a:r>
              <a:rPr lang="el-GR" altLang="ko-KR" sz="1100" b="1" dirty="0">
                <a:latin typeface="Times New Roman"/>
                <a:cs typeface="Times New Roman"/>
              </a:rPr>
              <a:t>θ</a:t>
            </a:r>
            <a:endParaRPr lang="ko-KR" altLang="en-US" sz="11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0159282-8BCC-4CF6-AD12-F797D6745DF3}"/>
              </a:ext>
            </a:extLst>
          </p:cNvPr>
          <p:cNvSpPr txBox="1"/>
          <p:nvPr/>
        </p:nvSpPr>
        <p:spPr>
          <a:xfrm>
            <a:off x="9825458" y="1012849"/>
            <a:ext cx="877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EV IL-32</a:t>
            </a:r>
            <a:r>
              <a:rPr lang="el-GR" altLang="ko-KR" sz="1100" b="1" dirty="0">
                <a:latin typeface="Times New Roman"/>
                <a:cs typeface="Times New Roman"/>
              </a:rPr>
              <a:t>θ</a:t>
            </a:r>
            <a:endParaRPr lang="ko-KR" altLang="en-US" sz="1100" b="1" dirty="0"/>
          </a:p>
        </p:txBody>
      </p:sp>
      <p:cxnSp>
        <p:nvCxnSpPr>
          <p:cNvPr id="22" name="직선 연결선 192">
            <a:extLst>
              <a:ext uri="{FF2B5EF4-FFF2-40B4-BE49-F238E27FC236}">
                <a16:creationId xmlns:a16="http://schemas.microsoft.com/office/drawing/2014/main" id="{ACED2BF4-78A0-45F3-807D-AC739B5120D4}"/>
              </a:ext>
            </a:extLst>
          </p:cNvPr>
          <p:cNvCxnSpPr/>
          <p:nvPr/>
        </p:nvCxnSpPr>
        <p:spPr>
          <a:xfrm>
            <a:off x="9975860" y="1012849"/>
            <a:ext cx="6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연결선 171">
            <a:extLst>
              <a:ext uri="{FF2B5EF4-FFF2-40B4-BE49-F238E27FC236}">
                <a16:creationId xmlns:a16="http://schemas.microsoft.com/office/drawing/2014/main" id="{32E5CDF1-C5EE-44EA-A700-1270EED3863B}"/>
              </a:ext>
            </a:extLst>
          </p:cNvPr>
          <p:cNvCxnSpPr>
            <a:cxnSpLocks/>
          </p:cNvCxnSpPr>
          <p:nvPr/>
        </p:nvCxnSpPr>
        <p:spPr>
          <a:xfrm flipV="1">
            <a:off x="9244696" y="734898"/>
            <a:ext cx="1379164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171">
            <a:extLst>
              <a:ext uri="{FF2B5EF4-FFF2-40B4-BE49-F238E27FC236}">
                <a16:creationId xmlns:a16="http://schemas.microsoft.com/office/drawing/2014/main" id="{1D4664C9-81B0-4BE8-B2AC-CCD9B115A414}"/>
              </a:ext>
            </a:extLst>
          </p:cNvPr>
          <p:cNvCxnSpPr>
            <a:cxnSpLocks/>
          </p:cNvCxnSpPr>
          <p:nvPr/>
        </p:nvCxnSpPr>
        <p:spPr>
          <a:xfrm flipV="1">
            <a:off x="1772889" y="973944"/>
            <a:ext cx="1379164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DAB2D1BA-AC0C-47D7-BC72-E2F8D74C4BE5}"/>
              </a:ext>
            </a:extLst>
          </p:cNvPr>
          <p:cNvSpPr txBox="1"/>
          <p:nvPr/>
        </p:nvSpPr>
        <p:spPr>
          <a:xfrm>
            <a:off x="722497" y="1806034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/>
                <a:cs typeface="Times New Roman"/>
              </a:rPr>
              <a:t>p65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8371686-7F2E-4124-80B9-B0322AE3DB56}"/>
              </a:ext>
            </a:extLst>
          </p:cNvPr>
          <p:cNvSpPr txBox="1"/>
          <p:nvPr/>
        </p:nvSpPr>
        <p:spPr>
          <a:xfrm>
            <a:off x="673669" y="288878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/>
                <a:cs typeface="Times New Roman"/>
              </a:rPr>
              <a:t>p50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6E43859-4B7C-4564-864E-BE56EB8FFD64}"/>
              </a:ext>
            </a:extLst>
          </p:cNvPr>
          <p:cNvSpPr txBox="1"/>
          <p:nvPr/>
        </p:nvSpPr>
        <p:spPr>
          <a:xfrm>
            <a:off x="446155" y="4050306"/>
            <a:ext cx="7174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/>
                <a:cs typeface="Times New Roman"/>
              </a:rPr>
              <a:t>STAT3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007EDFE-8716-4EDC-8414-6F56A79F26C3}"/>
              </a:ext>
            </a:extLst>
          </p:cNvPr>
          <p:cNvSpPr txBox="1"/>
          <p:nvPr/>
        </p:nvSpPr>
        <p:spPr>
          <a:xfrm>
            <a:off x="8033848" y="5825389"/>
            <a:ext cx="649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/>
                <a:cs typeface="Times New Roman"/>
              </a:rPr>
              <a:t>PARP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C41F25D-7BC0-48BD-AE74-7FF7EEF8D4C3}"/>
              </a:ext>
            </a:extLst>
          </p:cNvPr>
          <p:cNvSpPr txBox="1"/>
          <p:nvPr/>
        </p:nvSpPr>
        <p:spPr>
          <a:xfrm>
            <a:off x="6785348" y="1932900"/>
            <a:ext cx="4635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/>
                <a:cs typeface="Times New Roman"/>
              </a:rPr>
              <a:t>p65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122F34A-733F-42DC-B506-2531801375BA}"/>
              </a:ext>
            </a:extLst>
          </p:cNvPr>
          <p:cNvSpPr txBox="1"/>
          <p:nvPr/>
        </p:nvSpPr>
        <p:spPr>
          <a:xfrm>
            <a:off x="8286098" y="4432511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/>
                <a:cs typeface="Times New Roman"/>
              </a:rPr>
              <a:t>p50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74F2B18-0F92-4B88-AA02-A368D3FDA797}"/>
              </a:ext>
            </a:extLst>
          </p:cNvPr>
          <p:cNvSpPr txBox="1"/>
          <p:nvPr/>
        </p:nvSpPr>
        <p:spPr>
          <a:xfrm>
            <a:off x="8111465" y="3630648"/>
            <a:ext cx="7174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/>
                <a:cs typeface="Times New Roman"/>
              </a:rPr>
              <a:t>STAT3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DBF3C0D6-7A77-436F-8097-42D6D687F659}"/>
              </a:ext>
            </a:extLst>
          </p:cNvPr>
          <p:cNvSpPr/>
          <p:nvPr/>
        </p:nvSpPr>
        <p:spPr>
          <a:xfrm>
            <a:off x="9177748" y="1344622"/>
            <a:ext cx="1478875" cy="8660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3E728245-FD16-4596-B9DA-FE0208D39EF7}"/>
              </a:ext>
            </a:extLst>
          </p:cNvPr>
          <p:cNvSpPr/>
          <p:nvPr/>
        </p:nvSpPr>
        <p:spPr>
          <a:xfrm>
            <a:off x="9166373" y="3320895"/>
            <a:ext cx="1368008" cy="7221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EA10E884-8310-46C2-9E45-10BED2101F24}"/>
              </a:ext>
            </a:extLst>
          </p:cNvPr>
          <p:cNvSpPr/>
          <p:nvPr/>
        </p:nvSpPr>
        <p:spPr>
          <a:xfrm>
            <a:off x="1729643" y="1588250"/>
            <a:ext cx="1453968" cy="7433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695368FB-F9B8-4603-9620-E42D6002BF1D}"/>
              </a:ext>
            </a:extLst>
          </p:cNvPr>
          <p:cNvSpPr/>
          <p:nvPr/>
        </p:nvSpPr>
        <p:spPr>
          <a:xfrm>
            <a:off x="1709576" y="2677765"/>
            <a:ext cx="1453968" cy="82009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A5061A81-1A1D-41A1-8697-920B97717DC5}"/>
              </a:ext>
            </a:extLst>
          </p:cNvPr>
          <p:cNvSpPr/>
          <p:nvPr/>
        </p:nvSpPr>
        <p:spPr>
          <a:xfrm>
            <a:off x="1772889" y="5245477"/>
            <a:ext cx="1453968" cy="10718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77A07EE9-935E-432B-A1ED-CD47FF71A9C2}"/>
              </a:ext>
            </a:extLst>
          </p:cNvPr>
          <p:cNvSpPr/>
          <p:nvPr/>
        </p:nvSpPr>
        <p:spPr>
          <a:xfrm>
            <a:off x="1721734" y="3784964"/>
            <a:ext cx="1453968" cy="8384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6D7A10B6-428F-4A1F-955B-8B0EA3419C45}"/>
              </a:ext>
            </a:extLst>
          </p:cNvPr>
          <p:cNvSpPr txBox="1"/>
          <p:nvPr/>
        </p:nvSpPr>
        <p:spPr>
          <a:xfrm>
            <a:off x="4168890" y="14973"/>
            <a:ext cx="30869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b="1" dirty="0">
                <a:latin typeface="Times New Roman" pitchFamily="18" charset="0"/>
                <a:cs typeface="Times New Roman" pitchFamily="18" charset="0"/>
              </a:rPr>
              <a:t>Raw data of figure 3C</a:t>
            </a:r>
            <a:endParaRPr lang="ko-KR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16578F91-1FCC-4022-B598-372CAC720265}"/>
              </a:ext>
            </a:extLst>
          </p:cNvPr>
          <p:cNvSpPr/>
          <p:nvPr/>
        </p:nvSpPr>
        <p:spPr>
          <a:xfrm>
            <a:off x="9177748" y="4160506"/>
            <a:ext cx="1368008" cy="7221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6" name="Picture 85">
            <a:extLst>
              <a:ext uri="{FF2B5EF4-FFF2-40B4-BE49-F238E27FC236}">
                <a16:creationId xmlns:a16="http://schemas.microsoft.com/office/drawing/2014/main" id="{5DDF1B50-30D4-43BE-AC02-21F8C601023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41766" y="5420683"/>
            <a:ext cx="2511908" cy="1030526"/>
          </a:xfrm>
          <a:prstGeom prst="rect">
            <a:avLst/>
          </a:prstGeom>
        </p:spPr>
      </p:pic>
      <p:sp>
        <p:nvSpPr>
          <p:cNvPr id="58" name="Rectangle 57">
            <a:extLst>
              <a:ext uri="{FF2B5EF4-FFF2-40B4-BE49-F238E27FC236}">
                <a16:creationId xmlns:a16="http://schemas.microsoft.com/office/drawing/2014/main" id="{CF47DF40-BA04-4DDF-B181-ACB5F9AE9561}"/>
              </a:ext>
            </a:extLst>
          </p:cNvPr>
          <p:cNvSpPr/>
          <p:nvPr/>
        </p:nvSpPr>
        <p:spPr>
          <a:xfrm>
            <a:off x="9200804" y="5354464"/>
            <a:ext cx="1344952" cy="11312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9910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FB8ED5CC-D006-487D-8A5F-D9D4118C60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72236" y="3099129"/>
            <a:ext cx="3139712" cy="114005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5322F6B-C5F0-4A0A-9EF7-AD5137FD51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70054" y="527683"/>
            <a:ext cx="3001039" cy="1214257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AFA104BC-7AE7-490A-900B-C33204B87D6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4376" y="5672719"/>
            <a:ext cx="1956986" cy="1060796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8BF95E3F-C574-48BA-B13E-07A22E28D25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8860" y="730004"/>
            <a:ext cx="1834896" cy="1011936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06359D65-946B-4F03-BBAB-9C49C3514CA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6937" y="1909937"/>
            <a:ext cx="2590800" cy="1011936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60F74843-6DA0-48CA-9BAA-ED9001B4C5E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7815" y="3048895"/>
            <a:ext cx="1956986" cy="1207113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A1CC91CD-E0EA-4B4F-BD7F-6CCA28B1DF8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7208" y="4392678"/>
            <a:ext cx="1956816" cy="105460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A5AB784-0D47-4268-A045-F33E7A57DE7C}"/>
              </a:ext>
            </a:extLst>
          </p:cNvPr>
          <p:cNvSpPr txBox="1"/>
          <p:nvPr/>
        </p:nvSpPr>
        <p:spPr>
          <a:xfrm>
            <a:off x="1801531" y="5895340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GAPDH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45A28B2-27AA-4EA9-99A4-B0D145003D43}"/>
              </a:ext>
            </a:extLst>
          </p:cNvPr>
          <p:cNvSpPr txBox="1"/>
          <p:nvPr/>
        </p:nvSpPr>
        <p:spPr>
          <a:xfrm>
            <a:off x="2000589" y="4783729"/>
            <a:ext cx="6332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l-GR" altLang="ko-KR" sz="1400" b="1" dirty="0">
                <a:latin typeface="Times New Roman" pitchFamily="18" charset="0"/>
                <a:cs typeface="Times New Roman" pitchFamily="18" charset="0"/>
              </a:rPr>
              <a:t>κ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l-GR" altLang="ko-KR" sz="1400" b="1" dirty="0">
                <a:latin typeface="Times New Roman" pitchFamily="18" charset="0"/>
                <a:cs typeface="Times New Roman" pitchFamily="18" charset="0"/>
              </a:rPr>
              <a:t>α</a:t>
            </a:r>
            <a:endParaRPr lang="en-US" altLang="ko-KR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C2A1826-94BD-4B16-95DF-8C7F54C4509C}"/>
              </a:ext>
            </a:extLst>
          </p:cNvPr>
          <p:cNvSpPr txBox="1"/>
          <p:nvPr/>
        </p:nvSpPr>
        <p:spPr>
          <a:xfrm>
            <a:off x="1900917" y="1150228"/>
            <a:ext cx="732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COX-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DE204A6-61E4-4ABB-B646-8498BF529592}"/>
              </a:ext>
            </a:extLst>
          </p:cNvPr>
          <p:cNvSpPr txBox="1"/>
          <p:nvPr/>
        </p:nvSpPr>
        <p:spPr>
          <a:xfrm>
            <a:off x="1541844" y="2267320"/>
            <a:ext cx="1091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E-Cadherin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A906576B-B11D-4645-A98C-C76BE63E2D6C}"/>
              </a:ext>
            </a:extLst>
          </p:cNvPr>
          <p:cNvSpPr/>
          <p:nvPr/>
        </p:nvSpPr>
        <p:spPr>
          <a:xfrm>
            <a:off x="3996308" y="676675"/>
            <a:ext cx="614763" cy="10994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1EAFBC4D-B4C4-4046-8A90-1411160414CA}"/>
              </a:ext>
            </a:extLst>
          </p:cNvPr>
          <p:cNvSpPr/>
          <p:nvPr/>
        </p:nvSpPr>
        <p:spPr>
          <a:xfrm>
            <a:off x="3996308" y="1981533"/>
            <a:ext cx="614763" cy="10462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6F88364-3AA8-42CE-937B-773B889259F0}"/>
              </a:ext>
            </a:extLst>
          </p:cNvPr>
          <p:cNvSpPr/>
          <p:nvPr/>
        </p:nvSpPr>
        <p:spPr>
          <a:xfrm>
            <a:off x="3966292" y="3198477"/>
            <a:ext cx="614763" cy="10462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3FFE8A84-3F29-4908-87B4-B6C556C06331}"/>
              </a:ext>
            </a:extLst>
          </p:cNvPr>
          <p:cNvSpPr/>
          <p:nvPr/>
        </p:nvSpPr>
        <p:spPr>
          <a:xfrm>
            <a:off x="3978710" y="4392678"/>
            <a:ext cx="614763" cy="10462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28B1D11F-C188-45D2-A4A6-D5F356A74D11}"/>
              </a:ext>
            </a:extLst>
          </p:cNvPr>
          <p:cNvSpPr/>
          <p:nvPr/>
        </p:nvSpPr>
        <p:spPr>
          <a:xfrm>
            <a:off x="4015616" y="5645470"/>
            <a:ext cx="614763" cy="10462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91919B5-B38D-4599-A70B-98B613CB3CDE}"/>
              </a:ext>
            </a:extLst>
          </p:cNvPr>
          <p:cNvSpPr txBox="1"/>
          <p:nvPr/>
        </p:nvSpPr>
        <p:spPr>
          <a:xfrm>
            <a:off x="1202967" y="3574828"/>
            <a:ext cx="14308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p- STAT3 (Y705)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BAFB814-6103-4E26-BAFE-FA1FCE5CFE1A}"/>
              </a:ext>
            </a:extLst>
          </p:cNvPr>
          <p:cNvSpPr txBox="1"/>
          <p:nvPr/>
        </p:nvSpPr>
        <p:spPr>
          <a:xfrm>
            <a:off x="4280299" y="14973"/>
            <a:ext cx="28641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b="1" dirty="0">
                <a:latin typeface="Times New Roman" pitchFamily="18" charset="0"/>
                <a:cs typeface="Times New Roman" pitchFamily="18" charset="0"/>
              </a:rPr>
              <a:t>Raw data of figure 4</a:t>
            </a:r>
            <a:endParaRPr lang="ko-KR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57213790-94D5-47E5-9431-83A03F73CFC1}"/>
              </a:ext>
            </a:extLst>
          </p:cNvPr>
          <p:cNvSpPr/>
          <p:nvPr/>
        </p:nvSpPr>
        <p:spPr>
          <a:xfrm>
            <a:off x="8314633" y="651482"/>
            <a:ext cx="612740" cy="9588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8B684CA-E8C5-41B8-8ED0-97A707EC38F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730662" y="1843948"/>
            <a:ext cx="3791723" cy="115487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86C7B8A-71CB-451D-A1FC-912A98A2BBD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590510" y="4350782"/>
            <a:ext cx="4072026" cy="108815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28DA640-9497-4D62-9224-9B8A6BF6832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443638" y="5593525"/>
            <a:ext cx="3078747" cy="1085182"/>
          </a:xfrm>
          <a:prstGeom prst="rect">
            <a:avLst/>
          </a:prstGeom>
        </p:spPr>
      </p:pic>
      <p:sp>
        <p:nvSpPr>
          <p:cNvPr id="40" name="Rectangle 39">
            <a:extLst>
              <a:ext uri="{FF2B5EF4-FFF2-40B4-BE49-F238E27FC236}">
                <a16:creationId xmlns:a16="http://schemas.microsoft.com/office/drawing/2014/main" id="{611DE519-36F0-47CD-96A8-6F2E380367E4}"/>
              </a:ext>
            </a:extLst>
          </p:cNvPr>
          <p:cNvSpPr/>
          <p:nvPr/>
        </p:nvSpPr>
        <p:spPr>
          <a:xfrm>
            <a:off x="8314633" y="1845045"/>
            <a:ext cx="612740" cy="9588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B9E79E71-8C36-4CFC-AB27-1752541D389F}"/>
              </a:ext>
            </a:extLst>
          </p:cNvPr>
          <p:cNvSpPr/>
          <p:nvPr/>
        </p:nvSpPr>
        <p:spPr>
          <a:xfrm>
            <a:off x="8314633" y="3209702"/>
            <a:ext cx="612740" cy="9588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44C2130C-DC22-49E3-B1B5-4DC067E559E7}"/>
              </a:ext>
            </a:extLst>
          </p:cNvPr>
          <p:cNvSpPr/>
          <p:nvPr/>
        </p:nvSpPr>
        <p:spPr>
          <a:xfrm>
            <a:off x="8314633" y="4458476"/>
            <a:ext cx="612740" cy="9588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92B99D4C-5F03-45E6-9D3A-DE8719B8B38D}"/>
              </a:ext>
            </a:extLst>
          </p:cNvPr>
          <p:cNvSpPr/>
          <p:nvPr/>
        </p:nvSpPr>
        <p:spPr>
          <a:xfrm>
            <a:off x="8314633" y="5655528"/>
            <a:ext cx="612740" cy="9588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6669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54</TotalTime>
  <Words>163</Words>
  <Application>Microsoft Office PowerPoint</Application>
  <PresentationFormat>Widescreen</PresentationFormat>
  <Paragraphs>8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u Huyen Pham</dc:creator>
  <cp:lastModifiedBy>Thu Huyen Pham</cp:lastModifiedBy>
  <cp:revision>4</cp:revision>
  <dcterms:created xsi:type="dcterms:W3CDTF">2019-03-15T08:05:59Z</dcterms:created>
  <dcterms:modified xsi:type="dcterms:W3CDTF">2019-05-06T06:16:24Z</dcterms:modified>
</cp:coreProperties>
</file>